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1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nish Yadav" userId="4beb67dbd1f8e7f9" providerId="LiveId" clId="{20F0F18A-9429-406C-B392-E549F940441F}"/>
    <pc:docChg chg="undo custSel addSld delSld modSld">
      <pc:chgData name="Manish Yadav" userId="4beb67dbd1f8e7f9" providerId="LiveId" clId="{20F0F18A-9429-406C-B392-E549F940441F}" dt="2023-07-03T15:09:33.269" v="2182" actId="1036"/>
      <pc:docMkLst>
        <pc:docMk/>
      </pc:docMkLst>
      <pc:sldChg chg="new del">
        <pc:chgData name="Manish Yadav" userId="4beb67dbd1f8e7f9" providerId="LiveId" clId="{20F0F18A-9429-406C-B392-E549F940441F}" dt="2023-07-03T14:50:28.471" v="1566" actId="47"/>
        <pc:sldMkLst>
          <pc:docMk/>
          <pc:sldMk cId="11895254" sldId="256"/>
        </pc:sldMkLst>
      </pc:sldChg>
      <pc:sldChg chg="addSp delSp modSp new mod">
        <pc:chgData name="Manish Yadav" userId="4beb67dbd1f8e7f9" providerId="LiveId" clId="{20F0F18A-9429-406C-B392-E549F940441F}" dt="2023-07-03T15:04:58.369" v="2114" actId="1037"/>
        <pc:sldMkLst>
          <pc:docMk/>
          <pc:sldMk cId="3520707049" sldId="257"/>
        </pc:sldMkLst>
        <pc:spChg chg="del mod">
          <ac:chgData name="Manish Yadav" userId="4beb67dbd1f8e7f9" providerId="LiveId" clId="{20F0F18A-9429-406C-B392-E549F940441F}" dt="2023-07-03T11:09:47.574" v="4" actId="478"/>
          <ac:spMkLst>
            <pc:docMk/>
            <pc:sldMk cId="3520707049" sldId="257"/>
            <ac:spMk id="2" creationId="{E729A9B6-1DB8-7937-6697-A6145A81EEB2}"/>
          </ac:spMkLst>
        </pc:spChg>
        <pc:spChg chg="del">
          <ac:chgData name="Manish Yadav" userId="4beb67dbd1f8e7f9" providerId="LiveId" clId="{20F0F18A-9429-406C-B392-E549F940441F}" dt="2023-07-03T11:09:45.833" v="2" actId="478"/>
          <ac:spMkLst>
            <pc:docMk/>
            <pc:sldMk cId="3520707049" sldId="257"/>
            <ac:spMk id="3" creationId="{E2760E24-C4C9-A78F-0676-099D829A183B}"/>
          </ac:spMkLst>
        </pc:spChg>
        <pc:spChg chg="add mod">
          <ac:chgData name="Manish Yadav" userId="4beb67dbd1f8e7f9" providerId="LiveId" clId="{20F0F18A-9429-406C-B392-E549F940441F}" dt="2023-07-03T14:50:22.691" v="1564" actId="14100"/>
          <ac:spMkLst>
            <pc:docMk/>
            <pc:sldMk cId="3520707049" sldId="257"/>
            <ac:spMk id="4" creationId="{1825DEEC-1BB8-CFBD-6334-BA0E791A76FE}"/>
          </ac:spMkLst>
        </pc:spChg>
        <pc:spChg chg="add del mod">
          <ac:chgData name="Manish Yadav" userId="4beb67dbd1f8e7f9" providerId="LiveId" clId="{20F0F18A-9429-406C-B392-E549F940441F}" dt="2023-07-03T14:50:24.155" v="1565" actId="478"/>
          <ac:spMkLst>
            <pc:docMk/>
            <pc:sldMk cId="3520707049" sldId="257"/>
            <ac:spMk id="5" creationId="{E8E7B154-1876-615C-0744-952259FD82D3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7" creationId="{047FC9F2-F487-A84E-F9E3-CA65E22424E3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12" creationId="{80156A74-E3B4-9847-4EC5-A7585C285D41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16" creationId="{79385214-D888-B449-7011-FCDC1BB431FA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17" creationId="{DFFA1B4E-15BE-CACE-F44A-25BC2F1A6B66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18" creationId="{3B124CC3-D4C7-3848-57DE-2D5940A4F328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19" creationId="{96202A5A-CBE5-2D1C-CEE1-382C2BAE66FB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23" creationId="{8A21547D-27B8-F210-3728-41942AEA7992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24" creationId="{C15A4CB1-F4C1-5B86-68FA-EDD2AF17B4E8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25" creationId="{2BCCABBE-11BB-6A84-E4F9-0A0B5D19C8BA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26" creationId="{A09F267C-EA3C-B2F1-3A8E-3295F8F07FE4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27" creationId="{0BB88685-D5BA-738A-4863-F738ACC9DC8A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28" creationId="{37451791-CE21-580E-770E-E1E65D517B73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29" creationId="{2B65FA0D-4919-F5AD-B090-6905B7EDCB33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30" creationId="{9BD53FF0-D0D5-554C-C16C-A099D02DD0FA}"/>
          </ac:spMkLst>
        </pc:spChg>
        <pc:spChg chg="mod">
          <ac:chgData name="Manish Yadav" userId="4beb67dbd1f8e7f9" providerId="LiveId" clId="{20F0F18A-9429-406C-B392-E549F940441F}" dt="2023-07-03T11:11:30.158" v="11"/>
          <ac:spMkLst>
            <pc:docMk/>
            <pc:sldMk cId="3520707049" sldId="257"/>
            <ac:spMk id="31" creationId="{CDF068D7-14B6-3BD6-B5AC-ABDE00413D56}"/>
          </ac:spMkLst>
        </pc:spChg>
        <pc:spChg chg="del mod topLvl">
          <ac:chgData name="Manish Yadav" userId="4beb67dbd1f8e7f9" providerId="LiveId" clId="{20F0F18A-9429-406C-B392-E549F940441F}" dt="2023-07-03T11:44:23.099" v="368" actId="478"/>
          <ac:spMkLst>
            <pc:docMk/>
            <pc:sldMk cId="3520707049" sldId="257"/>
            <ac:spMk id="33" creationId="{404C745B-E6F8-0E21-937B-7F62857836FD}"/>
          </ac:spMkLst>
        </pc:spChg>
        <pc:spChg chg="del mod topLvl">
          <ac:chgData name="Manish Yadav" userId="4beb67dbd1f8e7f9" providerId="LiveId" clId="{20F0F18A-9429-406C-B392-E549F940441F}" dt="2023-07-03T11:43:05.551" v="362" actId="478"/>
          <ac:spMkLst>
            <pc:docMk/>
            <pc:sldMk cId="3520707049" sldId="257"/>
            <ac:spMk id="38" creationId="{6DE94337-BC48-8577-B21C-43664AE70C50}"/>
          </ac:spMkLst>
        </pc:spChg>
        <pc:spChg chg="mod topLvl">
          <ac:chgData name="Manish Yadav" userId="4beb67dbd1f8e7f9" providerId="LiveId" clId="{20F0F18A-9429-406C-B392-E549F940441F}" dt="2023-07-03T12:09:50.402" v="792" actId="1076"/>
          <ac:spMkLst>
            <pc:docMk/>
            <pc:sldMk cId="3520707049" sldId="257"/>
            <ac:spMk id="42" creationId="{150AD55B-0191-1B45-3739-CF21CB41EAEA}"/>
          </ac:spMkLst>
        </pc:spChg>
        <pc:spChg chg="del mod topLvl">
          <ac:chgData name="Manish Yadav" userId="4beb67dbd1f8e7f9" providerId="LiveId" clId="{20F0F18A-9429-406C-B392-E549F940441F}" dt="2023-07-03T11:44:18.542" v="367" actId="478"/>
          <ac:spMkLst>
            <pc:docMk/>
            <pc:sldMk cId="3520707049" sldId="257"/>
            <ac:spMk id="43" creationId="{CC59BE48-32F3-8847-990F-5E1EF64D5228}"/>
          </ac:spMkLst>
        </pc:spChg>
        <pc:spChg chg="del mod topLvl">
          <ac:chgData name="Manish Yadav" userId="4beb67dbd1f8e7f9" providerId="LiveId" clId="{20F0F18A-9429-406C-B392-E549F940441F}" dt="2023-07-03T11:44:15.867" v="365" actId="478"/>
          <ac:spMkLst>
            <pc:docMk/>
            <pc:sldMk cId="3520707049" sldId="257"/>
            <ac:spMk id="44" creationId="{20B29F2C-E84E-52CA-336D-2BC526BBEA0C}"/>
          </ac:spMkLst>
        </pc:spChg>
        <pc:spChg chg="mod topLvl">
          <ac:chgData name="Manish Yadav" userId="4beb67dbd1f8e7f9" providerId="LiveId" clId="{20F0F18A-9429-406C-B392-E549F940441F}" dt="2023-07-03T15:04:44.997" v="2112" actId="207"/>
          <ac:spMkLst>
            <pc:docMk/>
            <pc:sldMk cId="3520707049" sldId="257"/>
            <ac:spMk id="45" creationId="{CCA3CDE8-88A0-BAF5-336B-C1C3371DA0A0}"/>
          </ac:spMkLst>
        </pc:spChg>
        <pc:spChg chg="add del mod topLvl">
          <ac:chgData name="Manish Yadav" userId="4beb67dbd1f8e7f9" providerId="LiveId" clId="{20F0F18A-9429-406C-B392-E549F940441F}" dt="2023-07-03T14:51:21.055" v="1570" actId="164"/>
          <ac:spMkLst>
            <pc:docMk/>
            <pc:sldMk cId="3520707049" sldId="257"/>
            <ac:spMk id="49" creationId="{911932F0-ACD6-A611-B87C-EC44DBA9AAAC}"/>
          </ac:spMkLst>
        </pc:spChg>
        <pc:spChg chg="add del mod topLvl">
          <ac:chgData name="Manish Yadav" userId="4beb67dbd1f8e7f9" providerId="LiveId" clId="{20F0F18A-9429-406C-B392-E549F940441F}" dt="2023-07-03T15:04:58.369" v="2114" actId="1037"/>
          <ac:spMkLst>
            <pc:docMk/>
            <pc:sldMk cId="3520707049" sldId="257"/>
            <ac:spMk id="50" creationId="{D7D780B8-77B5-08AD-B7A5-0AAB8D1BA620}"/>
          </ac:spMkLst>
        </pc:spChg>
        <pc:spChg chg="add del mod topLvl">
          <ac:chgData name="Manish Yadav" userId="4beb67dbd1f8e7f9" providerId="LiveId" clId="{20F0F18A-9429-406C-B392-E549F940441F}" dt="2023-07-03T11:38:53.082" v="274" actId="478"/>
          <ac:spMkLst>
            <pc:docMk/>
            <pc:sldMk cId="3520707049" sldId="257"/>
            <ac:spMk id="51" creationId="{11257AD8-EB0F-08C3-6EFB-D755906F2ADA}"/>
          </ac:spMkLst>
        </pc:spChg>
        <pc:spChg chg="mod topLvl">
          <ac:chgData name="Manish Yadav" userId="4beb67dbd1f8e7f9" providerId="LiveId" clId="{20F0F18A-9429-406C-B392-E549F940441F}" dt="2023-07-03T14:52:58.409" v="1676" actId="1036"/>
          <ac:spMkLst>
            <pc:docMk/>
            <pc:sldMk cId="3520707049" sldId="257"/>
            <ac:spMk id="52" creationId="{DD2FB6D5-18A6-57C4-4386-B7A8DA515C36}"/>
          </ac:spMkLst>
        </pc:spChg>
        <pc:spChg chg="del mod topLvl">
          <ac:chgData name="Manish Yadav" userId="4beb67dbd1f8e7f9" providerId="LiveId" clId="{20F0F18A-9429-406C-B392-E549F940441F}" dt="2023-07-03T11:38:57.683" v="276" actId="478"/>
          <ac:spMkLst>
            <pc:docMk/>
            <pc:sldMk cId="3520707049" sldId="257"/>
            <ac:spMk id="53" creationId="{F88F6DBD-1402-0944-42FE-0CFE0093F1EB}"/>
          </ac:spMkLst>
        </pc:spChg>
        <pc:spChg chg="del mod topLvl">
          <ac:chgData name="Manish Yadav" userId="4beb67dbd1f8e7f9" providerId="LiveId" clId="{20F0F18A-9429-406C-B392-E549F940441F}" dt="2023-07-03T11:38:50.703" v="273" actId="478"/>
          <ac:spMkLst>
            <pc:docMk/>
            <pc:sldMk cId="3520707049" sldId="257"/>
            <ac:spMk id="54" creationId="{BCDFB7C3-9304-DD67-4A64-700B928904B2}"/>
          </ac:spMkLst>
        </pc:spChg>
        <pc:spChg chg="add del mod topLvl">
          <ac:chgData name="Manish Yadav" userId="4beb67dbd1f8e7f9" providerId="LiveId" clId="{20F0F18A-9429-406C-B392-E549F940441F}" dt="2023-07-03T11:38:55.184" v="275" actId="478"/>
          <ac:spMkLst>
            <pc:docMk/>
            <pc:sldMk cId="3520707049" sldId="257"/>
            <ac:spMk id="55" creationId="{A4DFE463-C754-3929-4818-A8793E20B540}"/>
          </ac:spMkLst>
        </pc:spChg>
        <pc:spChg chg="mod topLvl">
          <ac:chgData name="Manish Yadav" userId="4beb67dbd1f8e7f9" providerId="LiveId" clId="{20F0F18A-9429-406C-B392-E549F940441F}" dt="2023-07-03T14:52:58.409" v="1676" actId="1036"/>
          <ac:spMkLst>
            <pc:docMk/>
            <pc:sldMk cId="3520707049" sldId="257"/>
            <ac:spMk id="56" creationId="{77EA9702-BDCC-BE00-97FD-089865B9994F}"/>
          </ac:spMkLst>
        </pc:spChg>
        <pc:spChg chg="add del mod topLvl">
          <ac:chgData name="Manish Yadav" userId="4beb67dbd1f8e7f9" providerId="LiveId" clId="{20F0F18A-9429-406C-B392-E549F940441F}" dt="2023-07-03T14:52:58.409" v="1676" actId="1036"/>
          <ac:spMkLst>
            <pc:docMk/>
            <pc:sldMk cId="3520707049" sldId="257"/>
            <ac:spMk id="57" creationId="{6FE79C6F-8F76-C585-AB23-B3965D7B3AA5}"/>
          </ac:spMkLst>
        </pc:spChg>
        <pc:spChg chg="add del">
          <ac:chgData name="Manish Yadav" userId="4beb67dbd1f8e7f9" providerId="LiveId" clId="{20F0F18A-9429-406C-B392-E549F940441F}" dt="2023-07-03T11:19:50.643" v="130" actId="478"/>
          <ac:spMkLst>
            <pc:docMk/>
            <pc:sldMk cId="3520707049" sldId="257"/>
            <ac:spMk id="61" creationId="{FAF1E753-4B8B-6A71-EED9-CCCCF9B3A4DD}"/>
          </ac:spMkLst>
        </pc:spChg>
        <pc:spChg chg="add mod">
          <ac:chgData name="Manish Yadav" userId="4beb67dbd1f8e7f9" providerId="LiveId" clId="{20F0F18A-9429-406C-B392-E549F940441F}" dt="2023-07-03T14:51:21.055" v="1570" actId="164"/>
          <ac:spMkLst>
            <pc:docMk/>
            <pc:sldMk cId="3520707049" sldId="257"/>
            <ac:spMk id="63" creationId="{BA520452-C518-E7AF-DF7A-1D419CC313CD}"/>
          </ac:spMkLst>
        </pc:spChg>
        <pc:spChg chg="add mod">
          <ac:chgData name="Manish Yadav" userId="4beb67dbd1f8e7f9" providerId="LiveId" clId="{20F0F18A-9429-406C-B392-E549F940441F}" dt="2023-07-03T14:52:58.409" v="1676" actId="1036"/>
          <ac:spMkLst>
            <pc:docMk/>
            <pc:sldMk cId="3520707049" sldId="257"/>
            <ac:spMk id="64" creationId="{52A54032-3A2E-3B83-C321-F09EB731E911}"/>
          </ac:spMkLst>
        </pc:spChg>
        <pc:spChg chg="add mod">
          <ac:chgData name="Manish Yadav" userId="4beb67dbd1f8e7f9" providerId="LiveId" clId="{20F0F18A-9429-406C-B392-E549F940441F}" dt="2023-07-03T14:51:08.746" v="1569" actId="164"/>
          <ac:spMkLst>
            <pc:docMk/>
            <pc:sldMk cId="3520707049" sldId="257"/>
            <ac:spMk id="71" creationId="{B2E1D574-627C-FCEC-5F2E-2878D044851E}"/>
          </ac:spMkLst>
        </pc:spChg>
        <pc:spChg chg="add mod">
          <ac:chgData name="Manish Yadav" userId="4beb67dbd1f8e7f9" providerId="LiveId" clId="{20F0F18A-9429-406C-B392-E549F940441F}" dt="2023-07-03T14:52:58.409" v="1676" actId="1036"/>
          <ac:spMkLst>
            <pc:docMk/>
            <pc:sldMk cId="3520707049" sldId="257"/>
            <ac:spMk id="72" creationId="{2A099C97-403D-39BF-FC34-7A35656091DA}"/>
          </ac:spMkLst>
        </pc:spChg>
        <pc:grpChg chg="add mod">
          <ac:chgData name="Manish Yadav" userId="4beb67dbd1f8e7f9" providerId="LiveId" clId="{20F0F18A-9429-406C-B392-E549F940441F}" dt="2023-07-03T14:52:58.409" v="1676" actId="1036"/>
          <ac:grpSpMkLst>
            <pc:docMk/>
            <pc:sldMk cId="3520707049" sldId="257"/>
            <ac:grpSpMk id="2" creationId="{3E1E3717-0A53-F58E-A81E-232B32549000}"/>
          </ac:grpSpMkLst>
        </pc:grpChg>
        <pc:grpChg chg="add mod">
          <ac:chgData name="Manish Yadav" userId="4beb67dbd1f8e7f9" providerId="LiveId" clId="{20F0F18A-9429-406C-B392-E549F940441F}" dt="2023-07-03T14:51:42.584" v="1571" actId="164"/>
          <ac:grpSpMkLst>
            <pc:docMk/>
            <pc:sldMk cId="3520707049" sldId="257"/>
            <ac:grpSpMk id="3" creationId="{0DDE1B62-A80D-7069-64D0-087841AA667F}"/>
          </ac:grpSpMkLst>
        </pc:grpChg>
        <pc:grpChg chg="add mod">
          <ac:chgData name="Manish Yadav" userId="4beb67dbd1f8e7f9" providerId="LiveId" clId="{20F0F18A-9429-406C-B392-E549F940441F}" dt="2023-07-03T14:52:58.409" v="1676" actId="1036"/>
          <ac:grpSpMkLst>
            <pc:docMk/>
            <pc:sldMk cId="3520707049" sldId="257"/>
            <ac:grpSpMk id="6" creationId="{21D33926-7605-B111-8C9C-673E1A1A9262}"/>
          </ac:grpSpMkLst>
        </pc:grpChg>
        <pc:grpChg chg="mod">
          <ac:chgData name="Manish Yadav" userId="4beb67dbd1f8e7f9" providerId="LiveId" clId="{20F0F18A-9429-406C-B392-E549F940441F}" dt="2023-07-03T11:11:30.158" v="11"/>
          <ac:grpSpMkLst>
            <pc:docMk/>
            <pc:sldMk cId="3520707049" sldId="257"/>
            <ac:grpSpMk id="15" creationId="{9E580CD3-F259-9A88-6AD8-28B41F2E44FD}"/>
          </ac:grpSpMkLst>
        </pc:grpChg>
        <pc:grpChg chg="mod">
          <ac:chgData name="Manish Yadav" userId="4beb67dbd1f8e7f9" providerId="LiveId" clId="{20F0F18A-9429-406C-B392-E549F940441F}" dt="2023-07-03T11:11:30.158" v="11"/>
          <ac:grpSpMkLst>
            <pc:docMk/>
            <pc:sldMk cId="3520707049" sldId="257"/>
            <ac:grpSpMk id="22" creationId="{7BFAB142-8C23-43F5-7751-0286F7E83379}"/>
          </ac:grpSpMkLst>
        </pc:grpChg>
        <pc:grpChg chg="add mod">
          <ac:chgData name="Manish Yadav" userId="4beb67dbd1f8e7f9" providerId="LiveId" clId="{20F0F18A-9429-406C-B392-E549F940441F}" dt="2023-07-03T14:52:58.409" v="1676" actId="1036"/>
          <ac:grpSpMkLst>
            <pc:docMk/>
            <pc:sldMk cId="3520707049" sldId="257"/>
            <ac:grpSpMk id="32" creationId="{7F81ED71-303A-E82E-6C78-8D91A3AEF02A}"/>
          </ac:grpSpMkLst>
        </pc:grpChg>
        <pc:grpChg chg="add del mod">
          <ac:chgData name="Manish Yadav" userId="4beb67dbd1f8e7f9" providerId="LiveId" clId="{20F0F18A-9429-406C-B392-E549F940441F}" dt="2023-07-03T11:12:28.301" v="27" actId="165"/>
          <ac:grpSpMkLst>
            <pc:docMk/>
            <pc:sldMk cId="3520707049" sldId="257"/>
            <ac:grpSpMk id="32" creationId="{EDD3F399-0F31-BE47-8E8E-F360301DAD7B}"/>
          </ac:grpSpMkLst>
        </pc:grpChg>
        <pc:grpChg chg="del mod topLvl">
          <ac:chgData name="Manish Yadav" userId="4beb67dbd1f8e7f9" providerId="LiveId" clId="{20F0F18A-9429-406C-B392-E549F940441F}" dt="2023-07-03T11:12:40.721" v="28" actId="165"/>
          <ac:grpSpMkLst>
            <pc:docMk/>
            <pc:sldMk cId="3520707049" sldId="257"/>
            <ac:grpSpMk id="41" creationId="{7B02FBA0-4EF2-8DD3-0817-C4FEC7EC9D84}"/>
          </ac:grpSpMkLst>
        </pc:grpChg>
        <pc:grpChg chg="del mod topLvl">
          <ac:chgData name="Manish Yadav" userId="4beb67dbd1f8e7f9" providerId="LiveId" clId="{20F0F18A-9429-406C-B392-E549F940441F}" dt="2023-07-03T11:13:18.716" v="32" actId="165"/>
          <ac:grpSpMkLst>
            <pc:docMk/>
            <pc:sldMk cId="3520707049" sldId="257"/>
            <ac:grpSpMk id="48" creationId="{AA2BA2FC-CD69-10E2-B2BB-69F8062CCC5A}"/>
          </ac:grpSpMkLst>
        </pc:grpChg>
        <pc:grpChg chg="add mod">
          <ac:chgData name="Manish Yadav" userId="4beb67dbd1f8e7f9" providerId="LiveId" clId="{20F0F18A-9429-406C-B392-E549F940441F}" dt="2023-07-03T11:13:25.839" v="33" actId="164"/>
          <ac:grpSpMkLst>
            <pc:docMk/>
            <pc:sldMk cId="3520707049" sldId="257"/>
            <ac:grpSpMk id="58" creationId="{D758DAA5-7A9B-52AB-60EF-078B50C07AA6}"/>
          </ac:grpSpMkLst>
        </pc:grpChg>
        <pc:grpChg chg="add mod">
          <ac:chgData name="Manish Yadav" userId="4beb67dbd1f8e7f9" providerId="LiveId" clId="{20F0F18A-9429-406C-B392-E549F940441F}" dt="2023-07-03T14:51:08.746" v="1569" actId="164"/>
          <ac:grpSpMkLst>
            <pc:docMk/>
            <pc:sldMk cId="3520707049" sldId="257"/>
            <ac:grpSpMk id="59" creationId="{0EF5A728-2818-2193-2BEC-A5A6EC6687A4}"/>
          </ac:grpSpMkLst>
        </pc:grpChg>
        <pc:picChg chg="mod">
          <ac:chgData name="Manish Yadav" userId="4beb67dbd1f8e7f9" providerId="LiveId" clId="{20F0F18A-9429-406C-B392-E549F940441F}" dt="2023-07-03T11:11:30.158" v="11"/>
          <ac:picMkLst>
            <pc:docMk/>
            <pc:sldMk cId="3520707049" sldId="257"/>
            <ac:picMk id="20" creationId="{239E3C29-76A7-5D2F-010F-871D38BD20C6}"/>
          </ac:picMkLst>
        </pc:picChg>
        <pc:picChg chg="mod">
          <ac:chgData name="Manish Yadav" userId="4beb67dbd1f8e7f9" providerId="LiveId" clId="{20F0F18A-9429-406C-B392-E549F940441F}" dt="2023-07-03T11:11:30.158" v="11"/>
          <ac:picMkLst>
            <pc:docMk/>
            <pc:sldMk cId="3520707049" sldId="257"/>
            <ac:picMk id="21" creationId="{DB41612C-85B8-87F4-7A35-E844FE5CAB25}"/>
          </ac:picMkLst>
        </pc:picChg>
        <pc:picChg chg="mod topLvl modCrop">
          <ac:chgData name="Manish Yadav" userId="4beb67dbd1f8e7f9" providerId="LiveId" clId="{20F0F18A-9429-406C-B392-E549F940441F}" dt="2023-07-03T11:16:52.520" v="62" actId="732"/>
          <ac:picMkLst>
            <pc:docMk/>
            <pc:sldMk cId="3520707049" sldId="257"/>
            <ac:picMk id="46" creationId="{62DBD90F-47ED-5832-456E-F4923B35BB48}"/>
          </ac:picMkLst>
        </pc:picChg>
        <pc:picChg chg="mod topLvl modCrop">
          <ac:chgData name="Manish Yadav" userId="4beb67dbd1f8e7f9" providerId="LiveId" clId="{20F0F18A-9429-406C-B392-E549F940441F}" dt="2023-07-03T14:51:21.055" v="1570" actId="164"/>
          <ac:picMkLst>
            <pc:docMk/>
            <pc:sldMk cId="3520707049" sldId="257"/>
            <ac:picMk id="47" creationId="{16B72037-2B47-037D-6B24-23EB90EEE958}"/>
          </ac:picMkLst>
        </pc:picChg>
        <pc:picChg chg="add del mod">
          <ac:chgData name="Manish Yadav" userId="4beb67dbd1f8e7f9" providerId="LiveId" clId="{20F0F18A-9429-406C-B392-E549F940441F}" dt="2023-07-03T11:35:34.295" v="207" actId="478"/>
          <ac:picMkLst>
            <pc:docMk/>
            <pc:sldMk cId="3520707049" sldId="257"/>
            <ac:picMk id="62" creationId="{2CD590C1-549B-45F7-FA4E-58F293DCC171}"/>
          </ac:picMkLst>
        </pc:picChg>
        <pc:cxnChg chg="mod">
          <ac:chgData name="Manish Yadav" userId="4beb67dbd1f8e7f9" providerId="LiveId" clId="{20F0F18A-9429-406C-B392-E549F940441F}" dt="2023-07-03T11:11:30.158" v="11"/>
          <ac:cxnSpMkLst>
            <pc:docMk/>
            <pc:sldMk cId="3520707049" sldId="257"/>
            <ac:cxnSpMk id="8" creationId="{375C6479-3CEF-6F5F-5124-DA315E90E303}"/>
          </ac:cxnSpMkLst>
        </pc:cxnChg>
        <pc:cxnChg chg="mod">
          <ac:chgData name="Manish Yadav" userId="4beb67dbd1f8e7f9" providerId="LiveId" clId="{20F0F18A-9429-406C-B392-E549F940441F}" dt="2023-07-03T11:11:30.158" v="11"/>
          <ac:cxnSpMkLst>
            <pc:docMk/>
            <pc:sldMk cId="3520707049" sldId="257"/>
            <ac:cxnSpMk id="9" creationId="{1486BDA2-D3EF-2DDE-BB22-1F2611D36DFA}"/>
          </ac:cxnSpMkLst>
        </pc:cxnChg>
        <pc:cxnChg chg="mod">
          <ac:chgData name="Manish Yadav" userId="4beb67dbd1f8e7f9" providerId="LiveId" clId="{20F0F18A-9429-406C-B392-E549F940441F}" dt="2023-07-03T11:11:30.158" v="11"/>
          <ac:cxnSpMkLst>
            <pc:docMk/>
            <pc:sldMk cId="3520707049" sldId="257"/>
            <ac:cxnSpMk id="10" creationId="{1DD5781E-3773-6863-0BC3-57207846A024}"/>
          </ac:cxnSpMkLst>
        </pc:cxnChg>
        <pc:cxnChg chg="mod">
          <ac:chgData name="Manish Yadav" userId="4beb67dbd1f8e7f9" providerId="LiveId" clId="{20F0F18A-9429-406C-B392-E549F940441F}" dt="2023-07-03T11:11:30.158" v="11"/>
          <ac:cxnSpMkLst>
            <pc:docMk/>
            <pc:sldMk cId="3520707049" sldId="257"/>
            <ac:cxnSpMk id="11" creationId="{E270AC58-4179-019D-A648-E827D607D018}"/>
          </ac:cxnSpMkLst>
        </pc:cxnChg>
        <pc:cxnChg chg="mod">
          <ac:chgData name="Manish Yadav" userId="4beb67dbd1f8e7f9" providerId="LiveId" clId="{20F0F18A-9429-406C-B392-E549F940441F}" dt="2023-07-03T11:11:30.158" v="11"/>
          <ac:cxnSpMkLst>
            <pc:docMk/>
            <pc:sldMk cId="3520707049" sldId="257"/>
            <ac:cxnSpMk id="13" creationId="{70F297A0-DF8F-A6BB-41FE-765A8811C3D5}"/>
          </ac:cxnSpMkLst>
        </pc:cxnChg>
        <pc:cxnChg chg="mod">
          <ac:chgData name="Manish Yadav" userId="4beb67dbd1f8e7f9" providerId="LiveId" clId="{20F0F18A-9429-406C-B392-E549F940441F}" dt="2023-07-03T11:11:30.158" v="11"/>
          <ac:cxnSpMkLst>
            <pc:docMk/>
            <pc:sldMk cId="3520707049" sldId="257"/>
            <ac:cxnSpMk id="14" creationId="{3CE4CCA1-EDD2-D453-40AB-6151E9253D1F}"/>
          </ac:cxnSpMkLst>
        </pc:cxnChg>
        <pc:cxnChg chg="mod topLvl">
          <ac:chgData name="Manish Yadav" userId="4beb67dbd1f8e7f9" providerId="LiveId" clId="{20F0F18A-9429-406C-B392-E549F940441F}" dt="2023-07-03T14:52:58.409" v="1676" actId="1036"/>
          <ac:cxnSpMkLst>
            <pc:docMk/>
            <pc:sldMk cId="3520707049" sldId="257"/>
            <ac:cxnSpMk id="34" creationId="{E02D7267-9CC2-0DD0-F9AD-952F4CA2C3C5}"/>
          </ac:cxnSpMkLst>
        </pc:cxnChg>
        <pc:cxnChg chg="del mod topLvl">
          <ac:chgData name="Manish Yadav" userId="4beb67dbd1f8e7f9" providerId="LiveId" clId="{20F0F18A-9429-406C-B392-E549F940441F}" dt="2023-07-03T11:13:34.338" v="35" actId="21"/>
          <ac:cxnSpMkLst>
            <pc:docMk/>
            <pc:sldMk cId="3520707049" sldId="257"/>
            <ac:cxnSpMk id="35" creationId="{D75FB4BA-D655-174E-E977-A0D14EB7FC86}"/>
          </ac:cxnSpMkLst>
        </pc:cxnChg>
        <pc:cxnChg chg="mod topLvl">
          <ac:chgData name="Manish Yadav" userId="4beb67dbd1f8e7f9" providerId="LiveId" clId="{20F0F18A-9429-406C-B392-E549F940441F}" dt="2023-07-03T14:52:58.409" v="1676" actId="1036"/>
          <ac:cxnSpMkLst>
            <pc:docMk/>
            <pc:sldMk cId="3520707049" sldId="257"/>
            <ac:cxnSpMk id="36" creationId="{0F942777-C708-5044-5247-8B642AAA4D00}"/>
          </ac:cxnSpMkLst>
        </pc:cxnChg>
        <pc:cxnChg chg="mod topLvl">
          <ac:chgData name="Manish Yadav" userId="4beb67dbd1f8e7f9" providerId="LiveId" clId="{20F0F18A-9429-406C-B392-E549F940441F}" dt="2023-07-03T11:12:50.899" v="29" actId="164"/>
          <ac:cxnSpMkLst>
            <pc:docMk/>
            <pc:sldMk cId="3520707049" sldId="257"/>
            <ac:cxnSpMk id="37" creationId="{3F171DED-DF63-4048-F95B-250BB27CD62E}"/>
          </ac:cxnSpMkLst>
        </pc:cxnChg>
        <pc:cxnChg chg="mod topLvl">
          <ac:chgData name="Manish Yadav" userId="4beb67dbd1f8e7f9" providerId="LiveId" clId="{20F0F18A-9429-406C-B392-E549F940441F}" dt="2023-07-03T11:12:50.899" v="29" actId="164"/>
          <ac:cxnSpMkLst>
            <pc:docMk/>
            <pc:sldMk cId="3520707049" sldId="257"/>
            <ac:cxnSpMk id="39" creationId="{4B669C4F-5073-5C23-4E9F-89A8F885B3AE}"/>
          </ac:cxnSpMkLst>
        </pc:cxnChg>
        <pc:cxnChg chg="mod topLvl">
          <ac:chgData name="Manish Yadav" userId="4beb67dbd1f8e7f9" providerId="LiveId" clId="{20F0F18A-9429-406C-B392-E549F940441F}" dt="2023-07-03T11:12:50.899" v="29" actId="164"/>
          <ac:cxnSpMkLst>
            <pc:docMk/>
            <pc:sldMk cId="3520707049" sldId="257"/>
            <ac:cxnSpMk id="40" creationId="{EED270D8-7657-B3D6-66F8-E99EC16E9674}"/>
          </ac:cxnSpMkLst>
        </pc:cxnChg>
        <pc:cxnChg chg="add mod">
          <ac:chgData name="Manish Yadav" userId="4beb67dbd1f8e7f9" providerId="LiveId" clId="{20F0F18A-9429-406C-B392-E549F940441F}" dt="2023-07-03T14:52:58.409" v="1676" actId="1036"/>
          <ac:cxnSpMkLst>
            <pc:docMk/>
            <pc:sldMk cId="3520707049" sldId="257"/>
            <ac:cxnSpMk id="60" creationId="{D6E3D5AD-6AE3-F6F5-8501-EB186F86F970}"/>
          </ac:cxnSpMkLst>
        </pc:cxnChg>
        <pc:cxnChg chg="add mod">
          <ac:chgData name="Manish Yadav" userId="4beb67dbd1f8e7f9" providerId="LiveId" clId="{20F0F18A-9429-406C-B392-E549F940441F}" dt="2023-07-03T14:52:58.409" v="1676" actId="1036"/>
          <ac:cxnSpMkLst>
            <pc:docMk/>
            <pc:sldMk cId="3520707049" sldId="257"/>
            <ac:cxnSpMk id="66" creationId="{D027A65B-08B8-6DD8-9FC4-5C47F84DBD22}"/>
          </ac:cxnSpMkLst>
        </pc:cxnChg>
        <pc:cxnChg chg="add mod">
          <ac:chgData name="Manish Yadav" userId="4beb67dbd1f8e7f9" providerId="LiveId" clId="{20F0F18A-9429-406C-B392-E549F940441F}" dt="2023-07-03T14:52:58.409" v="1676" actId="1036"/>
          <ac:cxnSpMkLst>
            <pc:docMk/>
            <pc:sldMk cId="3520707049" sldId="257"/>
            <ac:cxnSpMk id="68" creationId="{59B4FB0A-A636-1D85-7B66-444C91DEE9FC}"/>
          </ac:cxnSpMkLst>
        </pc:cxnChg>
      </pc:sldChg>
      <pc:sldChg chg="addSp delSp modSp new mod">
        <pc:chgData name="Manish Yadav" userId="4beb67dbd1f8e7f9" providerId="LiveId" clId="{20F0F18A-9429-406C-B392-E549F940441F}" dt="2023-07-03T15:09:04.257" v="2152" actId="1036"/>
        <pc:sldMkLst>
          <pc:docMk/>
          <pc:sldMk cId="1910464147" sldId="258"/>
        </pc:sldMkLst>
        <pc:spChg chg="del">
          <ac:chgData name="Manish Yadav" userId="4beb67dbd1f8e7f9" providerId="LiveId" clId="{20F0F18A-9429-406C-B392-E549F940441F}" dt="2023-07-03T11:44:59.585" v="370" actId="478"/>
          <ac:spMkLst>
            <pc:docMk/>
            <pc:sldMk cId="1910464147" sldId="258"/>
            <ac:spMk id="2" creationId="{F875D19A-3403-788B-C6DF-34004E41CE7B}"/>
          </ac:spMkLst>
        </pc:spChg>
        <pc:spChg chg="add del mod">
          <ac:chgData name="Manish Yadav" userId="4beb67dbd1f8e7f9" providerId="LiveId" clId="{20F0F18A-9429-406C-B392-E549F940441F}" dt="2023-07-03T14:50:07.069" v="1561" actId="478"/>
          <ac:spMkLst>
            <pc:docMk/>
            <pc:sldMk cId="1910464147" sldId="258"/>
            <ac:spMk id="3" creationId="{E53B2C8A-5794-AC9B-1209-1F98CBB1A5E9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6" creationId="{5EAE5946-8ABD-4CE0-0716-DDF75C46BEBE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7" creationId="{6E70AC9B-4C8C-7141-40E4-9C6A27100AC7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8" creationId="{908D62D6-14EF-3857-5210-ED5B875C7FA9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9" creationId="{54CA9FDB-255E-5A47-9FF2-4F41E3165669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10" creationId="{5B97E0C9-FC8B-0DB9-452B-2E8256EBE1BF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13" creationId="{D20BAA8C-5C97-4CD2-3B4A-F20C086F408B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15" creationId="{F706B1E0-A661-AB7A-21AF-8FE2CCCEC45C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16" creationId="{5BEBBAFB-7031-AF37-EA3E-9AD8F1901661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18" creationId="{194F4398-2A49-E8E8-0901-F972FDDFFED9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19" creationId="{183325B2-3021-0504-CCB6-53A0C8A4C436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23" creationId="{696BEB26-D1B1-595E-6B00-FA0A806BC9D2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28" creationId="{54D342DA-8124-0D5D-177A-4C84FE777F09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29" creationId="{9A5BD46D-776B-B418-B99D-1D412D737A95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30" creationId="{96541DD1-A933-0A6B-76CD-7520659F4E3B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31" creationId="{BF102F00-A9B2-2827-6C15-8D42A0AEB942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32" creationId="{043FE449-39A4-C5D9-A48F-FF7C83A8C26D}"/>
          </ac:spMkLst>
        </pc:spChg>
        <pc:spChg chg="mod">
          <ac:chgData name="Manish Yadav" userId="4beb67dbd1f8e7f9" providerId="LiveId" clId="{20F0F18A-9429-406C-B392-E549F940441F}" dt="2023-07-03T11:45:00.558" v="371"/>
          <ac:spMkLst>
            <pc:docMk/>
            <pc:sldMk cId="1910464147" sldId="258"/>
            <ac:spMk id="33" creationId="{F3B56600-8298-876F-E1FF-796E9ADC2228}"/>
          </ac:spMkLst>
        </pc:spChg>
        <pc:spChg chg="add mod">
          <ac:chgData name="Manish Yadav" userId="4beb67dbd1f8e7f9" providerId="LiveId" clId="{20F0F18A-9429-406C-B392-E549F940441F}" dt="2023-07-03T14:50:10.583" v="1562" actId="1076"/>
          <ac:spMkLst>
            <pc:docMk/>
            <pc:sldMk cId="1910464147" sldId="258"/>
            <ac:spMk id="40" creationId="{A4B59316-8C95-E822-5D42-BF6F97F34DF2}"/>
          </ac:spMkLst>
        </pc:spChg>
        <pc:spChg chg="del mod topLvl">
          <ac:chgData name="Manish Yadav" userId="4beb67dbd1f8e7f9" providerId="LiveId" clId="{20F0F18A-9429-406C-B392-E549F940441F}" dt="2023-07-03T11:50:12.063" v="446" actId="478"/>
          <ac:spMkLst>
            <pc:docMk/>
            <pc:sldMk cId="1910464147" sldId="258"/>
            <ac:spMk id="43" creationId="{28D0C2DB-AB7F-D302-3FD4-14AEEF3A57C5}"/>
          </ac:spMkLst>
        </pc:spChg>
        <pc:spChg chg="del mod topLvl">
          <ac:chgData name="Manish Yadav" userId="4beb67dbd1f8e7f9" providerId="LiveId" clId="{20F0F18A-9429-406C-B392-E549F940441F}" dt="2023-07-03T11:50:14.533" v="448" actId="478"/>
          <ac:spMkLst>
            <pc:docMk/>
            <pc:sldMk cId="1910464147" sldId="258"/>
            <ac:spMk id="44" creationId="{FA536F5A-9565-78F3-C59E-1C53F1629D2D}"/>
          </ac:spMkLst>
        </pc:spChg>
        <pc:spChg chg="del mod topLvl">
          <ac:chgData name="Manish Yadav" userId="4beb67dbd1f8e7f9" providerId="LiveId" clId="{20F0F18A-9429-406C-B392-E549F940441F}" dt="2023-07-03T11:50:13.432" v="447" actId="478"/>
          <ac:spMkLst>
            <pc:docMk/>
            <pc:sldMk cId="1910464147" sldId="258"/>
            <ac:spMk id="45" creationId="{9F18EB8E-2A08-BFDF-6B81-96D115B260A6}"/>
          </ac:spMkLst>
        </pc:spChg>
        <pc:spChg chg="del mod topLvl">
          <ac:chgData name="Manish Yadav" userId="4beb67dbd1f8e7f9" providerId="LiveId" clId="{20F0F18A-9429-406C-B392-E549F940441F}" dt="2023-07-03T11:50:22.734" v="452" actId="478"/>
          <ac:spMkLst>
            <pc:docMk/>
            <pc:sldMk cId="1910464147" sldId="258"/>
            <ac:spMk id="46" creationId="{99AEF78F-CA24-523E-3B8B-70142F98065B}"/>
          </ac:spMkLst>
        </pc:spChg>
        <pc:spChg chg="mod topLvl">
          <ac:chgData name="Manish Yadav" userId="4beb67dbd1f8e7f9" providerId="LiveId" clId="{20F0F18A-9429-406C-B392-E549F940441F}" dt="2023-07-03T12:04:51.533" v="762" actId="165"/>
          <ac:spMkLst>
            <pc:docMk/>
            <pc:sldMk cId="1910464147" sldId="258"/>
            <ac:spMk id="47" creationId="{2F27B635-1964-BA72-5130-5D1CD79DE8F9}"/>
          </ac:spMkLst>
        </pc:spChg>
        <pc:spChg chg="mod topLvl">
          <ac:chgData name="Manish Yadav" userId="4beb67dbd1f8e7f9" providerId="LiveId" clId="{20F0F18A-9429-406C-B392-E549F940441F}" dt="2023-07-03T12:00:04.407" v="688" actId="164"/>
          <ac:spMkLst>
            <pc:docMk/>
            <pc:sldMk cId="1910464147" sldId="258"/>
            <ac:spMk id="50" creationId="{3884118D-6681-A03E-D08D-F9CE5FEF97F8}"/>
          </ac:spMkLst>
        </pc:spChg>
        <pc:spChg chg="del mod">
          <ac:chgData name="Manish Yadav" userId="4beb67dbd1f8e7f9" providerId="LiveId" clId="{20F0F18A-9429-406C-B392-E549F940441F}" dt="2023-07-03T11:50:05.556" v="443" actId="478"/>
          <ac:spMkLst>
            <pc:docMk/>
            <pc:sldMk cId="1910464147" sldId="258"/>
            <ac:spMk id="52" creationId="{4F8D280A-5358-2A94-3FE4-52C941C63862}"/>
          </ac:spMkLst>
        </pc:spChg>
        <pc:spChg chg="del mod topLvl">
          <ac:chgData name="Manish Yadav" userId="4beb67dbd1f8e7f9" providerId="LiveId" clId="{20F0F18A-9429-406C-B392-E549F940441F}" dt="2023-07-03T11:50:06.893" v="444" actId="478"/>
          <ac:spMkLst>
            <pc:docMk/>
            <pc:sldMk cId="1910464147" sldId="258"/>
            <ac:spMk id="53" creationId="{B94B42D5-D6E4-0728-EA5A-08E53815F2C5}"/>
          </ac:spMkLst>
        </pc:spChg>
        <pc:spChg chg="del mod">
          <ac:chgData name="Manish Yadav" userId="4beb67dbd1f8e7f9" providerId="LiveId" clId="{20F0F18A-9429-406C-B392-E549F940441F}" dt="2023-07-03T11:50:04.001" v="442" actId="478"/>
          <ac:spMkLst>
            <pc:docMk/>
            <pc:sldMk cId="1910464147" sldId="258"/>
            <ac:spMk id="55" creationId="{60082E9F-BA1B-2BE2-7874-6410BCA97CF1}"/>
          </ac:spMkLst>
        </pc:spChg>
        <pc:spChg chg="del mod topLvl">
          <ac:chgData name="Manish Yadav" userId="4beb67dbd1f8e7f9" providerId="LiveId" clId="{20F0F18A-9429-406C-B392-E549F940441F}" dt="2023-07-03T11:50:09.002" v="445" actId="478"/>
          <ac:spMkLst>
            <pc:docMk/>
            <pc:sldMk cId="1910464147" sldId="258"/>
            <ac:spMk id="56" creationId="{3022B08B-A297-5F03-6980-EBB476E7D3F1}"/>
          </ac:spMkLst>
        </pc:spChg>
        <pc:spChg chg="del mod">
          <ac:chgData name="Manish Yadav" userId="4beb67dbd1f8e7f9" providerId="LiveId" clId="{20F0F18A-9429-406C-B392-E549F940441F}" dt="2023-07-03T11:50:00.697" v="441" actId="478"/>
          <ac:spMkLst>
            <pc:docMk/>
            <pc:sldMk cId="1910464147" sldId="258"/>
            <ac:spMk id="60" creationId="{ACE2157E-329E-48E3-5922-D8B4283CE30C}"/>
          </ac:spMkLst>
        </pc:spChg>
        <pc:spChg chg="mod topLvl">
          <ac:chgData name="Manish Yadav" userId="4beb67dbd1f8e7f9" providerId="LiveId" clId="{20F0F18A-9429-406C-B392-E549F940441F}" dt="2023-07-03T12:00:04.407" v="688" actId="164"/>
          <ac:spMkLst>
            <pc:docMk/>
            <pc:sldMk cId="1910464147" sldId="258"/>
            <ac:spMk id="65" creationId="{DE342C79-C4C3-8FEC-09AB-7624C6A84E00}"/>
          </ac:spMkLst>
        </pc:spChg>
        <pc:spChg chg="del mod topLvl">
          <ac:chgData name="Manish Yadav" userId="4beb67dbd1f8e7f9" providerId="LiveId" clId="{20F0F18A-9429-406C-B392-E549F940441F}" dt="2023-07-03T15:05:25.537" v="2118" actId="478"/>
          <ac:spMkLst>
            <pc:docMk/>
            <pc:sldMk cId="1910464147" sldId="258"/>
            <ac:spMk id="66" creationId="{0CAE3D23-04AC-5F0B-21C0-1298290E522E}"/>
          </ac:spMkLst>
        </pc:spChg>
        <pc:spChg chg="del mod topLvl">
          <ac:chgData name="Manish Yadav" userId="4beb67dbd1f8e7f9" providerId="LiveId" clId="{20F0F18A-9429-406C-B392-E549F940441F}" dt="2023-07-03T15:05:23.757" v="2117" actId="478"/>
          <ac:spMkLst>
            <pc:docMk/>
            <pc:sldMk cId="1910464147" sldId="258"/>
            <ac:spMk id="67" creationId="{A7802961-1B1D-CF52-166B-6852696BB7D2}"/>
          </ac:spMkLst>
        </pc:spChg>
        <pc:spChg chg="mod topLvl">
          <ac:chgData name="Manish Yadav" userId="4beb67dbd1f8e7f9" providerId="LiveId" clId="{20F0F18A-9429-406C-B392-E549F940441F}" dt="2023-07-03T12:04:51.533" v="762" actId="165"/>
          <ac:spMkLst>
            <pc:docMk/>
            <pc:sldMk cId="1910464147" sldId="258"/>
            <ac:spMk id="68" creationId="{A6B997D9-CE3B-E579-B3D7-FCFE0AB2B737}"/>
          </ac:spMkLst>
        </pc:spChg>
        <pc:spChg chg="del mod topLvl">
          <ac:chgData name="Manish Yadav" userId="4beb67dbd1f8e7f9" providerId="LiveId" clId="{20F0F18A-9429-406C-B392-E549F940441F}" dt="2023-07-03T15:05:21.098" v="2116" actId="478"/>
          <ac:spMkLst>
            <pc:docMk/>
            <pc:sldMk cId="1910464147" sldId="258"/>
            <ac:spMk id="69" creationId="{03927E7A-FFA6-7415-3E29-D143EBAFFCE0}"/>
          </ac:spMkLst>
        </pc:spChg>
        <pc:spChg chg="del mod topLvl">
          <ac:chgData name="Manish Yadav" userId="4beb67dbd1f8e7f9" providerId="LiveId" clId="{20F0F18A-9429-406C-B392-E549F940441F}" dt="2023-07-03T15:05:18.013" v="2115" actId="478"/>
          <ac:spMkLst>
            <pc:docMk/>
            <pc:sldMk cId="1910464147" sldId="258"/>
            <ac:spMk id="70" creationId="{7EE8EDD8-D718-9615-FE1A-5942757E5890}"/>
          </ac:spMkLst>
        </pc:spChg>
        <pc:spChg chg="add mod">
          <ac:chgData name="Manish Yadav" userId="4beb67dbd1f8e7f9" providerId="LiveId" clId="{20F0F18A-9429-406C-B392-E549F940441F}" dt="2023-07-03T12:04:28.291" v="741" actId="164"/>
          <ac:spMkLst>
            <pc:docMk/>
            <pc:sldMk cId="1910464147" sldId="258"/>
            <ac:spMk id="77" creationId="{C0777817-E8B9-7324-0E2C-3ED7EFA5154E}"/>
          </ac:spMkLst>
        </pc:spChg>
        <pc:spChg chg="add mod">
          <ac:chgData name="Manish Yadav" userId="4beb67dbd1f8e7f9" providerId="LiveId" clId="{20F0F18A-9429-406C-B392-E549F940441F}" dt="2023-07-03T12:04:51.533" v="762" actId="165"/>
          <ac:spMkLst>
            <pc:docMk/>
            <pc:sldMk cId="1910464147" sldId="258"/>
            <ac:spMk id="79" creationId="{1291A85B-41C6-DFB7-D003-274255E7C0E1}"/>
          </ac:spMkLst>
        </pc:spChg>
        <pc:spChg chg="add mod">
          <ac:chgData name="Manish Yadav" userId="4beb67dbd1f8e7f9" providerId="LiveId" clId="{20F0F18A-9429-406C-B392-E549F940441F}" dt="2023-07-03T12:00:04.407" v="688" actId="164"/>
          <ac:spMkLst>
            <pc:docMk/>
            <pc:sldMk cId="1910464147" sldId="258"/>
            <ac:spMk id="81" creationId="{76895C09-27C5-6268-30C3-35B78138219D}"/>
          </ac:spMkLst>
        </pc:spChg>
        <pc:spChg chg="add del">
          <ac:chgData name="Manish Yadav" userId="4beb67dbd1f8e7f9" providerId="LiveId" clId="{20F0F18A-9429-406C-B392-E549F940441F}" dt="2023-07-03T12:00:31.535" v="712" actId="478"/>
          <ac:spMkLst>
            <pc:docMk/>
            <pc:sldMk cId="1910464147" sldId="258"/>
            <ac:spMk id="86" creationId="{19D4C48F-A4AF-C488-7577-87B3A8A10C43}"/>
          </ac:spMkLst>
        </pc:spChg>
        <pc:spChg chg="add mod topLvl">
          <ac:chgData name="Manish Yadav" userId="4beb67dbd1f8e7f9" providerId="LiveId" clId="{20F0F18A-9429-406C-B392-E549F940441F}" dt="2023-07-03T15:09:04.257" v="2152" actId="1036"/>
          <ac:spMkLst>
            <pc:docMk/>
            <pc:sldMk cId="1910464147" sldId="258"/>
            <ac:spMk id="87" creationId="{2AF65083-D8C1-2796-9367-C17807DE85D3}"/>
          </ac:spMkLst>
        </pc:spChg>
        <pc:spChg chg="add del mod topLvl">
          <ac:chgData name="Manish Yadav" userId="4beb67dbd1f8e7f9" providerId="LiveId" clId="{20F0F18A-9429-406C-B392-E549F940441F}" dt="2023-07-03T12:04:55.855" v="763" actId="478"/>
          <ac:spMkLst>
            <pc:docMk/>
            <pc:sldMk cId="1910464147" sldId="258"/>
            <ac:spMk id="88" creationId="{027F4122-79CA-9E0C-536D-796A1BAB1587}"/>
          </ac:spMkLst>
        </pc:spChg>
        <pc:spChg chg="add del mod">
          <ac:chgData name="Manish Yadav" userId="4beb67dbd1f8e7f9" providerId="LiveId" clId="{20F0F18A-9429-406C-B392-E549F940441F}" dt="2023-07-03T12:31:19.379" v="986" actId="21"/>
          <ac:spMkLst>
            <pc:docMk/>
            <pc:sldMk cId="1910464147" sldId="258"/>
            <ac:spMk id="103" creationId="{1DCAC6B6-40BC-D498-5F64-676E906DD7C8}"/>
          </ac:spMkLst>
        </pc:spChg>
        <pc:grpChg chg="add mod">
          <ac:chgData name="Manish Yadav" userId="4beb67dbd1f8e7f9" providerId="LiveId" clId="{20F0F18A-9429-406C-B392-E549F940441F}" dt="2023-07-03T12:04:28.291" v="741" actId="164"/>
          <ac:grpSpMkLst>
            <pc:docMk/>
            <pc:sldMk cId="1910464147" sldId="258"/>
            <ac:grpSpMk id="4" creationId="{E5270DEE-EBD8-D04C-11D3-E5AA93A58543}"/>
          </ac:grpSpMkLst>
        </pc:grpChg>
        <pc:grpChg chg="mod">
          <ac:chgData name="Manish Yadav" userId="4beb67dbd1f8e7f9" providerId="LiveId" clId="{20F0F18A-9429-406C-B392-E549F940441F}" dt="2023-07-03T11:45:00.558" v="371"/>
          <ac:grpSpMkLst>
            <pc:docMk/>
            <pc:sldMk cId="1910464147" sldId="258"/>
            <ac:grpSpMk id="5" creationId="{6908E5AE-FDA6-0AD4-F25E-604284808EC8}"/>
          </ac:grpSpMkLst>
        </pc:grpChg>
        <pc:grpChg chg="mod">
          <ac:chgData name="Manish Yadav" userId="4beb67dbd1f8e7f9" providerId="LiveId" clId="{20F0F18A-9429-406C-B392-E549F940441F}" dt="2023-07-03T11:45:00.558" v="371"/>
          <ac:grpSpMkLst>
            <pc:docMk/>
            <pc:sldMk cId="1910464147" sldId="258"/>
            <ac:grpSpMk id="11" creationId="{F6353313-3C02-5490-8F0E-2F8F597E0EC6}"/>
          </ac:grpSpMkLst>
        </pc:grpChg>
        <pc:grpChg chg="mod">
          <ac:chgData name="Manish Yadav" userId="4beb67dbd1f8e7f9" providerId="LiveId" clId="{20F0F18A-9429-406C-B392-E549F940441F}" dt="2023-07-03T11:45:00.558" v="371"/>
          <ac:grpSpMkLst>
            <pc:docMk/>
            <pc:sldMk cId="1910464147" sldId="258"/>
            <ac:grpSpMk id="12" creationId="{82B19C65-2947-0C9F-8D8D-CB4E1F17F2CC}"/>
          </ac:grpSpMkLst>
        </pc:grpChg>
        <pc:grpChg chg="mod">
          <ac:chgData name="Manish Yadav" userId="4beb67dbd1f8e7f9" providerId="LiveId" clId="{20F0F18A-9429-406C-B392-E549F940441F}" dt="2023-07-03T11:45:00.558" v="371"/>
          <ac:grpSpMkLst>
            <pc:docMk/>
            <pc:sldMk cId="1910464147" sldId="258"/>
            <ac:grpSpMk id="14" creationId="{6CA7E691-3B3E-4794-9AD5-0EE7E3F2B9DA}"/>
          </ac:grpSpMkLst>
        </pc:grpChg>
        <pc:grpChg chg="mod">
          <ac:chgData name="Manish Yadav" userId="4beb67dbd1f8e7f9" providerId="LiveId" clId="{20F0F18A-9429-406C-B392-E549F940441F}" dt="2023-07-03T11:45:00.558" v="371"/>
          <ac:grpSpMkLst>
            <pc:docMk/>
            <pc:sldMk cId="1910464147" sldId="258"/>
            <ac:grpSpMk id="17" creationId="{B6995B6C-2DBF-FB5C-C00D-12AC8AAD82CE}"/>
          </ac:grpSpMkLst>
        </pc:grpChg>
        <pc:grpChg chg="mod">
          <ac:chgData name="Manish Yadav" userId="4beb67dbd1f8e7f9" providerId="LiveId" clId="{20F0F18A-9429-406C-B392-E549F940441F}" dt="2023-07-03T11:45:00.558" v="371"/>
          <ac:grpSpMkLst>
            <pc:docMk/>
            <pc:sldMk cId="1910464147" sldId="258"/>
            <ac:grpSpMk id="20" creationId="{DD94EDC7-AE28-D0AD-3E7E-6B697865C2DF}"/>
          </ac:grpSpMkLst>
        </pc:grpChg>
        <pc:grpChg chg="add del mod">
          <ac:chgData name="Manish Yadav" userId="4beb67dbd1f8e7f9" providerId="LiveId" clId="{20F0F18A-9429-406C-B392-E549F940441F}" dt="2023-07-03T11:46:27.990" v="435" actId="165"/>
          <ac:grpSpMkLst>
            <pc:docMk/>
            <pc:sldMk cId="1910464147" sldId="258"/>
            <ac:grpSpMk id="41" creationId="{2F75E413-90E3-61CE-1DD4-2451462C994A}"/>
          </ac:grpSpMkLst>
        </pc:grpChg>
        <pc:grpChg chg="del mod topLvl">
          <ac:chgData name="Manish Yadav" userId="4beb67dbd1f8e7f9" providerId="LiveId" clId="{20F0F18A-9429-406C-B392-E549F940441F}" dt="2023-07-03T11:49:51.104" v="439" actId="165"/>
          <ac:grpSpMkLst>
            <pc:docMk/>
            <pc:sldMk cId="1910464147" sldId="258"/>
            <ac:grpSpMk id="42" creationId="{BC0F958C-A958-C215-CB87-9E0C9AFAB97B}"/>
          </ac:grpSpMkLst>
        </pc:grpChg>
        <pc:grpChg chg="del mod topLvl">
          <ac:chgData name="Manish Yadav" userId="4beb67dbd1f8e7f9" providerId="LiveId" clId="{20F0F18A-9429-406C-B392-E549F940441F}" dt="2023-07-03T11:49:56.223" v="440" actId="165"/>
          <ac:grpSpMkLst>
            <pc:docMk/>
            <pc:sldMk cId="1910464147" sldId="258"/>
            <ac:grpSpMk id="48" creationId="{490B5F29-16EA-B0C8-EC55-92A96ED1BF62}"/>
          </ac:grpSpMkLst>
        </pc:grpChg>
        <pc:grpChg chg="del mod topLvl">
          <ac:chgData name="Manish Yadav" userId="4beb67dbd1f8e7f9" providerId="LiveId" clId="{20F0F18A-9429-406C-B392-E549F940441F}" dt="2023-07-03T11:50:06.893" v="444" actId="478"/>
          <ac:grpSpMkLst>
            <pc:docMk/>
            <pc:sldMk cId="1910464147" sldId="258"/>
            <ac:grpSpMk id="49" creationId="{A77C4493-18EC-56C5-3F90-3E89DE675D4B}"/>
          </ac:grpSpMkLst>
        </pc:grpChg>
        <pc:grpChg chg="del mod topLvl">
          <ac:chgData name="Manish Yadav" userId="4beb67dbd1f8e7f9" providerId="LiveId" clId="{20F0F18A-9429-406C-B392-E549F940441F}" dt="2023-07-03T11:50:09.002" v="445" actId="478"/>
          <ac:grpSpMkLst>
            <pc:docMk/>
            <pc:sldMk cId="1910464147" sldId="258"/>
            <ac:grpSpMk id="51" creationId="{2DED22DD-5003-A156-FDBC-78698F1DB58B}"/>
          </ac:grpSpMkLst>
        </pc:grpChg>
        <pc:grpChg chg="del mod topLvl">
          <ac:chgData name="Manish Yadav" userId="4beb67dbd1f8e7f9" providerId="LiveId" clId="{20F0F18A-9429-406C-B392-E549F940441F}" dt="2023-07-03T11:50:31.822" v="454" actId="165"/>
          <ac:grpSpMkLst>
            <pc:docMk/>
            <pc:sldMk cId="1910464147" sldId="258"/>
            <ac:grpSpMk id="54" creationId="{F2CA2FDB-3153-76BF-F702-7A376EF32C07}"/>
          </ac:grpSpMkLst>
        </pc:grpChg>
        <pc:grpChg chg="del mod topLvl">
          <ac:chgData name="Manish Yadav" userId="4beb67dbd1f8e7f9" providerId="LiveId" clId="{20F0F18A-9429-406C-B392-E549F940441F}" dt="2023-07-03T11:50:51.886" v="455" actId="165"/>
          <ac:grpSpMkLst>
            <pc:docMk/>
            <pc:sldMk cId="1910464147" sldId="258"/>
            <ac:grpSpMk id="57" creationId="{9472591B-8D82-C5FD-548A-0427B47E320F}"/>
          </ac:grpSpMkLst>
        </pc:grpChg>
        <pc:grpChg chg="add mod topLvl">
          <ac:chgData name="Manish Yadav" userId="4beb67dbd1f8e7f9" providerId="LiveId" clId="{20F0F18A-9429-406C-B392-E549F940441F}" dt="2023-07-03T15:09:04.257" v="2152" actId="1036"/>
          <ac:grpSpMkLst>
            <pc:docMk/>
            <pc:sldMk cId="1910464147" sldId="258"/>
            <ac:grpSpMk id="84" creationId="{7D7C7E28-7A59-3D8E-BA84-0EB61A7E3E5C}"/>
          </ac:grpSpMkLst>
        </pc:grpChg>
        <pc:grpChg chg="add mod topLvl">
          <ac:chgData name="Manish Yadav" userId="4beb67dbd1f8e7f9" providerId="LiveId" clId="{20F0F18A-9429-406C-B392-E549F940441F}" dt="2023-07-03T15:09:04.257" v="2152" actId="1036"/>
          <ac:grpSpMkLst>
            <pc:docMk/>
            <pc:sldMk cId="1910464147" sldId="258"/>
            <ac:grpSpMk id="85" creationId="{8199635E-0D7B-D5CA-2D4D-3EFC5A3DE41C}"/>
          </ac:grpSpMkLst>
        </pc:grpChg>
        <pc:grpChg chg="add del mod">
          <ac:chgData name="Manish Yadav" userId="4beb67dbd1f8e7f9" providerId="LiveId" clId="{20F0F18A-9429-406C-B392-E549F940441F}" dt="2023-07-03T12:04:55.855" v="763" actId="478"/>
          <ac:grpSpMkLst>
            <pc:docMk/>
            <pc:sldMk cId="1910464147" sldId="258"/>
            <ac:grpSpMk id="89" creationId="{FBB3D857-8DD8-2FB6-DD45-BF9439665636}"/>
          </ac:grpSpMkLst>
        </pc:grpChg>
        <pc:grpChg chg="add del mod">
          <ac:chgData name="Manish Yadav" userId="4beb67dbd1f8e7f9" providerId="LiveId" clId="{20F0F18A-9429-406C-B392-E549F940441F}" dt="2023-07-03T12:04:51.533" v="762" actId="165"/>
          <ac:grpSpMkLst>
            <pc:docMk/>
            <pc:sldMk cId="1910464147" sldId="258"/>
            <ac:grpSpMk id="90" creationId="{5BBB3E9C-3A14-6CB2-7416-976A749AEFD9}"/>
          </ac:grpSpMkLst>
        </pc:grpChg>
        <pc:grpChg chg="add mod">
          <ac:chgData name="Manish Yadav" userId="4beb67dbd1f8e7f9" providerId="LiveId" clId="{20F0F18A-9429-406C-B392-E549F940441F}" dt="2023-07-03T15:09:04.257" v="2152" actId="1036"/>
          <ac:grpSpMkLst>
            <pc:docMk/>
            <pc:sldMk cId="1910464147" sldId="258"/>
            <ac:grpSpMk id="91" creationId="{49703A39-6D10-8535-9996-D72523B96F97}"/>
          </ac:grpSpMkLst>
        </pc:grpChg>
        <pc:picChg chg="mod modCrop">
          <ac:chgData name="Manish Yadav" userId="4beb67dbd1f8e7f9" providerId="LiveId" clId="{20F0F18A-9429-406C-B392-E549F940441F}" dt="2023-07-03T11:56:30.886" v="523" actId="1076"/>
          <ac:picMkLst>
            <pc:docMk/>
            <pc:sldMk cId="1910464147" sldId="258"/>
            <ac:picMk id="21" creationId="{9A50F1A7-ECA2-CC2D-E5C9-24506813FD30}"/>
          </ac:picMkLst>
        </pc:picChg>
        <pc:picChg chg="mod">
          <ac:chgData name="Manish Yadav" userId="4beb67dbd1f8e7f9" providerId="LiveId" clId="{20F0F18A-9429-406C-B392-E549F940441F}" dt="2023-07-03T11:45:00.558" v="371"/>
          <ac:picMkLst>
            <pc:docMk/>
            <pc:sldMk cId="1910464147" sldId="258"/>
            <ac:picMk id="22" creationId="{80F18D4F-3407-D3DA-D5C5-700989888CE2}"/>
          </ac:picMkLst>
        </pc:picChg>
        <pc:picChg chg="mod topLvl modCrop">
          <ac:chgData name="Manish Yadav" userId="4beb67dbd1f8e7f9" providerId="LiveId" clId="{20F0F18A-9429-406C-B392-E549F940441F}" dt="2023-07-03T12:00:04.407" v="688" actId="164"/>
          <ac:picMkLst>
            <pc:docMk/>
            <pc:sldMk cId="1910464147" sldId="258"/>
            <ac:picMk id="58" creationId="{CA9E8E6C-0D0F-8A91-4A9E-0FF8D4AF48B6}"/>
          </ac:picMkLst>
        </pc:picChg>
        <pc:picChg chg="mod topLvl modCrop">
          <ac:chgData name="Manish Yadav" userId="4beb67dbd1f8e7f9" providerId="LiveId" clId="{20F0F18A-9429-406C-B392-E549F940441F}" dt="2023-07-03T12:04:51.533" v="762" actId="165"/>
          <ac:picMkLst>
            <pc:docMk/>
            <pc:sldMk cId="1910464147" sldId="258"/>
            <ac:picMk id="59" creationId="{95956E4E-9DFD-7F1D-863B-AA7BA0D9D0DE}"/>
          </ac:picMkLst>
        </pc:picChg>
        <pc:picChg chg="add del mod">
          <ac:chgData name="Manish Yadav" userId="4beb67dbd1f8e7f9" providerId="LiveId" clId="{20F0F18A-9429-406C-B392-E549F940441F}" dt="2023-07-03T11:54:56.385" v="498" actId="478"/>
          <ac:picMkLst>
            <pc:docMk/>
            <pc:sldMk cId="1910464147" sldId="258"/>
            <ac:picMk id="78" creationId="{32AA1F61-06CB-8325-EB23-D33D343D3F6E}"/>
          </ac:picMkLst>
        </pc:picChg>
        <pc:picChg chg="add del mod">
          <ac:chgData name="Manish Yadav" userId="4beb67dbd1f8e7f9" providerId="LiveId" clId="{20F0F18A-9429-406C-B392-E549F940441F}" dt="2023-07-03T11:57:27.809" v="671" actId="478"/>
          <ac:picMkLst>
            <pc:docMk/>
            <pc:sldMk cId="1910464147" sldId="258"/>
            <ac:picMk id="80" creationId="{DA2C753F-8191-B23F-C18D-08830604DF69}"/>
          </ac:picMkLst>
        </pc:pic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24" creationId="{14C6B780-5A0C-ED02-2B1B-7EC4F62C05E2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25" creationId="{02DBDC9B-CBB5-EFD2-2C80-00B4DBFCC2D7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26" creationId="{572EC5C1-1C97-FB3C-43FD-F4B8C3CC4FB7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27" creationId="{D15D2583-78B2-33D8-D28E-D35BB1E51FE5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34" creationId="{5CBD42FC-9914-CB42-B04E-CDF26985FD0A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35" creationId="{46A6DFD3-8528-EC18-AE1A-841AB873DE45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36" creationId="{4764AEAB-0FB1-D5EB-E473-DD825816A083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37" creationId="{0331F3A3-2C16-C4A5-835D-D8809418ED0F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38" creationId="{42816FF0-69BB-C5A9-1404-1891C2A6B21E}"/>
          </ac:cxnSpMkLst>
        </pc:cxnChg>
        <pc:cxnChg chg="mod">
          <ac:chgData name="Manish Yadav" userId="4beb67dbd1f8e7f9" providerId="LiveId" clId="{20F0F18A-9429-406C-B392-E549F940441F}" dt="2023-07-03T11:45:00.558" v="371"/>
          <ac:cxnSpMkLst>
            <pc:docMk/>
            <pc:sldMk cId="1910464147" sldId="258"/>
            <ac:cxnSpMk id="39" creationId="{09B7EDAD-9EEC-7B13-DE28-822A7648F6F3}"/>
          </ac:cxnSpMkLst>
        </pc:cxnChg>
        <pc:cxnChg chg="del mod">
          <ac:chgData name="Manish Yadav" userId="4beb67dbd1f8e7f9" providerId="LiveId" clId="{20F0F18A-9429-406C-B392-E549F940441F}" dt="2023-07-03T11:50:16.123" v="449" actId="478"/>
          <ac:cxnSpMkLst>
            <pc:docMk/>
            <pc:sldMk cId="1910464147" sldId="258"/>
            <ac:cxnSpMk id="61" creationId="{E390AFB5-B6D6-8D60-63CD-E5A173066CAF}"/>
          </ac:cxnSpMkLst>
        </pc:cxnChg>
        <pc:cxnChg chg="del mod">
          <ac:chgData name="Manish Yadav" userId="4beb67dbd1f8e7f9" providerId="LiveId" clId="{20F0F18A-9429-406C-B392-E549F940441F}" dt="2023-07-03T11:50:18.326" v="450" actId="478"/>
          <ac:cxnSpMkLst>
            <pc:docMk/>
            <pc:sldMk cId="1910464147" sldId="258"/>
            <ac:cxnSpMk id="62" creationId="{28D6B860-FB9F-001B-95DA-A1343CCB4D0B}"/>
          </ac:cxnSpMkLst>
        </pc:cxnChg>
        <pc:cxnChg chg="del mod">
          <ac:chgData name="Manish Yadav" userId="4beb67dbd1f8e7f9" providerId="LiveId" clId="{20F0F18A-9429-406C-B392-E549F940441F}" dt="2023-07-03T11:50:19.996" v="451" actId="478"/>
          <ac:cxnSpMkLst>
            <pc:docMk/>
            <pc:sldMk cId="1910464147" sldId="258"/>
            <ac:cxnSpMk id="63" creationId="{D1BD6FF1-E624-FA49-3E9A-AF5137918018}"/>
          </ac:cxnSpMkLst>
        </pc:cxnChg>
        <pc:cxnChg chg="del mod">
          <ac:chgData name="Manish Yadav" userId="4beb67dbd1f8e7f9" providerId="LiveId" clId="{20F0F18A-9429-406C-B392-E549F940441F}" dt="2023-07-03T11:50:26.707" v="453" actId="478"/>
          <ac:cxnSpMkLst>
            <pc:docMk/>
            <pc:sldMk cId="1910464147" sldId="258"/>
            <ac:cxnSpMk id="64" creationId="{C19F1CA2-C8E8-AC3C-CF59-468AADD797F7}"/>
          </ac:cxnSpMkLst>
        </pc:cxnChg>
        <pc:cxnChg chg="mod topLvl">
          <ac:chgData name="Manish Yadav" userId="4beb67dbd1f8e7f9" providerId="LiveId" clId="{20F0F18A-9429-406C-B392-E549F940441F}" dt="2023-07-03T12:04:51.533" v="762" actId="165"/>
          <ac:cxnSpMkLst>
            <pc:docMk/>
            <pc:sldMk cId="1910464147" sldId="258"/>
            <ac:cxnSpMk id="71" creationId="{84E42C74-E36E-6CC0-002D-631570733247}"/>
          </ac:cxnSpMkLst>
        </pc:cxnChg>
        <pc:cxnChg chg="mod topLvl">
          <ac:chgData name="Manish Yadav" userId="4beb67dbd1f8e7f9" providerId="LiveId" clId="{20F0F18A-9429-406C-B392-E549F940441F}" dt="2023-07-03T12:04:51.533" v="762" actId="165"/>
          <ac:cxnSpMkLst>
            <pc:docMk/>
            <pc:sldMk cId="1910464147" sldId="258"/>
            <ac:cxnSpMk id="72" creationId="{87B5E260-DBD6-79FD-B098-30BDC025B2B8}"/>
          </ac:cxnSpMkLst>
        </pc:cxnChg>
        <pc:cxnChg chg="mod topLvl">
          <ac:chgData name="Manish Yadav" userId="4beb67dbd1f8e7f9" providerId="LiveId" clId="{20F0F18A-9429-406C-B392-E549F940441F}" dt="2023-07-03T12:04:51.533" v="762" actId="165"/>
          <ac:cxnSpMkLst>
            <pc:docMk/>
            <pc:sldMk cId="1910464147" sldId="258"/>
            <ac:cxnSpMk id="73" creationId="{4F792334-67EC-863E-6649-BC3E13A38F17}"/>
          </ac:cxnSpMkLst>
        </pc:cxnChg>
        <pc:cxnChg chg="mod topLvl">
          <ac:chgData name="Manish Yadav" userId="4beb67dbd1f8e7f9" providerId="LiveId" clId="{20F0F18A-9429-406C-B392-E549F940441F}" dt="2023-07-03T12:00:04.407" v="688" actId="164"/>
          <ac:cxnSpMkLst>
            <pc:docMk/>
            <pc:sldMk cId="1910464147" sldId="258"/>
            <ac:cxnSpMk id="74" creationId="{288817EA-6A23-BD54-3DB8-BC0089095F8E}"/>
          </ac:cxnSpMkLst>
        </pc:cxnChg>
        <pc:cxnChg chg="mod topLvl">
          <ac:chgData name="Manish Yadav" userId="4beb67dbd1f8e7f9" providerId="LiveId" clId="{20F0F18A-9429-406C-B392-E549F940441F}" dt="2023-07-03T12:00:04.407" v="688" actId="164"/>
          <ac:cxnSpMkLst>
            <pc:docMk/>
            <pc:sldMk cId="1910464147" sldId="258"/>
            <ac:cxnSpMk id="75" creationId="{541FCAA8-E512-F00C-13A2-BE491564D32F}"/>
          </ac:cxnSpMkLst>
        </pc:cxnChg>
        <pc:cxnChg chg="mod topLvl">
          <ac:chgData name="Manish Yadav" userId="4beb67dbd1f8e7f9" providerId="LiveId" clId="{20F0F18A-9429-406C-B392-E549F940441F}" dt="2023-07-03T12:00:04.407" v="688" actId="164"/>
          <ac:cxnSpMkLst>
            <pc:docMk/>
            <pc:sldMk cId="1910464147" sldId="258"/>
            <ac:cxnSpMk id="76" creationId="{973690D6-9429-B72D-AF0D-05846F4FD86F}"/>
          </ac:cxnSpMkLst>
        </pc:cxnChg>
        <pc:cxnChg chg="add del">
          <ac:chgData name="Manish Yadav" userId="4beb67dbd1f8e7f9" providerId="LiveId" clId="{20F0F18A-9429-406C-B392-E549F940441F}" dt="2023-07-03T11:59:49.906" v="687" actId="478"/>
          <ac:cxnSpMkLst>
            <pc:docMk/>
            <pc:sldMk cId="1910464147" sldId="258"/>
            <ac:cxnSpMk id="83" creationId="{D9A83A5A-7C77-7553-C524-4CBF567D7835}"/>
          </ac:cxnSpMkLst>
        </pc:cxnChg>
        <pc:cxnChg chg="add mod">
          <ac:chgData name="Manish Yadav" userId="4beb67dbd1f8e7f9" providerId="LiveId" clId="{20F0F18A-9429-406C-B392-E549F940441F}" dt="2023-07-03T15:09:04.257" v="2152" actId="1036"/>
          <ac:cxnSpMkLst>
            <pc:docMk/>
            <pc:sldMk cId="1910464147" sldId="258"/>
            <ac:cxnSpMk id="93" creationId="{76058F5F-263C-9D71-09B0-C307F7D6436A}"/>
          </ac:cxnSpMkLst>
        </pc:cxnChg>
        <pc:cxnChg chg="add mod">
          <ac:chgData name="Manish Yadav" userId="4beb67dbd1f8e7f9" providerId="LiveId" clId="{20F0F18A-9429-406C-B392-E549F940441F}" dt="2023-07-03T15:09:04.257" v="2152" actId="1036"/>
          <ac:cxnSpMkLst>
            <pc:docMk/>
            <pc:sldMk cId="1910464147" sldId="258"/>
            <ac:cxnSpMk id="96" creationId="{E6237B8D-700D-4943-92B6-070526E72166}"/>
          </ac:cxnSpMkLst>
        </pc:cxnChg>
      </pc:sldChg>
      <pc:sldChg chg="addSp delSp modSp new mod">
        <pc:chgData name="Manish Yadav" userId="4beb67dbd1f8e7f9" providerId="LiveId" clId="{20F0F18A-9429-406C-B392-E549F940441F}" dt="2023-07-03T15:09:16.460" v="2163" actId="1036"/>
        <pc:sldMkLst>
          <pc:docMk/>
          <pc:sldMk cId="2940019726" sldId="259"/>
        </pc:sldMkLst>
        <pc:spChg chg="del">
          <ac:chgData name="Manish Yadav" userId="4beb67dbd1f8e7f9" providerId="LiveId" clId="{20F0F18A-9429-406C-B392-E549F940441F}" dt="2023-07-03T12:21:23.880" v="805" actId="478"/>
          <ac:spMkLst>
            <pc:docMk/>
            <pc:sldMk cId="2940019726" sldId="259"/>
            <ac:spMk id="2" creationId="{A89DE16C-336C-4743-A08C-6C0D9B8102F5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5" creationId="{E964E1DC-84CE-B60D-1469-EFD7C14390E9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6" creationId="{614C34B7-BEB8-08BC-07E6-FCD8E665AFD5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8" creationId="{A2C080BC-67AD-05C9-E7AC-9805CE4DC074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11" creationId="{AE6EB446-38D1-AEE6-A913-A6F7CEA674B4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18" creationId="{781EE77C-BEB5-C4EC-E53D-F2CE92D5491D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19" creationId="{A7C02E8F-E03B-2D04-7787-CE95B4BDE658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0" creationId="{CC51B931-D916-DA47-A271-0969AA9FFD78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1" creationId="{EE9969BC-7156-2C8D-2DB3-2BE71ECEDAB0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2" creationId="{9CA1B3E6-55DC-83A0-E886-3C72551EF76F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3" creationId="{FB2A869E-1860-E9B4-D3C3-862A48BF79DE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4" creationId="{21647AB1-1D7D-B538-EAFB-EE11D0DAB9DF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5" creationId="{1FD5782A-C3DC-7794-DB05-CB37197D2544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6" creationId="{B7B67A6E-4835-87F2-8541-2F9374AA626C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7" creationId="{B5200741-70E1-7B51-2659-0D62E8583991}"/>
          </ac:spMkLst>
        </pc:spChg>
        <pc:spChg chg="mod">
          <ac:chgData name="Manish Yadav" userId="4beb67dbd1f8e7f9" providerId="LiveId" clId="{20F0F18A-9429-406C-B392-E549F940441F}" dt="2023-07-03T12:17:21.226" v="801"/>
          <ac:spMkLst>
            <pc:docMk/>
            <pc:sldMk cId="2940019726" sldId="259"/>
            <ac:spMk id="28" creationId="{07994175-AB89-63B4-C940-F41673DD7C74}"/>
          </ac:spMkLst>
        </pc:spChg>
        <pc:spChg chg="del mod topLvl">
          <ac:chgData name="Manish Yadav" userId="4beb67dbd1f8e7f9" providerId="LiveId" clId="{20F0F18A-9429-406C-B392-E549F940441F}" dt="2023-07-03T12:22:54.715" v="829" actId="478"/>
          <ac:spMkLst>
            <pc:docMk/>
            <pc:sldMk cId="2940019726" sldId="259"/>
            <ac:spMk id="31" creationId="{414DF9C0-B272-79AF-B7BB-622D9B63E114}"/>
          </ac:spMkLst>
        </pc:spChg>
        <pc:spChg chg="del mod">
          <ac:chgData name="Manish Yadav" userId="4beb67dbd1f8e7f9" providerId="LiveId" clId="{20F0F18A-9429-406C-B392-E549F940441F}" dt="2023-07-03T12:22:36.730" v="824" actId="478"/>
          <ac:spMkLst>
            <pc:docMk/>
            <pc:sldMk cId="2940019726" sldId="259"/>
            <ac:spMk id="32" creationId="{C9273B4C-3916-0D04-9CF9-7976B3A6E954}"/>
          </ac:spMkLst>
        </pc:spChg>
        <pc:spChg chg="del mod">
          <ac:chgData name="Manish Yadav" userId="4beb67dbd1f8e7f9" providerId="LiveId" clId="{20F0F18A-9429-406C-B392-E549F940441F}" dt="2023-07-03T12:22:51.653" v="828" actId="478"/>
          <ac:spMkLst>
            <pc:docMk/>
            <pc:sldMk cId="2940019726" sldId="259"/>
            <ac:spMk id="34" creationId="{E184DEAD-D25B-D646-6E86-E4B367755008}"/>
          </ac:spMkLst>
        </pc:spChg>
        <pc:spChg chg="mod">
          <ac:chgData name="Manish Yadav" userId="4beb67dbd1f8e7f9" providerId="LiveId" clId="{20F0F18A-9429-406C-B392-E549F940441F}" dt="2023-07-03T12:24:24.758" v="841" actId="1038"/>
          <ac:spMkLst>
            <pc:docMk/>
            <pc:sldMk cId="2940019726" sldId="259"/>
            <ac:spMk id="37" creationId="{A5D0F88D-E5F9-EB33-09BA-13AD22FE3367}"/>
          </ac:spMkLst>
        </pc:spChg>
        <pc:spChg chg="del mod">
          <ac:chgData name="Manish Yadav" userId="4beb67dbd1f8e7f9" providerId="LiveId" clId="{20F0F18A-9429-406C-B392-E549F940441F}" dt="2023-07-03T12:22:40.976" v="825" actId="478"/>
          <ac:spMkLst>
            <pc:docMk/>
            <pc:sldMk cId="2940019726" sldId="259"/>
            <ac:spMk id="44" creationId="{3F5A9204-6A70-F4BA-61B4-EB1C4CB21978}"/>
          </ac:spMkLst>
        </pc:spChg>
        <pc:spChg chg="mod">
          <ac:chgData name="Manish Yadav" userId="4beb67dbd1f8e7f9" providerId="LiveId" clId="{20F0F18A-9429-406C-B392-E549F940441F}" dt="2023-07-03T12:21:12.875" v="803"/>
          <ac:spMkLst>
            <pc:docMk/>
            <pc:sldMk cId="2940019726" sldId="259"/>
            <ac:spMk id="45" creationId="{43EBEAFE-A849-FC4F-8DD4-DAA6B281953F}"/>
          </ac:spMkLst>
        </pc:spChg>
        <pc:spChg chg="del mod">
          <ac:chgData name="Manish Yadav" userId="4beb67dbd1f8e7f9" providerId="LiveId" clId="{20F0F18A-9429-406C-B392-E549F940441F}" dt="2023-07-03T15:05:45.760" v="2120" actId="478"/>
          <ac:spMkLst>
            <pc:docMk/>
            <pc:sldMk cId="2940019726" sldId="259"/>
            <ac:spMk id="46" creationId="{6F8B8A34-95FD-FC59-CE1D-1BA9E674DD54}"/>
          </ac:spMkLst>
        </pc:spChg>
        <pc:spChg chg="del mod">
          <ac:chgData name="Manish Yadav" userId="4beb67dbd1f8e7f9" providerId="LiveId" clId="{20F0F18A-9429-406C-B392-E549F940441F}" dt="2023-07-03T15:05:43.548" v="2119" actId="478"/>
          <ac:spMkLst>
            <pc:docMk/>
            <pc:sldMk cId="2940019726" sldId="259"/>
            <ac:spMk id="47" creationId="{4F139F69-D456-B6F3-2F46-FC2DF4AEE2A9}"/>
          </ac:spMkLst>
        </pc:spChg>
        <pc:spChg chg="del mod">
          <ac:chgData name="Manish Yadav" userId="4beb67dbd1f8e7f9" providerId="LiveId" clId="{20F0F18A-9429-406C-B392-E549F940441F}" dt="2023-07-03T12:24:20.476" v="837" actId="478"/>
          <ac:spMkLst>
            <pc:docMk/>
            <pc:sldMk cId="2940019726" sldId="259"/>
            <ac:spMk id="48" creationId="{B422A68D-B852-C906-303E-25E751D948F9}"/>
          </ac:spMkLst>
        </pc:spChg>
        <pc:spChg chg="del mod">
          <ac:chgData name="Manish Yadav" userId="4beb67dbd1f8e7f9" providerId="LiveId" clId="{20F0F18A-9429-406C-B392-E549F940441F}" dt="2023-07-03T12:24:17.526" v="835" actId="478"/>
          <ac:spMkLst>
            <pc:docMk/>
            <pc:sldMk cId="2940019726" sldId="259"/>
            <ac:spMk id="49" creationId="{4639DDE4-D382-AD01-ADBC-C6142C0CFD5A}"/>
          </ac:spMkLst>
        </pc:spChg>
        <pc:spChg chg="del mod">
          <ac:chgData name="Manish Yadav" userId="4beb67dbd1f8e7f9" providerId="LiveId" clId="{20F0F18A-9429-406C-B392-E549F940441F}" dt="2023-07-03T12:24:18.943" v="836" actId="478"/>
          <ac:spMkLst>
            <pc:docMk/>
            <pc:sldMk cId="2940019726" sldId="259"/>
            <ac:spMk id="50" creationId="{75010664-823C-6A3A-8F19-8E244980704E}"/>
          </ac:spMkLst>
        </pc:spChg>
        <pc:spChg chg="del mod">
          <ac:chgData name="Manish Yadav" userId="4beb67dbd1f8e7f9" providerId="LiveId" clId="{20F0F18A-9429-406C-B392-E549F940441F}" dt="2023-07-03T12:24:11.206" v="832" actId="478"/>
          <ac:spMkLst>
            <pc:docMk/>
            <pc:sldMk cId="2940019726" sldId="259"/>
            <ac:spMk id="51" creationId="{23CADA33-6424-67B1-4558-ECC28233A55B}"/>
          </ac:spMkLst>
        </pc:spChg>
        <pc:spChg chg="del mod">
          <ac:chgData name="Manish Yadav" userId="4beb67dbd1f8e7f9" providerId="LiveId" clId="{20F0F18A-9429-406C-B392-E549F940441F}" dt="2023-07-03T12:24:15.466" v="834" actId="478"/>
          <ac:spMkLst>
            <pc:docMk/>
            <pc:sldMk cId="2940019726" sldId="259"/>
            <ac:spMk id="52" creationId="{B9A469B9-742B-0060-1553-EF4106C08942}"/>
          </ac:spMkLst>
        </pc:spChg>
        <pc:spChg chg="del mod">
          <ac:chgData name="Manish Yadav" userId="4beb67dbd1f8e7f9" providerId="LiveId" clId="{20F0F18A-9429-406C-B392-E549F940441F}" dt="2023-07-03T12:24:06.803" v="831" actId="478"/>
          <ac:spMkLst>
            <pc:docMk/>
            <pc:sldMk cId="2940019726" sldId="259"/>
            <ac:spMk id="53" creationId="{C0D6084D-0687-8C1D-738A-1708501768BE}"/>
          </ac:spMkLst>
        </pc:spChg>
        <pc:spChg chg="del mod">
          <ac:chgData name="Manish Yadav" userId="4beb67dbd1f8e7f9" providerId="LiveId" clId="{20F0F18A-9429-406C-B392-E549F940441F}" dt="2023-07-03T12:24:13.851" v="833" actId="478"/>
          <ac:spMkLst>
            <pc:docMk/>
            <pc:sldMk cId="2940019726" sldId="259"/>
            <ac:spMk id="54" creationId="{2920AE90-A913-EAED-EBAC-92132125B335}"/>
          </ac:spMkLst>
        </pc:spChg>
        <pc:spChg chg="del mod">
          <ac:chgData name="Manish Yadav" userId="4beb67dbd1f8e7f9" providerId="LiveId" clId="{20F0F18A-9429-406C-B392-E549F940441F}" dt="2023-07-03T15:05:48.051" v="2121" actId="478"/>
          <ac:spMkLst>
            <pc:docMk/>
            <pc:sldMk cId="2940019726" sldId="259"/>
            <ac:spMk id="57" creationId="{F3EC4CBD-0DC3-9BCD-C2E6-E672EEBB7D92}"/>
          </ac:spMkLst>
        </pc:spChg>
        <pc:spChg chg="mod">
          <ac:chgData name="Manish Yadav" userId="4beb67dbd1f8e7f9" providerId="LiveId" clId="{20F0F18A-9429-406C-B392-E549F940441F}" dt="2023-07-03T12:21:40.093" v="808"/>
          <ac:spMkLst>
            <pc:docMk/>
            <pc:sldMk cId="2940019726" sldId="259"/>
            <ac:spMk id="58" creationId="{7486DAEE-53EF-20AF-C53E-0FA83A773C3C}"/>
          </ac:spMkLst>
        </pc:spChg>
        <pc:spChg chg="mod">
          <ac:chgData name="Manish Yadav" userId="4beb67dbd1f8e7f9" providerId="LiveId" clId="{20F0F18A-9429-406C-B392-E549F940441F}" dt="2023-07-03T12:21:40.093" v="808"/>
          <ac:spMkLst>
            <pc:docMk/>
            <pc:sldMk cId="2940019726" sldId="259"/>
            <ac:spMk id="60" creationId="{16E7B726-DD48-34E0-1004-5795C60946A2}"/>
          </ac:spMkLst>
        </pc:spChg>
        <pc:spChg chg="del mod">
          <ac:chgData name="Manish Yadav" userId="4beb67dbd1f8e7f9" providerId="LiveId" clId="{20F0F18A-9429-406C-B392-E549F940441F}" dt="2023-07-03T12:26:21.510" v="870" actId="478"/>
          <ac:spMkLst>
            <pc:docMk/>
            <pc:sldMk cId="2940019726" sldId="259"/>
            <ac:spMk id="63" creationId="{DD205238-C130-FFF7-1AF3-15AE692B2060}"/>
          </ac:spMkLst>
        </pc:spChg>
        <pc:spChg chg="del mod">
          <ac:chgData name="Manish Yadav" userId="4beb67dbd1f8e7f9" providerId="LiveId" clId="{20F0F18A-9429-406C-B392-E549F940441F}" dt="2023-07-03T15:05:49.682" v="2122" actId="478"/>
          <ac:spMkLst>
            <pc:docMk/>
            <pc:sldMk cId="2940019726" sldId="259"/>
            <ac:spMk id="70" creationId="{9F0B3C98-E4BD-EFFB-788B-104CE7A90739}"/>
          </ac:spMkLst>
        </pc:spChg>
        <pc:spChg chg="del mod">
          <ac:chgData name="Manish Yadav" userId="4beb67dbd1f8e7f9" providerId="LiveId" clId="{20F0F18A-9429-406C-B392-E549F940441F}" dt="2023-07-03T12:26:06.423" v="863" actId="478"/>
          <ac:spMkLst>
            <pc:docMk/>
            <pc:sldMk cId="2940019726" sldId="259"/>
            <ac:spMk id="71" creationId="{3677F6C1-75F5-8D10-EEE2-2673BC732FBE}"/>
          </ac:spMkLst>
        </pc:spChg>
        <pc:spChg chg="del mod">
          <ac:chgData name="Manish Yadav" userId="4beb67dbd1f8e7f9" providerId="LiveId" clId="{20F0F18A-9429-406C-B392-E549F940441F}" dt="2023-07-03T12:26:12.418" v="866" actId="478"/>
          <ac:spMkLst>
            <pc:docMk/>
            <pc:sldMk cId="2940019726" sldId="259"/>
            <ac:spMk id="72" creationId="{21FED3DE-6758-7D4B-52A5-9060A30C7D88}"/>
          </ac:spMkLst>
        </pc:spChg>
        <pc:spChg chg="del mod">
          <ac:chgData name="Manish Yadav" userId="4beb67dbd1f8e7f9" providerId="LiveId" clId="{20F0F18A-9429-406C-B392-E549F940441F}" dt="2023-07-03T12:26:02.440" v="862" actId="478"/>
          <ac:spMkLst>
            <pc:docMk/>
            <pc:sldMk cId="2940019726" sldId="259"/>
            <ac:spMk id="73" creationId="{C519968A-3E70-3957-AD4F-1A896B33128A}"/>
          </ac:spMkLst>
        </pc:spChg>
        <pc:spChg chg="del mod">
          <ac:chgData name="Manish Yadav" userId="4beb67dbd1f8e7f9" providerId="LiveId" clId="{20F0F18A-9429-406C-B392-E549F940441F}" dt="2023-07-03T12:25:59.239" v="861" actId="478"/>
          <ac:spMkLst>
            <pc:docMk/>
            <pc:sldMk cId="2940019726" sldId="259"/>
            <ac:spMk id="74" creationId="{430D6A88-F237-D203-6943-17C3AF8F4987}"/>
          </ac:spMkLst>
        </pc:spChg>
        <pc:spChg chg="del mod">
          <ac:chgData name="Manish Yadav" userId="4beb67dbd1f8e7f9" providerId="LiveId" clId="{20F0F18A-9429-406C-B392-E549F940441F}" dt="2023-07-03T12:25:52.003" v="857" actId="478"/>
          <ac:spMkLst>
            <pc:docMk/>
            <pc:sldMk cId="2940019726" sldId="259"/>
            <ac:spMk id="75" creationId="{79B77FBF-2A62-A853-0DFE-3904435824DF}"/>
          </ac:spMkLst>
        </pc:spChg>
        <pc:spChg chg="del mod">
          <ac:chgData name="Manish Yadav" userId="4beb67dbd1f8e7f9" providerId="LiveId" clId="{20F0F18A-9429-406C-B392-E549F940441F}" dt="2023-07-03T12:25:57.379" v="860" actId="478"/>
          <ac:spMkLst>
            <pc:docMk/>
            <pc:sldMk cId="2940019726" sldId="259"/>
            <ac:spMk id="76" creationId="{AB744E04-42C6-859B-648E-F61B6AF4E53A}"/>
          </ac:spMkLst>
        </pc:spChg>
        <pc:spChg chg="del mod">
          <ac:chgData name="Manish Yadav" userId="4beb67dbd1f8e7f9" providerId="LiveId" clId="{20F0F18A-9429-406C-B392-E549F940441F}" dt="2023-07-03T12:25:53.791" v="858" actId="478"/>
          <ac:spMkLst>
            <pc:docMk/>
            <pc:sldMk cId="2940019726" sldId="259"/>
            <ac:spMk id="77" creationId="{0F4E7CC8-A10C-1939-FB05-A46E833069DC}"/>
          </ac:spMkLst>
        </pc:spChg>
        <pc:spChg chg="del mod">
          <ac:chgData name="Manish Yadav" userId="4beb67dbd1f8e7f9" providerId="LiveId" clId="{20F0F18A-9429-406C-B392-E549F940441F}" dt="2023-07-03T12:25:55.676" v="859" actId="478"/>
          <ac:spMkLst>
            <pc:docMk/>
            <pc:sldMk cId="2940019726" sldId="259"/>
            <ac:spMk id="78" creationId="{C168AD11-FE8B-FD6B-FFD8-B7F499D70C2D}"/>
          </ac:spMkLst>
        </pc:spChg>
        <pc:spChg chg="del mod">
          <ac:chgData name="Manish Yadav" userId="4beb67dbd1f8e7f9" providerId="LiveId" clId="{20F0F18A-9429-406C-B392-E549F940441F}" dt="2023-07-03T12:25:49.472" v="856" actId="478"/>
          <ac:spMkLst>
            <pc:docMk/>
            <pc:sldMk cId="2940019726" sldId="259"/>
            <ac:spMk id="79" creationId="{8D6DD868-B87D-F5C2-B782-6CDD7AC065A9}"/>
          </ac:spMkLst>
        </pc:spChg>
        <pc:spChg chg="del mod">
          <ac:chgData name="Manish Yadav" userId="4beb67dbd1f8e7f9" providerId="LiveId" clId="{20F0F18A-9429-406C-B392-E549F940441F}" dt="2023-07-03T12:25:47.109" v="855" actId="478"/>
          <ac:spMkLst>
            <pc:docMk/>
            <pc:sldMk cId="2940019726" sldId="259"/>
            <ac:spMk id="80" creationId="{0DF3AD35-9211-6BD1-BBAF-53241DE9E923}"/>
          </ac:spMkLst>
        </pc:spChg>
        <pc:spChg chg="add mod">
          <ac:chgData name="Manish Yadav" userId="4beb67dbd1f8e7f9" providerId="LiveId" clId="{20F0F18A-9429-406C-B392-E549F940441F}" dt="2023-07-03T15:09:16.460" v="2163" actId="1036"/>
          <ac:spMkLst>
            <pc:docMk/>
            <pc:sldMk cId="2940019726" sldId="259"/>
            <ac:spMk id="81" creationId="{5F4624D8-7971-CF42-E1AE-CE517AB2B9FC}"/>
          </ac:spMkLst>
        </pc:spChg>
        <pc:spChg chg="add mod">
          <ac:chgData name="Manish Yadav" userId="4beb67dbd1f8e7f9" providerId="LiveId" clId="{20F0F18A-9429-406C-B392-E549F940441F}" dt="2023-07-03T15:09:16.460" v="2163" actId="1036"/>
          <ac:spMkLst>
            <pc:docMk/>
            <pc:sldMk cId="2940019726" sldId="259"/>
            <ac:spMk id="82" creationId="{330E5890-7145-8C51-859B-6F10018B404D}"/>
          </ac:spMkLst>
        </pc:spChg>
        <pc:spChg chg="add mod">
          <ac:chgData name="Manish Yadav" userId="4beb67dbd1f8e7f9" providerId="LiveId" clId="{20F0F18A-9429-406C-B392-E549F940441F}" dt="2023-07-03T14:57:40.921" v="1870" actId="164"/>
          <ac:spMkLst>
            <pc:docMk/>
            <pc:sldMk cId="2940019726" sldId="259"/>
            <ac:spMk id="88" creationId="{D8588E65-125B-88FE-6BD6-03CF14B5369C}"/>
          </ac:spMkLst>
        </pc:spChg>
        <pc:spChg chg="add del mod">
          <ac:chgData name="Manish Yadav" userId="4beb67dbd1f8e7f9" providerId="LiveId" clId="{20F0F18A-9429-406C-B392-E549F940441F}" dt="2023-07-03T14:49:55.099" v="1557" actId="478"/>
          <ac:spMkLst>
            <pc:docMk/>
            <pc:sldMk cId="2940019726" sldId="259"/>
            <ac:spMk id="91" creationId="{E00EE6F7-C271-7D12-F561-758C72CCBB10}"/>
          </ac:spMkLst>
        </pc:spChg>
        <pc:spChg chg="add mod">
          <ac:chgData name="Manish Yadav" userId="4beb67dbd1f8e7f9" providerId="LiveId" clId="{20F0F18A-9429-406C-B392-E549F940441F}" dt="2023-07-03T14:49:57.412" v="1558" actId="1076"/>
          <ac:spMkLst>
            <pc:docMk/>
            <pc:sldMk cId="2940019726" sldId="259"/>
            <ac:spMk id="92" creationId="{CF8BE0E3-7CFB-A7F7-D2AB-F86E6C69DD8A}"/>
          </ac:spMkLst>
        </pc:spChg>
        <pc:spChg chg="add mod">
          <ac:chgData name="Manish Yadav" userId="4beb67dbd1f8e7f9" providerId="LiveId" clId="{20F0F18A-9429-406C-B392-E549F940441F}" dt="2023-07-03T14:57:46.437" v="1871" actId="164"/>
          <ac:spMkLst>
            <pc:docMk/>
            <pc:sldMk cId="2940019726" sldId="259"/>
            <ac:spMk id="94" creationId="{6B9D0093-D2B8-1F59-C1A1-02B8CA758E09}"/>
          </ac:spMkLst>
        </pc:spChg>
        <pc:spChg chg="add del mod">
          <ac:chgData name="Manish Yadav" userId="4beb67dbd1f8e7f9" providerId="LiveId" clId="{20F0F18A-9429-406C-B392-E549F940441F}" dt="2023-07-03T12:43:42.368" v="1162" actId="21"/>
          <ac:spMkLst>
            <pc:docMk/>
            <pc:sldMk cId="2940019726" sldId="259"/>
            <ac:spMk id="95" creationId="{97EDC3AC-71D6-CAF0-A9A4-30A85E90AEF7}"/>
          </ac:spMkLst>
        </pc:spChg>
        <pc:grpChg chg="add mod">
          <ac:chgData name="Manish Yadav" userId="4beb67dbd1f8e7f9" providerId="LiveId" clId="{20F0F18A-9429-406C-B392-E549F940441F}" dt="2023-07-03T15:09:16.460" v="2163" actId="1036"/>
          <ac:grpSpMkLst>
            <pc:docMk/>
            <pc:sldMk cId="2940019726" sldId="259"/>
            <ac:grpSpMk id="2" creationId="{F7590BC0-C557-4C4D-CA98-EF2D4AAD1C83}"/>
          </ac:grpSpMkLst>
        </pc:grpChg>
        <pc:grpChg chg="add mod">
          <ac:chgData name="Manish Yadav" userId="4beb67dbd1f8e7f9" providerId="LiveId" clId="{20F0F18A-9429-406C-B392-E549F940441F}" dt="2023-07-03T15:09:16.460" v="2163" actId="1036"/>
          <ac:grpSpMkLst>
            <pc:docMk/>
            <pc:sldMk cId="2940019726" sldId="259"/>
            <ac:grpSpMk id="3" creationId="{E094C602-FC0D-4AED-4919-7720B5ECB1AA}"/>
          </ac:grpSpMkLst>
        </pc:grpChg>
        <pc:grpChg chg="mod">
          <ac:chgData name="Manish Yadav" userId="4beb67dbd1f8e7f9" providerId="LiveId" clId="{20F0F18A-9429-406C-B392-E549F940441F}" dt="2023-07-03T12:17:21.226" v="801"/>
          <ac:grpSpMkLst>
            <pc:docMk/>
            <pc:sldMk cId="2940019726" sldId="259"/>
            <ac:grpSpMk id="4" creationId="{C3D235CD-3237-0817-E75F-19BF61EC98FC}"/>
          </ac:grpSpMkLst>
        </pc:grpChg>
        <pc:grpChg chg="mod">
          <ac:chgData name="Manish Yadav" userId="4beb67dbd1f8e7f9" providerId="LiveId" clId="{20F0F18A-9429-406C-B392-E549F940441F}" dt="2023-07-03T12:17:21.226" v="801"/>
          <ac:grpSpMkLst>
            <pc:docMk/>
            <pc:sldMk cId="2940019726" sldId="259"/>
            <ac:grpSpMk id="7" creationId="{03B0612D-DA6B-B372-E991-C0D15C1FBACE}"/>
          </ac:grpSpMkLst>
        </pc:grpChg>
        <pc:grpChg chg="add mod">
          <ac:chgData name="Manish Yadav" userId="4beb67dbd1f8e7f9" providerId="LiveId" clId="{20F0F18A-9429-406C-B392-E549F940441F}" dt="2023-07-03T15:09:16.460" v="2163" actId="1036"/>
          <ac:grpSpMkLst>
            <pc:docMk/>
            <pc:sldMk cId="2940019726" sldId="259"/>
            <ac:grpSpMk id="29" creationId="{4C29E2BA-7F36-84C6-980D-C7AA4AB65C7D}"/>
          </ac:grpSpMkLst>
        </pc:grpChg>
        <pc:grpChg chg="add del mod">
          <ac:chgData name="Manish Yadav" userId="4beb67dbd1f8e7f9" providerId="LiveId" clId="{20F0F18A-9429-406C-B392-E549F940441F}" dt="2023-07-03T12:22:54.715" v="829" actId="478"/>
          <ac:grpSpMkLst>
            <pc:docMk/>
            <pc:sldMk cId="2940019726" sldId="259"/>
            <ac:grpSpMk id="29" creationId="{727F8DEB-9BD8-2D14-85F6-1039BE410EE0}"/>
          </ac:grpSpMkLst>
        </pc:grpChg>
        <pc:grpChg chg="del mod">
          <ac:chgData name="Manish Yadav" userId="4beb67dbd1f8e7f9" providerId="LiveId" clId="{20F0F18A-9429-406C-B392-E549F940441F}" dt="2023-07-03T12:22:36.730" v="824" actId="478"/>
          <ac:grpSpMkLst>
            <pc:docMk/>
            <pc:sldMk cId="2940019726" sldId="259"/>
            <ac:grpSpMk id="30" creationId="{9EE11A7C-3F25-CD79-3435-1966E6B5319E}"/>
          </ac:grpSpMkLst>
        </pc:grpChg>
        <pc:grpChg chg="mod topLvl">
          <ac:chgData name="Manish Yadav" userId="4beb67dbd1f8e7f9" providerId="LiveId" clId="{20F0F18A-9429-406C-B392-E549F940441F}" dt="2023-07-03T14:57:40.921" v="1870" actId="164"/>
          <ac:grpSpMkLst>
            <pc:docMk/>
            <pc:sldMk cId="2940019726" sldId="259"/>
            <ac:grpSpMk id="33" creationId="{B7BD8FB1-2C7D-E9C7-5623-6EF5FDAF347D}"/>
          </ac:grpSpMkLst>
        </pc:grpChg>
        <pc:grpChg chg="add del mod">
          <ac:chgData name="Manish Yadav" userId="4beb67dbd1f8e7f9" providerId="LiveId" clId="{20F0F18A-9429-406C-B392-E549F940441F}" dt="2023-07-03T15:05:48.051" v="2121" actId="478"/>
          <ac:grpSpMkLst>
            <pc:docMk/>
            <pc:sldMk cId="2940019726" sldId="259"/>
            <ac:grpSpMk id="55" creationId="{8ED59E59-2DBD-5EED-A4F2-7183D2048E22}"/>
          </ac:grpSpMkLst>
        </pc:grpChg>
        <pc:grpChg chg="mod">
          <ac:chgData name="Manish Yadav" userId="4beb67dbd1f8e7f9" providerId="LiveId" clId="{20F0F18A-9429-406C-B392-E549F940441F}" dt="2023-07-03T12:21:40.093" v="808"/>
          <ac:grpSpMkLst>
            <pc:docMk/>
            <pc:sldMk cId="2940019726" sldId="259"/>
            <ac:grpSpMk id="56" creationId="{4FD430A7-C14D-3527-BBFA-20FF2A2BCE59}"/>
          </ac:grpSpMkLst>
        </pc:grpChg>
        <pc:grpChg chg="mod">
          <ac:chgData name="Manish Yadav" userId="4beb67dbd1f8e7f9" providerId="LiveId" clId="{20F0F18A-9429-406C-B392-E549F940441F}" dt="2023-07-03T12:21:40.093" v="808"/>
          <ac:grpSpMkLst>
            <pc:docMk/>
            <pc:sldMk cId="2940019726" sldId="259"/>
            <ac:grpSpMk id="59" creationId="{DB80BD06-E8F1-FA45-1C30-3E8EA4CD8996}"/>
          </ac:grpSpMkLst>
        </pc:grpChg>
        <pc:picChg chg="mod">
          <ac:chgData name="Manish Yadav" userId="4beb67dbd1f8e7f9" providerId="LiveId" clId="{20F0F18A-9429-406C-B392-E549F940441F}" dt="2023-07-03T12:17:21.226" v="801"/>
          <ac:picMkLst>
            <pc:docMk/>
            <pc:sldMk cId="2940019726" sldId="259"/>
            <ac:picMk id="9" creationId="{18BEB509-6F78-02CB-8F1B-0FCAD52B901E}"/>
          </ac:picMkLst>
        </pc:picChg>
        <pc:picChg chg="mod">
          <ac:chgData name="Manish Yadav" userId="4beb67dbd1f8e7f9" providerId="LiveId" clId="{20F0F18A-9429-406C-B392-E549F940441F}" dt="2023-07-03T12:17:21.226" v="801"/>
          <ac:picMkLst>
            <pc:docMk/>
            <pc:sldMk cId="2940019726" sldId="259"/>
            <ac:picMk id="10" creationId="{A54D2D81-6A83-BB67-BDF9-42A9C95732DD}"/>
          </ac:picMkLst>
        </pc:picChg>
        <pc:picChg chg="mod modCrop">
          <ac:chgData name="Manish Yadav" userId="4beb67dbd1f8e7f9" providerId="LiveId" clId="{20F0F18A-9429-406C-B392-E549F940441F}" dt="2023-07-03T12:24:56.405" v="845" actId="732"/>
          <ac:picMkLst>
            <pc:docMk/>
            <pc:sldMk cId="2940019726" sldId="259"/>
            <ac:picMk id="35" creationId="{97A8E8DB-55DE-07C3-F7D6-D31F133C03F0}"/>
          </ac:picMkLst>
        </pc:picChg>
        <pc:picChg chg="del mod">
          <ac:chgData name="Manish Yadav" userId="4beb67dbd1f8e7f9" providerId="LiveId" clId="{20F0F18A-9429-406C-B392-E549F940441F}" dt="2023-07-03T12:22:29.988" v="822" actId="478"/>
          <ac:picMkLst>
            <pc:docMk/>
            <pc:sldMk cId="2940019726" sldId="259"/>
            <ac:picMk id="36" creationId="{2E63B862-7967-CED5-126E-E8F4A688EDF4}"/>
          </ac:picMkLst>
        </pc:picChg>
        <pc:picChg chg="del mod">
          <ac:chgData name="Manish Yadav" userId="4beb67dbd1f8e7f9" providerId="LiveId" clId="{20F0F18A-9429-406C-B392-E549F940441F}" dt="2023-07-03T12:26:17.739" v="868" actId="478"/>
          <ac:picMkLst>
            <pc:docMk/>
            <pc:sldMk cId="2940019726" sldId="259"/>
            <ac:picMk id="61" creationId="{8BBD50D5-8894-62E0-0671-7D18C8B3CD2F}"/>
          </ac:picMkLst>
        </pc:picChg>
        <pc:picChg chg="mod modCrop">
          <ac:chgData name="Manish Yadav" userId="4beb67dbd1f8e7f9" providerId="LiveId" clId="{20F0F18A-9429-406C-B392-E549F940441F}" dt="2023-07-03T12:27:11.187" v="892" actId="732"/>
          <ac:picMkLst>
            <pc:docMk/>
            <pc:sldMk cId="2940019726" sldId="259"/>
            <ac:picMk id="62" creationId="{F176F0C6-1214-28D8-3309-C61F1CBD3BA8}"/>
          </ac:picMkLst>
        </pc:picChg>
        <pc:picChg chg="add del mod">
          <ac:chgData name="Manish Yadav" userId="4beb67dbd1f8e7f9" providerId="LiveId" clId="{20F0F18A-9429-406C-B392-E549F940441F}" dt="2023-07-03T12:30:04.870" v="962" actId="478"/>
          <ac:picMkLst>
            <pc:docMk/>
            <pc:sldMk cId="2940019726" sldId="259"/>
            <ac:picMk id="87" creationId="{FB26F365-0D2B-7183-35C2-69F9E338F206}"/>
          </ac:picMkLst>
        </pc:picChg>
        <pc:picChg chg="add del mod">
          <ac:chgData name="Manish Yadav" userId="4beb67dbd1f8e7f9" providerId="LiveId" clId="{20F0F18A-9429-406C-B392-E549F940441F}" dt="2023-07-03T12:32:50.424" v="1076" actId="478"/>
          <ac:picMkLst>
            <pc:docMk/>
            <pc:sldMk cId="2940019726" sldId="259"/>
            <ac:picMk id="93" creationId="{E78ADF25-09A3-B715-FBAE-840F8BF7D0FE}"/>
          </ac:picMkLst>
        </pc:picChg>
        <pc:cxnChg chg="mod">
          <ac:chgData name="Manish Yadav" userId="4beb67dbd1f8e7f9" providerId="LiveId" clId="{20F0F18A-9429-406C-B392-E549F940441F}" dt="2023-07-03T12:17:21.226" v="801"/>
          <ac:cxnSpMkLst>
            <pc:docMk/>
            <pc:sldMk cId="2940019726" sldId="259"/>
            <ac:cxnSpMk id="12" creationId="{E92E0043-2CC5-F013-6A49-7498DFF01557}"/>
          </ac:cxnSpMkLst>
        </pc:cxnChg>
        <pc:cxnChg chg="mod">
          <ac:chgData name="Manish Yadav" userId="4beb67dbd1f8e7f9" providerId="LiveId" clId="{20F0F18A-9429-406C-B392-E549F940441F}" dt="2023-07-03T12:17:21.226" v="801"/>
          <ac:cxnSpMkLst>
            <pc:docMk/>
            <pc:sldMk cId="2940019726" sldId="259"/>
            <ac:cxnSpMk id="13" creationId="{44403555-96A3-3A32-6B60-5FA7A74E4170}"/>
          </ac:cxnSpMkLst>
        </pc:cxnChg>
        <pc:cxnChg chg="mod">
          <ac:chgData name="Manish Yadav" userId="4beb67dbd1f8e7f9" providerId="LiveId" clId="{20F0F18A-9429-406C-B392-E549F940441F}" dt="2023-07-03T12:17:21.226" v="801"/>
          <ac:cxnSpMkLst>
            <pc:docMk/>
            <pc:sldMk cId="2940019726" sldId="259"/>
            <ac:cxnSpMk id="14" creationId="{A8E5789F-78CE-39E8-CE02-6C5E9B3570D1}"/>
          </ac:cxnSpMkLst>
        </pc:cxnChg>
        <pc:cxnChg chg="mod">
          <ac:chgData name="Manish Yadav" userId="4beb67dbd1f8e7f9" providerId="LiveId" clId="{20F0F18A-9429-406C-B392-E549F940441F}" dt="2023-07-03T12:17:21.226" v="801"/>
          <ac:cxnSpMkLst>
            <pc:docMk/>
            <pc:sldMk cId="2940019726" sldId="259"/>
            <ac:cxnSpMk id="15" creationId="{6A996281-F138-A9D7-1631-1F393D296ADE}"/>
          </ac:cxnSpMkLst>
        </pc:cxnChg>
        <pc:cxnChg chg="mod">
          <ac:chgData name="Manish Yadav" userId="4beb67dbd1f8e7f9" providerId="LiveId" clId="{20F0F18A-9429-406C-B392-E549F940441F}" dt="2023-07-03T12:17:21.226" v="801"/>
          <ac:cxnSpMkLst>
            <pc:docMk/>
            <pc:sldMk cId="2940019726" sldId="259"/>
            <ac:cxnSpMk id="16" creationId="{ED887429-8395-F5D8-F927-0BF5F761671E}"/>
          </ac:cxnSpMkLst>
        </pc:cxnChg>
        <pc:cxnChg chg="mod">
          <ac:chgData name="Manish Yadav" userId="4beb67dbd1f8e7f9" providerId="LiveId" clId="{20F0F18A-9429-406C-B392-E549F940441F}" dt="2023-07-03T12:17:21.226" v="801"/>
          <ac:cxnSpMkLst>
            <pc:docMk/>
            <pc:sldMk cId="2940019726" sldId="259"/>
            <ac:cxnSpMk id="17" creationId="{8B9F9591-94B4-55A8-71C9-482A668067AD}"/>
          </ac:cxnSpMkLst>
        </pc:cxnChg>
        <pc:cxnChg chg="mod">
          <ac:chgData name="Manish Yadav" userId="4beb67dbd1f8e7f9" providerId="LiveId" clId="{20F0F18A-9429-406C-B392-E549F940441F}" dt="2023-07-03T12:21:12.875" v="803"/>
          <ac:cxnSpMkLst>
            <pc:docMk/>
            <pc:sldMk cId="2940019726" sldId="259"/>
            <ac:cxnSpMk id="38" creationId="{D64C18AC-D08F-57EF-5AC8-01617125A3CD}"/>
          </ac:cxnSpMkLst>
        </pc:cxnChg>
        <pc:cxnChg chg="mod">
          <ac:chgData name="Manish Yadav" userId="4beb67dbd1f8e7f9" providerId="LiveId" clId="{20F0F18A-9429-406C-B392-E549F940441F}" dt="2023-07-03T12:21:12.875" v="803"/>
          <ac:cxnSpMkLst>
            <pc:docMk/>
            <pc:sldMk cId="2940019726" sldId="259"/>
            <ac:cxnSpMk id="39" creationId="{6B14C8A7-0A56-4B0D-575B-5A2FCC035918}"/>
          </ac:cxnSpMkLst>
        </pc:cxnChg>
        <pc:cxnChg chg="mod">
          <ac:chgData name="Manish Yadav" userId="4beb67dbd1f8e7f9" providerId="LiveId" clId="{20F0F18A-9429-406C-B392-E549F940441F}" dt="2023-07-03T12:21:12.875" v="803"/>
          <ac:cxnSpMkLst>
            <pc:docMk/>
            <pc:sldMk cId="2940019726" sldId="259"/>
            <ac:cxnSpMk id="40" creationId="{A676F0E2-F603-8C7B-2A48-FE1D9180E149}"/>
          </ac:cxnSpMkLst>
        </pc:cxnChg>
        <pc:cxnChg chg="del mod">
          <ac:chgData name="Manish Yadav" userId="4beb67dbd1f8e7f9" providerId="LiveId" clId="{20F0F18A-9429-406C-B392-E549F940441F}" dt="2023-07-03T12:22:44.913" v="826" actId="478"/>
          <ac:cxnSpMkLst>
            <pc:docMk/>
            <pc:sldMk cId="2940019726" sldId="259"/>
            <ac:cxnSpMk id="41" creationId="{C3975559-0F03-BC19-BB9F-528F3998C623}"/>
          </ac:cxnSpMkLst>
        </pc:cxnChg>
        <pc:cxnChg chg="del mod">
          <ac:chgData name="Manish Yadav" userId="4beb67dbd1f8e7f9" providerId="LiveId" clId="{20F0F18A-9429-406C-B392-E549F940441F}" dt="2023-07-03T12:22:48.461" v="827" actId="478"/>
          <ac:cxnSpMkLst>
            <pc:docMk/>
            <pc:sldMk cId="2940019726" sldId="259"/>
            <ac:cxnSpMk id="42" creationId="{CB6935D2-6291-0B9E-CF9C-2C9F25D0FE89}"/>
          </ac:cxnSpMkLst>
        </pc:cxnChg>
        <pc:cxnChg chg="del mod">
          <ac:chgData name="Manish Yadav" userId="4beb67dbd1f8e7f9" providerId="LiveId" clId="{20F0F18A-9429-406C-B392-E549F940441F}" dt="2023-07-03T12:22:57.941" v="830" actId="478"/>
          <ac:cxnSpMkLst>
            <pc:docMk/>
            <pc:sldMk cId="2940019726" sldId="259"/>
            <ac:cxnSpMk id="43" creationId="{4A6CA252-7590-78D8-F575-202016C5396A}"/>
          </ac:cxnSpMkLst>
        </pc:cxnChg>
        <pc:cxnChg chg="del mod">
          <ac:chgData name="Manish Yadav" userId="4beb67dbd1f8e7f9" providerId="LiveId" clId="{20F0F18A-9429-406C-B392-E549F940441F}" dt="2023-07-03T12:26:09.976" v="865" actId="478"/>
          <ac:cxnSpMkLst>
            <pc:docMk/>
            <pc:sldMk cId="2940019726" sldId="259"/>
            <ac:cxnSpMk id="64" creationId="{D5B823C7-9EBE-A634-106F-D3F4BEA0FC46}"/>
          </ac:cxnSpMkLst>
        </pc:cxnChg>
        <pc:cxnChg chg="del mod">
          <ac:chgData name="Manish Yadav" userId="4beb67dbd1f8e7f9" providerId="LiveId" clId="{20F0F18A-9429-406C-B392-E549F940441F}" dt="2023-07-03T12:26:14.478" v="867" actId="478"/>
          <ac:cxnSpMkLst>
            <pc:docMk/>
            <pc:sldMk cId="2940019726" sldId="259"/>
            <ac:cxnSpMk id="65" creationId="{42A3DC8F-4144-0B4F-4372-C09DBD5CA7BE}"/>
          </ac:cxnSpMkLst>
        </pc:cxnChg>
        <pc:cxnChg chg="del mod">
          <ac:chgData name="Manish Yadav" userId="4beb67dbd1f8e7f9" providerId="LiveId" clId="{20F0F18A-9429-406C-B392-E549F940441F}" dt="2023-07-03T12:26:08.110" v="864" actId="478"/>
          <ac:cxnSpMkLst>
            <pc:docMk/>
            <pc:sldMk cId="2940019726" sldId="259"/>
            <ac:cxnSpMk id="66" creationId="{3111E852-A27C-1507-CA40-D018891C8607}"/>
          </ac:cxnSpMkLst>
        </pc:cxnChg>
        <pc:cxnChg chg="mod">
          <ac:chgData name="Manish Yadav" userId="4beb67dbd1f8e7f9" providerId="LiveId" clId="{20F0F18A-9429-406C-B392-E549F940441F}" dt="2023-07-03T12:21:40.093" v="808"/>
          <ac:cxnSpMkLst>
            <pc:docMk/>
            <pc:sldMk cId="2940019726" sldId="259"/>
            <ac:cxnSpMk id="67" creationId="{F7E78635-B54E-892D-301C-3B3CF8BB1C73}"/>
          </ac:cxnSpMkLst>
        </pc:cxnChg>
        <pc:cxnChg chg="mod">
          <ac:chgData name="Manish Yadav" userId="4beb67dbd1f8e7f9" providerId="LiveId" clId="{20F0F18A-9429-406C-B392-E549F940441F}" dt="2023-07-03T12:21:40.093" v="808"/>
          <ac:cxnSpMkLst>
            <pc:docMk/>
            <pc:sldMk cId="2940019726" sldId="259"/>
            <ac:cxnSpMk id="68" creationId="{B309790A-24BA-8F4A-093E-48180A0EC82F}"/>
          </ac:cxnSpMkLst>
        </pc:cxnChg>
        <pc:cxnChg chg="mod">
          <ac:chgData name="Manish Yadav" userId="4beb67dbd1f8e7f9" providerId="LiveId" clId="{20F0F18A-9429-406C-B392-E549F940441F}" dt="2023-07-03T12:21:40.093" v="808"/>
          <ac:cxnSpMkLst>
            <pc:docMk/>
            <pc:sldMk cId="2940019726" sldId="259"/>
            <ac:cxnSpMk id="69" creationId="{345A3836-9CE2-79E8-508F-39BDEA24C476}"/>
          </ac:cxnSpMkLst>
        </pc:cxnChg>
        <pc:cxnChg chg="add mod">
          <ac:chgData name="Manish Yadav" userId="4beb67dbd1f8e7f9" providerId="LiveId" clId="{20F0F18A-9429-406C-B392-E549F940441F}" dt="2023-07-03T15:09:16.460" v="2163" actId="1036"/>
          <ac:cxnSpMkLst>
            <pc:docMk/>
            <pc:sldMk cId="2940019726" sldId="259"/>
            <ac:cxnSpMk id="84" creationId="{4BEDE3C5-D160-F250-C013-205046AE19FD}"/>
          </ac:cxnSpMkLst>
        </pc:cxnChg>
        <pc:cxnChg chg="add mod">
          <ac:chgData name="Manish Yadav" userId="4beb67dbd1f8e7f9" providerId="LiveId" clId="{20F0F18A-9429-406C-B392-E549F940441F}" dt="2023-07-03T15:09:16.460" v="2163" actId="1036"/>
          <ac:cxnSpMkLst>
            <pc:docMk/>
            <pc:sldMk cId="2940019726" sldId="259"/>
            <ac:cxnSpMk id="86" creationId="{3522F432-2CB5-3B5D-6484-DACF16CEE100}"/>
          </ac:cxnSpMkLst>
        </pc:cxnChg>
      </pc:sldChg>
      <pc:sldChg chg="addSp delSp modSp new mod">
        <pc:chgData name="Manish Yadav" userId="4beb67dbd1f8e7f9" providerId="LiveId" clId="{20F0F18A-9429-406C-B392-E549F940441F}" dt="2023-07-03T15:09:33.269" v="2182" actId="1036"/>
        <pc:sldMkLst>
          <pc:docMk/>
          <pc:sldMk cId="152248518" sldId="260"/>
        </pc:sldMkLst>
        <pc:spChg chg="del">
          <ac:chgData name="Manish Yadav" userId="4beb67dbd1f8e7f9" providerId="LiveId" clId="{20F0F18A-9429-406C-B392-E549F940441F}" dt="2023-07-03T12:39:36.625" v="1096" actId="478"/>
          <ac:spMkLst>
            <pc:docMk/>
            <pc:sldMk cId="152248518" sldId="260"/>
            <ac:spMk id="2" creationId="{408E0F5E-3192-312F-1130-64EB6274C5BF}"/>
          </ac:spMkLst>
        </pc:spChg>
        <pc:spChg chg="add mod">
          <ac:chgData name="Manish Yadav" userId="4beb67dbd1f8e7f9" providerId="LiveId" clId="{20F0F18A-9429-406C-B392-E549F940441F}" dt="2023-07-03T14:49:41.781" v="1554" actId="1076"/>
          <ac:spMkLst>
            <pc:docMk/>
            <pc:sldMk cId="152248518" sldId="260"/>
            <ac:spMk id="4" creationId="{55685F16-4BC4-28D2-5F9C-F26FD8DC596D}"/>
          </ac:spMkLst>
        </pc:spChg>
        <pc:spChg chg="add del mod">
          <ac:chgData name="Manish Yadav" userId="4beb67dbd1f8e7f9" providerId="LiveId" clId="{20F0F18A-9429-406C-B392-E549F940441F}" dt="2023-07-03T14:49:27.257" v="1549"/>
          <ac:spMkLst>
            <pc:docMk/>
            <pc:sldMk cId="152248518" sldId="260"/>
            <ac:spMk id="5" creationId="{CD8195B5-0C40-BFCE-ABD9-A24AD5D93E47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8" creationId="{97AF515D-9516-6171-91F8-B430D330C5C6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9" creationId="{92B26243-7BBC-7678-D9A4-5EFAFEB14481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10" creationId="{487D4BB0-F069-933F-E6B2-BD3527F51816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11" creationId="{2CD7FB56-3D35-2182-9C9D-8F1912CC81A7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12" creationId="{57905912-18CA-3649-88BC-05FBFFED2A62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13" creationId="{23A1CB98-045D-F412-586A-5F68A2E5001C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14" creationId="{11841152-4ED8-3977-2306-FCE4E88C83F4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15" creationId="{10E86E2F-4E0E-AB29-2105-5F71547F873A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0" creationId="{EB2787C8-3D53-1A0F-CF7A-4220DEA568BB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1" creationId="{D493FE3B-4C20-6977-9659-03631E89643D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2" creationId="{9AE91927-4410-335A-EFBE-0F308A313B61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3" creationId="{8F7E27CA-5D73-4BAF-1438-E17ED04C2E9D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4" creationId="{33E4756D-91AA-06C7-51A5-C7B23CA04C66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5" creationId="{7D6F852B-157A-29D3-BCD9-61501ACAA7E7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6" creationId="{33D9D740-DC94-24ED-427A-4EECA9EB958F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7" creationId="{670595CE-D0EB-48DA-2968-E3D1B593A4A8}"/>
          </ac:spMkLst>
        </pc:spChg>
        <pc:spChg chg="mod">
          <ac:chgData name="Manish Yadav" userId="4beb67dbd1f8e7f9" providerId="LiveId" clId="{20F0F18A-9429-406C-B392-E549F940441F}" dt="2023-07-03T12:40:28.399" v="1139"/>
          <ac:spMkLst>
            <pc:docMk/>
            <pc:sldMk cId="152248518" sldId="260"/>
            <ac:spMk id="28" creationId="{3DCA5F10-DE51-A8EF-F522-D41575613ABD}"/>
          </ac:spMkLst>
        </pc:spChg>
        <pc:spChg chg="add del mod">
          <ac:chgData name="Manish Yadav" userId="4beb67dbd1f8e7f9" providerId="LiveId" clId="{20F0F18A-9429-406C-B392-E549F940441F}" dt="2023-07-03T12:45:28.341" v="1211" actId="478"/>
          <ac:spMkLst>
            <pc:docMk/>
            <pc:sldMk cId="152248518" sldId="260"/>
            <ac:spMk id="39" creationId="{83342CD2-2419-EBDD-D16B-CAF2BDB48BDF}"/>
          </ac:spMkLst>
        </pc:spChg>
        <pc:spChg chg="del mod topLvl">
          <ac:chgData name="Manish Yadav" userId="4beb67dbd1f8e7f9" providerId="LiveId" clId="{20F0F18A-9429-406C-B392-E549F940441F}" dt="2023-07-03T12:45:31.411" v="1212" actId="478"/>
          <ac:spMkLst>
            <pc:docMk/>
            <pc:sldMk cId="152248518" sldId="260"/>
            <ac:spMk id="40" creationId="{6A64DC88-C5FF-8BB4-D3C0-8C53F9001F61}"/>
          </ac:spMkLst>
        </pc:spChg>
        <pc:spChg chg="del mod">
          <ac:chgData name="Manish Yadav" userId="4beb67dbd1f8e7f9" providerId="LiveId" clId="{20F0F18A-9429-406C-B392-E549F940441F}" dt="2023-07-03T12:46:05.423" v="1220" actId="478"/>
          <ac:spMkLst>
            <pc:docMk/>
            <pc:sldMk cId="152248518" sldId="260"/>
            <ac:spMk id="41" creationId="{99C2E6FC-E1F0-1C87-B50E-B45D34C33F17}"/>
          </ac:spMkLst>
        </pc:spChg>
        <pc:spChg chg="mod">
          <ac:chgData name="Manish Yadav" userId="4beb67dbd1f8e7f9" providerId="LiveId" clId="{20F0F18A-9429-406C-B392-E549F940441F}" dt="2023-07-03T12:40:36.897" v="1141"/>
          <ac:spMkLst>
            <pc:docMk/>
            <pc:sldMk cId="152248518" sldId="260"/>
            <ac:spMk id="42" creationId="{5975229F-6393-CCF2-DBBF-40AA8D813304}"/>
          </ac:spMkLst>
        </pc:spChg>
        <pc:spChg chg="del mod">
          <ac:chgData name="Manish Yadav" userId="4beb67dbd1f8e7f9" providerId="LiveId" clId="{20F0F18A-9429-406C-B392-E549F940441F}" dt="2023-07-03T12:46:26.298" v="1226" actId="478"/>
          <ac:spMkLst>
            <pc:docMk/>
            <pc:sldMk cId="152248518" sldId="260"/>
            <ac:spMk id="43" creationId="{2DDCF583-82B2-197F-B145-5B7B18C67193}"/>
          </ac:spMkLst>
        </pc:spChg>
        <pc:spChg chg="del mod">
          <ac:chgData name="Manish Yadav" userId="4beb67dbd1f8e7f9" providerId="LiveId" clId="{20F0F18A-9429-406C-B392-E549F940441F}" dt="2023-07-03T12:54:29.987" v="1289" actId="478"/>
          <ac:spMkLst>
            <pc:docMk/>
            <pc:sldMk cId="152248518" sldId="260"/>
            <ac:spMk id="44" creationId="{AFA3CC22-77BC-5DEC-D386-C8EA3AE8F2E2}"/>
          </ac:spMkLst>
        </pc:spChg>
        <pc:spChg chg="del mod">
          <ac:chgData name="Manish Yadav" userId="4beb67dbd1f8e7f9" providerId="LiveId" clId="{20F0F18A-9429-406C-B392-E549F940441F}" dt="2023-07-03T12:45:03.321" v="1204" actId="478"/>
          <ac:spMkLst>
            <pc:docMk/>
            <pc:sldMk cId="152248518" sldId="260"/>
            <ac:spMk id="45" creationId="{503FA257-A2F6-83D0-EDB1-F63311F32BF5}"/>
          </ac:spMkLst>
        </pc:spChg>
        <pc:spChg chg="del mod">
          <ac:chgData name="Manish Yadav" userId="4beb67dbd1f8e7f9" providerId="LiveId" clId="{20F0F18A-9429-406C-B392-E549F940441F}" dt="2023-07-03T12:45:46.645" v="1214" actId="478"/>
          <ac:spMkLst>
            <pc:docMk/>
            <pc:sldMk cId="152248518" sldId="260"/>
            <ac:spMk id="46" creationId="{73349B51-70CC-AA53-C3B8-2CA0618F9661}"/>
          </ac:spMkLst>
        </pc:spChg>
        <pc:spChg chg="del mod">
          <ac:chgData name="Manish Yadav" userId="4beb67dbd1f8e7f9" providerId="LiveId" clId="{20F0F18A-9429-406C-B392-E549F940441F}" dt="2023-07-03T12:45:51.242" v="1215" actId="478"/>
          <ac:spMkLst>
            <pc:docMk/>
            <pc:sldMk cId="152248518" sldId="260"/>
            <ac:spMk id="51" creationId="{ADCC0A8D-73C6-0817-24D2-CBAFBF8166EC}"/>
          </ac:spMkLst>
        </pc:spChg>
        <pc:spChg chg="del mod">
          <ac:chgData name="Manish Yadav" userId="4beb67dbd1f8e7f9" providerId="LiveId" clId="{20F0F18A-9429-406C-B392-E549F940441F}" dt="2023-07-03T12:45:54.313" v="1216" actId="478"/>
          <ac:spMkLst>
            <pc:docMk/>
            <pc:sldMk cId="152248518" sldId="260"/>
            <ac:spMk id="52" creationId="{3EA7E751-7515-2192-4206-21D0511B1A6B}"/>
          </ac:spMkLst>
        </pc:spChg>
        <pc:spChg chg="del mod">
          <ac:chgData name="Manish Yadav" userId="4beb67dbd1f8e7f9" providerId="LiveId" clId="{20F0F18A-9429-406C-B392-E549F940441F}" dt="2023-07-03T12:45:57.303" v="1217" actId="478"/>
          <ac:spMkLst>
            <pc:docMk/>
            <pc:sldMk cId="152248518" sldId="260"/>
            <ac:spMk id="53" creationId="{5BFBB039-0B66-1924-8795-CFBB6A64A454}"/>
          </ac:spMkLst>
        </pc:spChg>
        <pc:spChg chg="del mod">
          <ac:chgData name="Manish Yadav" userId="4beb67dbd1f8e7f9" providerId="LiveId" clId="{20F0F18A-9429-406C-B392-E549F940441F}" dt="2023-07-03T12:46:37.591" v="1231" actId="478"/>
          <ac:spMkLst>
            <pc:docMk/>
            <pc:sldMk cId="152248518" sldId="260"/>
            <ac:spMk id="54" creationId="{0FA11513-CC10-5EE2-D37E-99A9E0C2103B}"/>
          </ac:spMkLst>
        </pc:spChg>
        <pc:spChg chg="del mod">
          <ac:chgData name="Manish Yadav" userId="4beb67dbd1f8e7f9" providerId="LiveId" clId="{20F0F18A-9429-406C-B392-E549F940441F}" dt="2023-07-03T12:46:31.405" v="1228" actId="478"/>
          <ac:spMkLst>
            <pc:docMk/>
            <pc:sldMk cId="152248518" sldId="260"/>
            <ac:spMk id="55" creationId="{1A835106-11BE-5C23-6C33-2CF200566A44}"/>
          </ac:spMkLst>
        </pc:spChg>
        <pc:spChg chg="del mod">
          <ac:chgData name="Manish Yadav" userId="4beb67dbd1f8e7f9" providerId="LiveId" clId="{20F0F18A-9429-406C-B392-E549F940441F}" dt="2023-07-03T12:46:43.390" v="1235" actId="478"/>
          <ac:spMkLst>
            <pc:docMk/>
            <pc:sldMk cId="152248518" sldId="260"/>
            <ac:spMk id="56" creationId="{FE860B47-C10D-BB22-E0DB-1E0C0A6E1E16}"/>
          </ac:spMkLst>
        </pc:spChg>
        <pc:spChg chg="mod">
          <ac:chgData name="Manish Yadav" userId="4beb67dbd1f8e7f9" providerId="LiveId" clId="{20F0F18A-9429-406C-B392-E549F940441F}" dt="2023-07-03T12:56:30.266" v="1330" actId="1038"/>
          <ac:spMkLst>
            <pc:docMk/>
            <pc:sldMk cId="152248518" sldId="260"/>
            <ac:spMk id="57" creationId="{94EA6117-5002-7146-AC9C-8A9586690666}"/>
          </ac:spMkLst>
        </pc:spChg>
        <pc:spChg chg="del mod">
          <ac:chgData name="Manish Yadav" userId="4beb67dbd1f8e7f9" providerId="LiveId" clId="{20F0F18A-9429-406C-B392-E549F940441F}" dt="2023-07-03T12:54:38.990" v="1291" actId="478"/>
          <ac:spMkLst>
            <pc:docMk/>
            <pc:sldMk cId="152248518" sldId="260"/>
            <ac:spMk id="58" creationId="{8EDFC514-8EEA-F654-C252-5AC6622CE48F}"/>
          </ac:spMkLst>
        </pc:spChg>
        <pc:spChg chg="del mod">
          <ac:chgData name="Manish Yadav" userId="4beb67dbd1f8e7f9" providerId="LiveId" clId="{20F0F18A-9429-406C-B392-E549F940441F}" dt="2023-07-03T12:54:33.554" v="1290" actId="478"/>
          <ac:spMkLst>
            <pc:docMk/>
            <pc:sldMk cId="152248518" sldId="260"/>
            <ac:spMk id="59" creationId="{4CA4F065-F704-9A8C-4238-EEB34B9CBE12}"/>
          </ac:spMkLst>
        </pc:spChg>
        <pc:spChg chg="del mod topLvl">
          <ac:chgData name="Manish Yadav" userId="4beb67dbd1f8e7f9" providerId="LiveId" clId="{20F0F18A-9429-406C-B392-E549F940441F}" dt="2023-07-03T12:50:56.294" v="1259" actId="478"/>
          <ac:spMkLst>
            <pc:docMk/>
            <pc:sldMk cId="152248518" sldId="260"/>
            <ac:spMk id="70" creationId="{7845544D-C37E-BC54-F66B-644048832B91}"/>
          </ac:spMkLst>
        </pc:spChg>
        <pc:spChg chg="del mod topLvl">
          <ac:chgData name="Manish Yadav" userId="4beb67dbd1f8e7f9" providerId="LiveId" clId="{20F0F18A-9429-406C-B392-E549F940441F}" dt="2023-07-03T12:50:53.476" v="1258" actId="478"/>
          <ac:spMkLst>
            <pc:docMk/>
            <pc:sldMk cId="152248518" sldId="260"/>
            <ac:spMk id="71" creationId="{C68B6C1A-B0EF-0037-3159-F7217DC241F2}"/>
          </ac:spMkLst>
        </pc:spChg>
        <pc:spChg chg="del mod topLvl">
          <ac:chgData name="Manish Yadav" userId="4beb67dbd1f8e7f9" providerId="LiveId" clId="{20F0F18A-9429-406C-B392-E549F940441F}" dt="2023-07-03T12:52:00.375" v="1276" actId="478"/>
          <ac:spMkLst>
            <pc:docMk/>
            <pc:sldMk cId="152248518" sldId="260"/>
            <ac:spMk id="72" creationId="{294B80CB-7B6C-BC66-06E6-DB4343E42DF2}"/>
          </ac:spMkLst>
        </pc:spChg>
        <pc:spChg chg="del mod topLvl">
          <ac:chgData name="Manish Yadav" userId="4beb67dbd1f8e7f9" providerId="LiveId" clId="{20F0F18A-9429-406C-B392-E549F940441F}" dt="2023-07-03T12:51:39.657" v="1267" actId="478"/>
          <ac:spMkLst>
            <pc:docMk/>
            <pc:sldMk cId="152248518" sldId="260"/>
            <ac:spMk id="73" creationId="{D19878F7-9661-6A78-37DD-EE177984F298}"/>
          </ac:spMkLst>
        </pc:spChg>
        <pc:spChg chg="mod topLvl">
          <ac:chgData name="Manish Yadav" userId="4beb67dbd1f8e7f9" providerId="LiveId" clId="{20F0F18A-9429-406C-B392-E549F940441F}" dt="2023-07-03T12:52:31.672" v="1282" actId="164"/>
          <ac:spMkLst>
            <pc:docMk/>
            <pc:sldMk cId="152248518" sldId="260"/>
            <ac:spMk id="74" creationId="{AFD01DEE-6E45-81B7-BEBB-307C4641DA79}"/>
          </ac:spMkLst>
        </pc:spChg>
        <pc:spChg chg="del mod">
          <ac:chgData name="Manish Yadav" userId="4beb67dbd1f8e7f9" providerId="LiveId" clId="{20F0F18A-9429-406C-B392-E549F940441F}" dt="2023-07-03T12:51:10.718" v="1262" actId="478"/>
          <ac:spMkLst>
            <pc:docMk/>
            <pc:sldMk cId="152248518" sldId="260"/>
            <ac:spMk id="75" creationId="{69B832E8-6DCE-C465-D78D-09F789C331E6}"/>
          </ac:spMkLst>
        </pc:spChg>
        <pc:spChg chg="del mod">
          <ac:chgData name="Manish Yadav" userId="4beb67dbd1f8e7f9" providerId="LiveId" clId="{20F0F18A-9429-406C-B392-E549F940441F}" dt="2023-07-03T12:51:00.068" v="1260" actId="478"/>
          <ac:spMkLst>
            <pc:docMk/>
            <pc:sldMk cId="152248518" sldId="260"/>
            <ac:spMk id="76" creationId="{7083286D-8AE5-4273-DAB7-93380029FADD}"/>
          </ac:spMkLst>
        </pc:spChg>
        <pc:spChg chg="del mod">
          <ac:chgData name="Manish Yadav" userId="4beb67dbd1f8e7f9" providerId="LiveId" clId="{20F0F18A-9429-406C-B392-E549F940441F}" dt="2023-07-03T12:51:02.989" v="1261" actId="478"/>
          <ac:spMkLst>
            <pc:docMk/>
            <pc:sldMk cId="152248518" sldId="260"/>
            <ac:spMk id="77" creationId="{ACA1FD9E-8FC3-5CDF-72A3-BF9EBFD63883}"/>
          </ac:spMkLst>
        </pc:spChg>
        <pc:spChg chg="del mod topLvl">
          <ac:chgData name="Manish Yadav" userId="4beb67dbd1f8e7f9" providerId="LiveId" clId="{20F0F18A-9429-406C-B392-E549F940441F}" dt="2023-07-03T12:51:53.636" v="1273" actId="478"/>
          <ac:spMkLst>
            <pc:docMk/>
            <pc:sldMk cId="152248518" sldId="260"/>
            <ac:spMk id="82" creationId="{B8B03659-7CDF-ABD0-4B15-65F69107523A}"/>
          </ac:spMkLst>
        </pc:spChg>
        <pc:spChg chg="del mod topLvl">
          <ac:chgData name="Manish Yadav" userId="4beb67dbd1f8e7f9" providerId="LiveId" clId="{20F0F18A-9429-406C-B392-E549F940441F}" dt="2023-07-03T12:51:46.087" v="1270" actId="478"/>
          <ac:spMkLst>
            <pc:docMk/>
            <pc:sldMk cId="152248518" sldId="260"/>
            <ac:spMk id="83" creationId="{215497DD-5B20-0B57-BD0C-DEC6CA2CA652}"/>
          </ac:spMkLst>
        </pc:spChg>
        <pc:spChg chg="del mod topLvl">
          <ac:chgData name="Manish Yadav" userId="4beb67dbd1f8e7f9" providerId="LiveId" clId="{20F0F18A-9429-406C-B392-E549F940441F}" dt="2023-07-03T12:51:42.668" v="1268" actId="478"/>
          <ac:spMkLst>
            <pc:docMk/>
            <pc:sldMk cId="152248518" sldId="260"/>
            <ac:spMk id="84" creationId="{17DF87A5-F6FD-3A99-AA5D-4F14C7A76F1D}"/>
          </ac:spMkLst>
        </pc:spChg>
        <pc:spChg chg="mod topLvl">
          <ac:chgData name="Manish Yadav" userId="4beb67dbd1f8e7f9" providerId="LiveId" clId="{20F0F18A-9429-406C-B392-E549F940441F}" dt="2023-07-03T12:57:08.356" v="1335" actId="1038"/>
          <ac:spMkLst>
            <pc:docMk/>
            <pc:sldMk cId="152248518" sldId="260"/>
            <ac:spMk id="85" creationId="{BB082C4D-5BA3-89BC-04C1-E780B4B90128}"/>
          </ac:spMkLst>
        </pc:spChg>
        <pc:spChg chg="del mod topLvl">
          <ac:chgData name="Manish Yadav" userId="4beb67dbd1f8e7f9" providerId="LiveId" clId="{20F0F18A-9429-406C-B392-E549F940441F}" dt="2023-07-03T12:54:49.259" v="1293" actId="478"/>
          <ac:spMkLst>
            <pc:docMk/>
            <pc:sldMk cId="152248518" sldId="260"/>
            <ac:spMk id="86" creationId="{16A00D50-E7F2-B1EC-FBC7-0AC79F071286}"/>
          </ac:spMkLst>
        </pc:spChg>
        <pc:spChg chg="del mod topLvl">
          <ac:chgData name="Manish Yadav" userId="4beb67dbd1f8e7f9" providerId="LiveId" clId="{20F0F18A-9429-406C-B392-E549F940441F}" dt="2023-07-03T12:54:45.993" v="1292" actId="478"/>
          <ac:spMkLst>
            <pc:docMk/>
            <pc:sldMk cId="152248518" sldId="260"/>
            <ac:spMk id="87" creationId="{A625390A-6296-173C-28DE-451CEB9D8695}"/>
          </ac:spMkLst>
        </pc:spChg>
        <pc:spChg chg="del mod topLvl">
          <ac:chgData name="Manish Yadav" userId="4beb67dbd1f8e7f9" providerId="LiveId" clId="{20F0F18A-9429-406C-B392-E549F940441F}" dt="2023-07-03T12:51:33.836" v="1265" actId="478"/>
          <ac:spMkLst>
            <pc:docMk/>
            <pc:sldMk cId="152248518" sldId="260"/>
            <ac:spMk id="88" creationId="{4617FB13-62BD-42D7-42F1-B060033DB562}"/>
          </ac:spMkLst>
        </pc:spChg>
        <pc:spChg chg="del mod topLvl">
          <ac:chgData name="Manish Yadav" userId="4beb67dbd1f8e7f9" providerId="LiveId" clId="{20F0F18A-9429-406C-B392-E549F940441F}" dt="2023-07-03T12:51:36.970" v="1266" actId="478"/>
          <ac:spMkLst>
            <pc:docMk/>
            <pc:sldMk cId="152248518" sldId="260"/>
            <ac:spMk id="89" creationId="{90E8D659-720F-FAE8-52F4-30CE90409132}"/>
          </ac:spMkLst>
        </pc:spChg>
        <pc:spChg chg="del mod topLvl">
          <ac:chgData name="Manish Yadav" userId="4beb67dbd1f8e7f9" providerId="LiveId" clId="{20F0F18A-9429-406C-B392-E549F940441F}" dt="2023-07-03T12:51:33.836" v="1265" actId="478"/>
          <ac:spMkLst>
            <pc:docMk/>
            <pc:sldMk cId="152248518" sldId="260"/>
            <ac:spMk id="90" creationId="{90F18590-6B4E-5D21-0D66-A800A5F4DC79}"/>
          </ac:spMkLst>
        </pc:spChg>
        <pc:spChg chg="add mod">
          <ac:chgData name="Manish Yadav" userId="4beb67dbd1f8e7f9" providerId="LiveId" clId="{20F0F18A-9429-406C-B392-E549F940441F}" dt="2023-07-03T15:09:33.269" v="2182" actId="1036"/>
          <ac:spMkLst>
            <pc:docMk/>
            <pc:sldMk cId="152248518" sldId="260"/>
            <ac:spMk id="99" creationId="{F5F7371A-1AC4-1119-B959-AE78DA1E58EE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02" creationId="{E0FD6092-8239-85F6-1E41-B76677ECA23A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03" creationId="{5A18C441-6D86-8715-4AA5-F7E380A7E117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04" creationId="{3D86F8D0-80F8-6224-C0DD-6B950B31FD27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05" creationId="{26979BDB-770B-FDF1-5B93-8B50BC134AB3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06" creationId="{B6B58286-F8A9-BDA9-606C-C9C038D7B7A5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07" creationId="{E339E581-020C-E6AB-047B-0602D1C64E87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08" creationId="{5D4123AB-0CA2-8319-C647-6F8404AABF94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09" creationId="{1BBB7329-F89B-9BD1-7108-4738D09EBC77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14" creationId="{4D927F99-9BFF-22C1-565C-253F3B8889C9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15" creationId="{E77D8798-40F6-47D1-3A9C-2BFCDFC3245C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16" creationId="{25122796-8B15-1A37-75F8-6C4A40A9BD31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17" creationId="{7E5AF751-946D-3CD3-F9C5-BA03F87E6142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18" creationId="{0236ECF7-BC0F-D2C4-1BF5-B27BAB9D33D8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19" creationId="{395866F3-6043-2724-F152-F050EA575FFF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20" creationId="{01E02D4C-85FA-5577-B7C3-68CDBE2627F2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21" creationId="{054A3FA4-5C45-22D3-DC6B-958CFA88D1ED}"/>
          </ac:spMkLst>
        </pc:spChg>
        <pc:spChg chg="mod">
          <ac:chgData name="Manish Yadav" userId="4beb67dbd1f8e7f9" providerId="LiveId" clId="{20F0F18A-9429-406C-B392-E549F940441F}" dt="2023-07-03T12:44:07.915" v="1168" actId="571"/>
          <ac:spMkLst>
            <pc:docMk/>
            <pc:sldMk cId="152248518" sldId="260"/>
            <ac:spMk id="122" creationId="{D7458F9E-DBFA-1FF6-A822-D5CBCCE453EA}"/>
          </ac:spMkLst>
        </pc:spChg>
        <pc:spChg chg="add del mod">
          <ac:chgData name="Manish Yadav" userId="4beb67dbd1f8e7f9" providerId="LiveId" clId="{20F0F18A-9429-406C-B392-E549F940441F}" dt="2023-07-03T12:44:11.161" v="1179" actId="478"/>
          <ac:spMkLst>
            <pc:docMk/>
            <pc:sldMk cId="152248518" sldId="260"/>
            <ac:spMk id="131" creationId="{F7B03134-3939-9872-73C3-A9BF7FC03342}"/>
          </ac:spMkLst>
        </pc:spChg>
        <pc:spChg chg="add mod">
          <ac:chgData name="Manish Yadav" userId="4beb67dbd1f8e7f9" providerId="LiveId" clId="{20F0F18A-9429-406C-B392-E549F940441F}" dt="2023-07-03T15:09:33.269" v="2182" actId="1036"/>
          <ac:spMkLst>
            <pc:docMk/>
            <pc:sldMk cId="152248518" sldId="260"/>
            <ac:spMk id="132" creationId="{D0B5D095-670B-9162-0FD7-F2450AF19A2A}"/>
          </ac:spMkLst>
        </pc:spChg>
        <pc:spChg chg="add mod">
          <ac:chgData name="Manish Yadav" userId="4beb67dbd1f8e7f9" providerId="LiveId" clId="{20F0F18A-9429-406C-B392-E549F940441F}" dt="2023-07-03T15:01:15.432" v="1956" actId="164"/>
          <ac:spMkLst>
            <pc:docMk/>
            <pc:sldMk cId="152248518" sldId="260"/>
            <ac:spMk id="143" creationId="{DDEDE0EC-CC00-BDD5-A4B0-F7E3C980E4E0}"/>
          </ac:spMkLst>
        </pc:spChg>
        <pc:spChg chg="add mod">
          <ac:chgData name="Manish Yadav" userId="4beb67dbd1f8e7f9" providerId="LiveId" clId="{20F0F18A-9429-406C-B392-E549F940441F}" dt="2023-07-03T15:00:50.343" v="1955" actId="164"/>
          <ac:spMkLst>
            <pc:docMk/>
            <pc:sldMk cId="152248518" sldId="260"/>
            <ac:spMk id="146" creationId="{1255BD13-1F2D-54A5-7152-AB2C5C623180}"/>
          </ac:spMkLst>
        </pc:spChg>
        <pc:grpChg chg="add mod">
          <ac:chgData name="Manish Yadav" userId="4beb67dbd1f8e7f9" providerId="LiveId" clId="{20F0F18A-9429-406C-B392-E549F940441F}" dt="2023-07-03T15:09:33.269" v="2182" actId="1036"/>
          <ac:grpSpMkLst>
            <pc:docMk/>
            <pc:sldMk cId="152248518" sldId="260"/>
            <ac:grpSpMk id="2" creationId="{857B0508-CBDA-F334-2D44-89E8B8697382}"/>
          </ac:grpSpMkLst>
        </pc:grpChg>
        <pc:grpChg chg="add mod">
          <ac:chgData name="Manish Yadav" userId="4beb67dbd1f8e7f9" providerId="LiveId" clId="{20F0F18A-9429-406C-B392-E549F940441F}" dt="2023-07-03T15:09:33.269" v="2182" actId="1036"/>
          <ac:grpSpMkLst>
            <pc:docMk/>
            <pc:sldMk cId="152248518" sldId="260"/>
            <ac:grpSpMk id="3" creationId="{BC0A7349-1173-FD29-6882-631DEE7758A3}"/>
          </ac:grpSpMkLst>
        </pc:grpChg>
        <pc:grpChg chg="add mod">
          <ac:chgData name="Manish Yadav" userId="4beb67dbd1f8e7f9" providerId="LiveId" clId="{20F0F18A-9429-406C-B392-E549F940441F}" dt="2023-07-03T15:09:33.269" v="2182" actId="1036"/>
          <ac:grpSpMkLst>
            <pc:docMk/>
            <pc:sldMk cId="152248518" sldId="260"/>
            <ac:grpSpMk id="6" creationId="{F62CD957-49BE-F147-3B70-DA317B76B8A5}"/>
          </ac:grpSpMkLst>
        </pc:grpChg>
        <pc:grpChg chg="mod">
          <ac:chgData name="Manish Yadav" userId="4beb67dbd1f8e7f9" providerId="LiveId" clId="{20F0F18A-9429-406C-B392-E549F940441F}" dt="2023-07-03T12:40:28.399" v="1139"/>
          <ac:grpSpMkLst>
            <pc:docMk/>
            <pc:sldMk cId="152248518" sldId="260"/>
            <ac:grpSpMk id="7" creationId="{028A1A98-0233-E825-4AC0-187EE74FF72B}"/>
          </ac:grpSpMkLst>
        </pc:grpChg>
        <pc:grpChg chg="add del mod">
          <ac:chgData name="Manish Yadav" userId="4beb67dbd1f8e7f9" providerId="LiveId" clId="{20F0F18A-9429-406C-B392-E549F940441F}" dt="2023-07-03T12:45:31.411" v="1212" actId="478"/>
          <ac:grpSpMkLst>
            <pc:docMk/>
            <pc:sldMk cId="152248518" sldId="260"/>
            <ac:grpSpMk id="37" creationId="{9608B7BB-9D72-DF16-C341-909E767C3DBE}"/>
          </ac:grpSpMkLst>
        </pc:grpChg>
        <pc:grpChg chg="mod topLvl">
          <ac:chgData name="Manish Yadav" userId="4beb67dbd1f8e7f9" providerId="LiveId" clId="{20F0F18A-9429-406C-B392-E549F940441F}" dt="2023-07-03T15:01:15.432" v="1956" actId="164"/>
          <ac:grpSpMkLst>
            <pc:docMk/>
            <pc:sldMk cId="152248518" sldId="260"/>
            <ac:grpSpMk id="38" creationId="{348D6B6C-11CA-136A-E3B6-157E66BAB687}"/>
          </ac:grpSpMkLst>
        </pc:grpChg>
        <pc:grpChg chg="add del mod">
          <ac:chgData name="Manish Yadav" userId="4beb67dbd1f8e7f9" providerId="LiveId" clId="{20F0F18A-9429-406C-B392-E549F940441F}" dt="2023-07-03T12:50:49.251" v="1257" actId="165"/>
          <ac:grpSpMkLst>
            <pc:docMk/>
            <pc:sldMk cId="152248518" sldId="260"/>
            <ac:grpSpMk id="68" creationId="{DBA4C938-FECA-A6DE-612E-B9BFBA332343}"/>
          </ac:grpSpMkLst>
        </pc:grpChg>
        <pc:grpChg chg="del mod topLvl">
          <ac:chgData name="Manish Yadav" userId="4beb67dbd1f8e7f9" providerId="LiveId" clId="{20F0F18A-9429-406C-B392-E549F940441F}" dt="2023-07-03T12:51:28.634" v="1264" actId="165"/>
          <ac:grpSpMkLst>
            <pc:docMk/>
            <pc:sldMk cId="152248518" sldId="260"/>
            <ac:grpSpMk id="69" creationId="{523D388F-9299-9C4E-E47E-C8002145098E}"/>
          </ac:grpSpMkLst>
        </pc:grpChg>
        <pc:grpChg chg="add del mod">
          <ac:chgData name="Manish Yadav" userId="4beb67dbd1f8e7f9" providerId="LiveId" clId="{20F0F18A-9429-406C-B392-E549F940441F}" dt="2023-07-03T12:44:11.161" v="1179" actId="478"/>
          <ac:grpSpMkLst>
            <pc:docMk/>
            <pc:sldMk cId="152248518" sldId="260"/>
            <ac:grpSpMk id="100" creationId="{C147F7AA-44D3-5795-CA0C-A83108702C63}"/>
          </ac:grpSpMkLst>
        </pc:grpChg>
        <pc:grpChg chg="mod">
          <ac:chgData name="Manish Yadav" userId="4beb67dbd1f8e7f9" providerId="LiveId" clId="{20F0F18A-9429-406C-B392-E549F940441F}" dt="2023-07-03T12:44:07.915" v="1168" actId="571"/>
          <ac:grpSpMkLst>
            <pc:docMk/>
            <pc:sldMk cId="152248518" sldId="260"/>
            <ac:grpSpMk id="101" creationId="{DE09AE5B-75F9-4948-C655-ECB5DA2100A9}"/>
          </ac:grpSpMkLst>
        </pc:grpChg>
        <pc:grpChg chg="add mod">
          <ac:chgData name="Manish Yadav" userId="4beb67dbd1f8e7f9" providerId="LiveId" clId="{20F0F18A-9429-406C-B392-E549F940441F}" dt="2023-07-03T15:00:50.343" v="1955" actId="164"/>
          <ac:grpSpMkLst>
            <pc:docMk/>
            <pc:sldMk cId="152248518" sldId="260"/>
            <ac:grpSpMk id="134" creationId="{3007FEEA-E2A5-8965-DB1E-4D7F3A16944E}"/>
          </ac:grpSpMkLst>
        </pc:grpChg>
        <pc:picChg chg="mod">
          <ac:chgData name="Manish Yadav" userId="4beb67dbd1f8e7f9" providerId="LiveId" clId="{20F0F18A-9429-406C-B392-E549F940441F}" dt="2023-07-03T12:40:28.399" v="1139"/>
          <ac:picMkLst>
            <pc:docMk/>
            <pc:sldMk cId="152248518" sldId="260"/>
            <ac:picMk id="35" creationId="{F60A71B4-3C57-F0EC-D748-80285403F9CB}"/>
          </ac:picMkLst>
        </pc:picChg>
        <pc:picChg chg="mod">
          <ac:chgData name="Manish Yadav" userId="4beb67dbd1f8e7f9" providerId="LiveId" clId="{20F0F18A-9429-406C-B392-E549F940441F}" dt="2023-07-03T12:40:28.399" v="1139"/>
          <ac:picMkLst>
            <pc:docMk/>
            <pc:sldMk cId="152248518" sldId="260"/>
            <ac:picMk id="36" creationId="{5F1FB04C-45C3-BA7D-9B0A-9BABFEC677FD}"/>
          </ac:picMkLst>
        </pc:picChg>
        <pc:picChg chg="mod modCrop">
          <ac:chgData name="Manish Yadav" userId="4beb67dbd1f8e7f9" providerId="LiveId" clId="{20F0F18A-9429-406C-B392-E549F940441F}" dt="2023-07-03T12:47:12.383" v="1241" actId="732"/>
          <ac:picMkLst>
            <pc:docMk/>
            <pc:sldMk cId="152248518" sldId="260"/>
            <ac:picMk id="66" creationId="{CF08D350-A639-23B6-0B2D-1E72A1A40701}"/>
          </ac:picMkLst>
        </pc:picChg>
        <pc:picChg chg="del mod">
          <ac:chgData name="Manish Yadav" userId="4beb67dbd1f8e7f9" providerId="LiveId" clId="{20F0F18A-9429-406C-B392-E549F940441F}" dt="2023-07-03T12:46:10.418" v="1221" actId="478"/>
          <ac:picMkLst>
            <pc:docMk/>
            <pc:sldMk cId="152248518" sldId="260"/>
            <ac:picMk id="67" creationId="{9E66D6D3-17C7-7BA1-4992-3AD1FFF4859F}"/>
          </ac:picMkLst>
        </pc:picChg>
        <pc:picChg chg="del mod">
          <ac:chgData name="Manish Yadav" userId="4beb67dbd1f8e7f9" providerId="LiveId" clId="{20F0F18A-9429-406C-B392-E549F940441F}" dt="2023-07-03T12:51:18.062" v="1263" actId="478"/>
          <ac:picMkLst>
            <pc:docMk/>
            <pc:sldMk cId="152248518" sldId="260"/>
            <ac:picMk id="97" creationId="{68E6C683-424F-5361-357B-079F19C8E72C}"/>
          </ac:picMkLst>
        </pc:picChg>
        <pc:picChg chg="mod topLvl modCrop">
          <ac:chgData name="Manish Yadav" userId="4beb67dbd1f8e7f9" providerId="LiveId" clId="{20F0F18A-9429-406C-B392-E549F940441F}" dt="2023-07-03T12:52:31.672" v="1282" actId="164"/>
          <ac:picMkLst>
            <pc:docMk/>
            <pc:sldMk cId="152248518" sldId="260"/>
            <ac:picMk id="98" creationId="{BC2F8941-1FE1-12AC-4D7C-FCB29DE93D81}"/>
          </ac:picMkLst>
        </pc:picChg>
        <pc:picChg chg="mod">
          <ac:chgData name="Manish Yadav" userId="4beb67dbd1f8e7f9" providerId="LiveId" clId="{20F0F18A-9429-406C-B392-E549F940441F}" dt="2023-07-03T12:44:07.915" v="1168" actId="571"/>
          <ac:picMkLst>
            <pc:docMk/>
            <pc:sldMk cId="152248518" sldId="260"/>
            <ac:picMk id="129" creationId="{CBBCEBE4-6AAC-9402-E766-4B54DEE00BC6}"/>
          </ac:picMkLst>
        </pc:picChg>
        <pc:picChg chg="mod">
          <ac:chgData name="Manish Yadav" userId="4beb67dbd1f8e7f9" providerId="LiveId" clId="{20F0F18A-9429-406C-B392-E549F940441F}" dt="2023-07-03T12:44:07.915" v="1168" actId="571"/>
          <ac:picMkLst>
            <pc:docMk/>
            <pc:sldMk cId="152248518" sldId="260"/>
            <ac:picMk id="130" creationId="{CEBB0B57-4A4A-7F5F-1390-4ADCABB3E3B5}"/>
          </ac:picMkLst>
        </pc:picChg>
        <pc:picChg chg="add del mod">
          <ac:chgData name="Manish Yadav" userId="4beb67dbd1f8e7f9" providerId="LiveId" clId="{20F0F18A-9429-406C-B392-E549F940441F}" dt="2023-07-03T12:59:17.466" v="1353" actId="478"/>
          <ac:picMkLst>
            <pc:docMk/>
            <pc:sldMk cId="152248518" sldId="260"/>
            <ac:picMk id="142" creationId="{F2C6AF74-558B-856A-D5FB-0E847AA9C910}"/>
          </ac:picMkLst>
        </pc:picChg>
        <pc:picChg chg="add del mod">
          <ac:chgData name="Manish Yadav" userId="4beb67dbd1f8e7f9" providerId="LiveId" clId="{20F0F18A-9429-406C-B392-E549F940441F}" dt="2023-07-03T13:02:38.006" v="1431" actId="478"/>
          <ac:picMkLst>
            <pc:docMk/>
            <pc:sldMk cId="152248518" sldId="260"/>
            <ac:picMk id="144" creationId="{0375E3D7-7A42-BB96-14B9-E07B0E9C70E4}"/>
          </ac:picMkLst>
        </pc:picChg>
        <pc:picChg chg="add del mod">
          <ac:chgData name="Manish Yadav" userId="4beb67dbd1f8e7f9" providerId="LiveId" clId="{20F0F18A-9429-406C-B392-E549F940441F}" dt="2023-07-03T13:03:34.148" v="1446" actId="478"/>
          <ac:picMkLst>
            <pc:docMk/>
            <pc:sldMk cId="152248518" sldId="260"/>
            <ac:picMk id="145" creationId="{69DCC107-73AD-2292-F134-4146E804FADB}"/>
          </ac:picMkLst>
        </pc:pic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16" creationId="{8B81E7CB-8629-9903-78E6-DFFFA9596A99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17" creationId="{602546F3-1F66-535B-8818-5CED44282337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18" creationId="{E788B9EA-A9CE-1179-76DF-E1280088DF68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19" creationId="{493B8201-785C-10BA-076C-B1BE6D932889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29" creationId="{1240F1BA-63F1-5C25-8F45-5B8636F922B9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30" creationId="{8ED4EF1F-B0E8-2903-D7FD-6CF83E33E7FB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31" creationId="{1E928A93-8989-3786-D8DC-4B4F2CEE83C7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32" creationId="{30439611-7591-D6E2-2ECE-826D8446DCE7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33" creationId="{64D1DCF3-12C1-E3F8-A66F-21D059AA9844}"/>
          </ac:cxnSpMkLst>
        </pc:cxnChg>
        <pc:cxnChg chg="mod">
          <ac:chgData name="Manish Yadav" userId="4beb67dbd1f8e7f9" providerId="LiveId" clId="{20F0F18A-9429-406C-B392-E549F940441F}" dt="2023-07-03T12:40:28.399" v="1139"/>
          <ac:cxnSpMkLst>
            <pc:docMk/>
            <pc:sldMk cId="152248518" sldId="260"/>
            <ac:cxnSpMk id="34" creationId="{3A46C4E0-60BA-56C7-383A-230DFC05CBE2}"/>
          </ac:cxnSpMkLst>
        </pc:cxnChg>
        <pc:cxnChg chg="del mod">
          <ac:chgData name="Manish Yadav" userId="4beb67dbd1f8e7f9" providerId="LiveId" clId="{20F0F18A-9429-406C-B392-E549F940441F}" dt="2023-07-03T12:46:01.728" v="1218" actId="478"/>
          <ac:cxnSpMkLst>
            <pc:docMk/>
            <pc:sldMk cId="152248518" sldId="260"/>
            <ac:cxnSpMk id="47" creationId="{0E43A272-55F0-BFB2-DCE2-9777EBAEA055}"/>
          </ac:cxnSpMkLst>
        </pc:cxnChg>
        <pc:cxnChg chg="del mod">
          <ac:chgData name="Manish Yadav" userId="4beb67dbd1f8e7f9" providerId="LiveId" clId="{20F0F18A-9429-406C-B392-E549F940441F}" dt="2023-07-03T12:46:15.146" v="1222" actId="478"/>
          <ac:cxnSpMkLst>
            <pc:docMk/>
            <pc:sldMk cId="152248518" sldId="260"/>
            <ac:cxnSpMk id="48" creationId="{5DACE37D-7D87-BF36-18E6-64B762527ED3}"/>
          </ac:cxnSpMkLst>
        </pc:cxnChg>
        <pc:cxnChg chg="del mod">
          <ac:chgData name="Manish Yadav" userId="4beb67dbd1f8e7f9" providerId="LiveId" clId="{20F0F18A-9429-406C-B392-E549F940441F}" dt="2023-07-03T12:46:18.865" v="1223" actId="478"/>
          <ac:cxnSpMkLst>
            <pc:docMk/>
            <pc:sldMk cId="152248518" sldId="260"/>
            <ac:cxnSpMk id="49" creationId="{F7B41670-2C93-953F-E540-FFC242AF7E7E}"/>
          </ac:cxnSpMkLst>
        </pc:cxnChg>
        <pc:cxnChg chg="del mod">
          <ac:chgData name="Manish Yadav" userId="4beb67dbd1f8e7f9" providerId="LiveId" clId="{20F0F18A-9429-406C-B392-E549F940441F}" dt="2023-07-03T12:46:21.697" v="1224" actId="478"/>
          <ac:cxnSpMkLst>
            <pc:docMk/>
            <pc:sldMk cId="152248518" sldId="260"/>
            <ac:cxnSpMk id="50" creationId="{6641537C-2C1D-9A50-E107-4314AA4DDF50}"/>
          </ac:cxnSpMkLst>
        </pc:cxnChg>
        <pc:cxnChg chg="mod">
          <ac:chgData name="Manish Yadav" userId="4beb67dbd1f8e7f9" providerId="LiveId" clId="{20F0F18A-9429-406C-B392-E549F940441F}" dt="2023-07-03T12:40:36.897" v="1141"/>
          <ac:cxnSpMkLst>
            <pc:docMk/>
            <pc:sldMk cId="152248518" sldId="260"/>
            <ac:cxnSpMk id="60" creationId="{80EB3E00-A6AD-EE6D-C044-AEFF90C40C22}"/>
          </ac:cxnSpMkLst>
        </pc:cxnChg>
        <pc:cxnChg chg="mod">
          <ac:chgData name="Manish Yadav" userId="4beb67dbd1f8e7f9" providerId="LiveId" clId="{20F0F18A-9429-406C-B392-E549F940441F}" dt="2023-07-03T12:40:36.897" v="1141"/>
          <ac:cxnSpMkLst>
            <pc:docMk/>
            <pc:sldMk cId="152248518" sldId="260"/>
            <ac:cxnSpMk id="61" creationId="{151F6393-7F33-40F1-D3F9-9CDF4319F9C6}"/>
          </ac:cxnSpMkLst>
        </pc:cxnChg>
        <pc:cxnChg chg="mod">
          <ac:chgData name="Manish Yadav" userId="4beb67dbd1f8e7f9" providerId="LiveId" clId="{20F0F18A-9429-406C-B392-E549F940441F}" dt="2023-07-03T12:40:36.897" v="1141"/>
          <ac:cxnSpMkLst>
            <pc:docMk/>
            <pc:sldMk cId="152248518" sldId="260"/>
            <ac:cxnSpMk id="62" creationId="{3274D34C-5EF7-8DF2-1973-ACB7B4E36537}"/>
          </ac:cxnSpMkLst>
        </pc:cxnChg>
        <pc:cxnChg chg="del mod">
          <ac:chgData name="Manish Yadav" userId="4beb67dbd1f8e7f9" providerId="LiveId" clId="{20F0F18A-9429-406C-B392-E549F940441F}" dt="2023-07-03T12:46:34.718" v="1230" actId="478"/>
          <ac:cxnSpMkLst>
            <pc:docMk/>
            <pc:sldMk cId="152248518" sldId="260"/>
            <ac:cxnSpMk id="63" creationId="{7551015F-2D1A-F674-DD1C-3AA9ED3B7735}"/>
          </ac:cxnSpMkLst>
        </pc:cxnChg>
        <pc:cxnChg chg="del mod">
          <ac:chgData name="Manish Yadav" userId="4beb67dbd1f8e7f9" providerId="LiveId" clId="{20F0F18A-9429-406C-B392-E549F940441F}" dt="2023-07-03T12:46:40.483" v="1232" actId="478"/>
          <ac:cxnSpMkLst>
            <pc:docMk/>
            <pc:sldMk cId="152248518" sldId="260"/>
            <ac:cxnSpMk id="64" creationId="{BBCBF1E7-5B82-60E7-89CE-F048190D138E}"/>
          </ac:cxnSpMkLst>
        </pc:cxnChg>
        <pc:cxnChg chg="del mod">
          <ac:chgData name="Manish Yadav" userId="4beb67dbd1f8e7f9" providerId="LiveId" clId="{20F0F18A-9429-406C-B392-E549F940441F}" dt="2023-07-03T12:46:46.435" v="1236" actId="478"/>
          <ac:cxnSpMkLst>
            <pc:docMk/>
            <pc:sldMk cId="152248518" sldId="260"/>
            <ac:cxnSpMk id="65" creationId="{3993E3BF-7714-01B5-A0FD-4A66FE069022}"/>
          </ac:cxnSpMkLst>
        </pc:cxnChg>
        <pc:cxnChg chg="del mod topLvl">
          <ac:chgData name="Manish Yadav" userId="4beb67dbd1f8e7f9" providerId="LiveId" clId="{20F0F18A-9429-406C-B392-E549F940441F}" dt="2023-07-03T12:51:55.495" v="1274" actId="478"/>
          <ac:cxnSpMkLst>
            <pc:docMk/>
            <pc:sldMk cId="152248518" sldId="260"/>
            <ac:cxnSpMk id="78" creationId="{2C4C02D9-DA33-BB46-133F-E0CCA62B445D}"/>
          </ac:cxnSpMkLst>
        </pc:cxnChg>
        <pc:cxnChg chg="del mod topLvl">
          <ac:chgData name="Manish Yadav" userId="4beb67dbd1f8e7f9" providerId="LiveId" clId="{20F0F18A-9429-406C-B392-E549F940441F}" dt="2023-07-03T12:51:58.292" v="1275" actId="478"/>
          <ac:cxnSpMkLst>
            <pc:docMk/>
            <pc:sldMk cId="152248518" sldId="260"/>
            <ac:cxnSpMk id="79" creationId="{A2E09A31-0109-7CFF-720B-EF307BB806D6}"/>
          </ac:cxnSpMkLst>
        </pc:cxnChg>
        <pc:cxnChg chg="del mod topLvl">
          <ac:chgData name="Manish Yadav" userId="4beb67dbd1f8e7f9" providerId="LiveId" clId="{20F0F18A-9429-406C-B392-E549F940441F}" dt="2023-07-03T12:51:51.582" v="1272" actId="478"/>
          <ac:cxnSpMkLst>
            <pc:docMk/>
            <pc:sldMk cId="152248518" sldId="260"/>
            <ac:cxnSpMk id="80" creationId="{240ECC81-3F26-B764-0215-3050F9126584}"/>
          </ac:cxnSpMkLst>
        </pc:cxnChg>
        <pc:cxnChg chg="del mod topLvl">
          <ac:chgData name="Manish Yadav" userId="4beb67dbd1f8e7f9" providerId="LiveId" clId="{20F0F18A-9429-406C-B392-E549F940441F}" dt="2023-07-03T12:51:49.053" v="1271" actId="478"/>
          <ac:cxnSpMkLst>
            <pc:docMk/>
            <pc:sldMk cId="152248518" sldId="260"/>
            <ac:cxnSpMk id="81" creationId="{9E20F400-1856-C026-088E-765F2019A768}"/>
          </ac:cxnSpMkLst>
        </pc:cxnChg>
        <pc:cxnChg chg="del mod topLvl">
          <ac:chgData name="Manish Yadav" userId="4beb67dbd1f8e7f9" providerId="LiveId" clId="{20F0F18A-9429-406C-B392-E549F940441F}" dt="2023-07-03T12:51:33.836" v="1265" actId="478"/>
          <ac:cxnSpMkLst>
            <pc:docMk/>
            <pc:sldMk cId="152248518" sldId="260"/>
            <ac:cxnSpMk id="91" creationId="{67533538-F52E-4D49-D594-8BF3F10ECA98}"/>
          </ac:cxnSpMkLst>
        </pc:cxnChg>
        <pc:cxnChg chg="del mod topLvl">
          <ac:chgData name="Manish Yadav" userId="4beb67dbd1f8e7f9" providerId="LiveId" clId="{20F0F18A-9429-406C-B392-E549F940441F}" dt="2023-07-03T12:51:33.836" v="1265" actId="478"/>
          <ac:cxnSpMkLst>
            <pc:docMk/>
            <pc:sldMk cId="152248518" sldId="260"/>
            <ac:cxnSpMk id="92" creationId="{4AA60BBD-A11D-FBD7-71EA-464FDF09A538}"/>
          </ac:cxnSpMkLst>
        </pc:cxnChg>
        <pc:cxnChg chg="del mod topLvl">
          <ac:chgData name="Manish Yadav" userId="4beb67dbd1f8e7f9" providerId="LiveId" clId="{20F0F18A-9429-406C-B392-E549F940441F}" dt="2023-07-03T12:51:33.836" v="1265" actId="478"/>
          <ac:cxnSpMkLst>
            <pc:docMk/>
            <pc:sldMk cId="152248518" sldId="260"/>
            <ac:cxnSpMk id="93" creationId="{C7253B65-0AAF-DCB5-D72A-39269259D36A}"/>
          </ac:cxnSpMkLst>
        </pc:cxnChg>
        <pc:cxnChg chg="mod topLvl">
          <ac:chgData name="Manish Yadav" userId="4beb67dbd1f8e7f9" providerId="LiveId" clId="{20F0F18A-9429-406C-B392-E549F940441F}" dt="2023-07-03T12:52:31.672" v="1282" actId="164"/>
          <ac:cxnSpMkLst>
            <pc:docMk/>
            <pc:sldMk cId="152248518" sldId="260"/>
            <ac:cxnSpMk id="94" creationId="{4B61A03E-9BB0-5782-81FF-33BFBBBF4931}"/>
          </ac:cxnSpMkLst>
        </pc:cxnChg>
        <pc:cxnChg chg="mod topLvl">
          <ac:chgData name="Manish Yadav" userId="4beb67dbd1f8e7f9" providerId="LiveId" clId="{20F0F18A-9429-406C-B392-E549F940441F}" dt="2023-07-03T12:52:31.672" v="1282" actId="164"/>
          <ac:cxnSpMkLst>
            <pc:docMk/>
            <pc:sldMk cId="152248518" sldId="260"/>
            <ac:cxnSpMk id="95" creationId="{75CA3ABC-158F-FEAB-2167-5DF59340809F}"/>
          </ac:cxnSpMkLst>
        </pc:cxnChg>
        <pc:cxnChg chg="mod topLvl">
          <ac:chgData name="Manish Yadav" userId="4beb67dbd1f8e7f9" providerId="LiveId" clId="{20F0F18A-9429-406C-B392-E549F940441F}" dt="2023-07-03T12:52:31.672" v="1282" actId="164"/>
          <ac:cxnSpMkLst>
            <pc:docMk/>
            <pc:sldMk cId="152248518" sldId="260"/>
            <ac:cxnSpMk id="96" creationId="{C88C0FA4-6815-1FCE-F04F-62BE711179E5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10" creationId="{F7F326A7-EB2B-5CBC-6C7D-A7A52C8E49A5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11" creationId="{81D24892-4DE9-333E-8BA9-2136D5D86041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12" creationId="{16EA1A85-ACE6-B3ED-F82E-871700ED2E01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13" creationId="{5634E2DA-80FA-BA23-BC94-75D1727E3C09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23" creationId="{904886BD-A116-33EE-7076-607B90DE806A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24" creationId="{BC2E7D68-835D-F3F7-3ADC-B7954068CF7F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25" creationId="{B22AADD7-DC04-342D-8343-6981110BA97F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26" creationId="{B946D33A-A90A-26F3-561A-4C6F56C80C84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27" creationId="{C921E9F3-8E0E-8301-0CF8-745DB94E4AA9}"/>
          </ac:cxnSpMkLst>
        </pc:cxnChg>
        <pc:cxnChg chg="mod">
          <ac:chgData name="Manish Yadav" userId="4beb67dbd1f8e7f9" providerId="LiveId" clId="{20F0F18A-9429-406C-B392-E549F940441F}" dt="2023-07-03T12:44:07.915" v="1168" actId="571"/>
          <ac:cxnSpMkLst>
            <pc:docMk/>
            <pc:sldMk cId="152248518" sldId="260"/>
            <ac:cxnSpMk id="128" creationId="{C33607C7-0228-2BAD-731A-AC499E43DAAE}"/>
          </ac:cxnSpMkLst>
        </pc:cxnChg>
        <pc:cxnChg chg="add mod">
          <ac:chgData name="Manish Yadav" userId="4beb67dbd1f8e7f9" providerId="LiveId" clId="{20F0F18A-9429-406C-B392-E549F940441F}" dt="2023-07-03T15:09:33.269" v="2182" actId="1036"/>
          <ac:cxnSpMkLst>
            <pc:docMk/>
            <pc:sldMk cId="152248518" sldId="260"/>
            <ac:cxnSpMk id="136" creationId="{F25BD331-0871-367F-A874-6E16D69AC0A2}"/>
          </ac:cxnSpMkLst>
        </pc:cxnChg>
        <pc:cxnChg chg="add mod">
          <ac:chgData name="Manish Yadav" userId="4beb67dbd1f8e7f9" providerId="LiveId" clId="{20F0F18A-9429-406C-B392-E549F940441F}" dt="2023-07-03T15:09:33.269" v="2182" actId="1036"/>
          <ac:cxnSpMkLst>
            <pc:docMk/>
            <pc:sldMk cId="152248518" sldId="260"/>
            <ac:cxnSpMk id="138" creationId="{DCD661EF-973D-95BF-5ACC-4F1817BD7016}"/>
          </ac:cxnSpMkLst>
        </pc:cxnChg>
      </pc:sldChg>
      <pc:sldChg chg="addSp delSp modSp new mod">
        <pc:chgData name="Manish Yadav" userId="4beb67dbd1f8e7f9" providerId="LiveId" clId="{20F0F18A-9429-406C-B392-E549F940441F}" dt="2023-07-03T15:04:17.598" v="2111" actId="693"/>
        <pc:sldMkLst>
          <pc:docMk/>
          <pc:sldMk cId="3818877438" sldId="261"/>
        </pc:sldMkLst>
        <pc:spChg chg="del">
          <ac:chgData name="Manish Yadav" userId="4beb67dbd1f8e7f9" providerId="LiveId" clId="{20F0F18A-9429-406C-B392-E549F940441F}" dt="2023-07-03T14:42:21.853" v="1469" actId="478"/>
          <ac:spMkLst>
            <pc:docMk/>
            <pc:sldMk cId="3818877438" sldId="261"/>
            <ac:spMk id="2" creationId="{B85B9DE9-ABE0-2D3B-F4C7-44D5F2C6B841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5" creationId="{58EAB423-FD21-639F-14D6-77368A5925ED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6" creationId="{6488296E-4D21-0FD7-AC20-812FA0436C03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7" creationId="{CC960E04-D133-C25D-3FEB-BF9946F7E5A1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8" creationId="{73A82B9B-A822-F308-C1F8-8293D3C78787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13" creationId="{2C6E9F87-22F8-9CA4-2958-C6E0F47A219B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14" creationId="{D84BED1E-0C24-EF12-539F-D67A61DDEA53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15" creationId="{BCA34666-3924-AE5D-1219-C4E5676600F2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16" creationId="{0A6EC241-8E14-F9AB-714B-D449FEFECE07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23" creationId="{70DBFBAA-2905-A55C-855D-3F42C7D91159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24" creationId="{BC345940-4A15-A9A1-CC54-FA9807256AE4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25" creationId="{BA6DE5A2-9976-6471-79FF-9D3C0CB28DDF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26" creationId="{F5A3EAAF-A020-8EFF-44C2-96DB8BB25D5D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28" creationId="{9B0CAE6C-6B0D-BEA1-6A08-214F0E9CEEB8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32" creationId="{F5AFCFA3-7C7D-C9B3-0CF0-D280130628E1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33" creationId="{26E04B3F-3EF9-58AB-11A2-36BEF7D72107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34" creationId="{8102333C-2D2F-4802-26A4-80BAD34CE0C5}"/>
          </ac:spMkLst>
        </pc:spChg>
        <pc:spChg chg="mod">
          <ac:chgData name="Manish Yadav" userId="4beb67dbd1f8e7f9" providerId="LiveId" clId="{20F0F18A-9429-406C-B392-E549F940441F}" dt="2023-07-03T14:42:22.338" v="1470"/>
          <ac:spMkLst>
            <pc:docMk/>
            <pc:sldMk cId="3818877438" sldId="261"/>
            <ac:spMk id="35" creationId="{8D71B93B-E6D7-752C-1A27-B1CADFE3FCDD}"/>
          </ac:spMkLst>
        </pc:spChg>
        <pc:spChg chg="add mod">
          <ac:chgData name="Manish Yadav" userId="4beb67dbd1f8e7f9" providerId="LiveId" clId="{20F0F18A-9429-406C-B392-E549F940441F}" dt="2023-07-03T15:02:55.424" v="2049" actId="1038"/>
          <ac:spMkLst>
            <pc:docMk/>
            <pc:sldMk cId="3818877438" sldId="261"/>
            <ac:spMk id="36" creationId="{A8EBEE03-560C-CAA7-BF28-AF9196F1D107}"/>
          </ac:spMkLst>
        </pc:spChg>
        <pc:spChg chg="add mod">
          <ac:chgData name="Manish Yadav" userId="4beb67dbd1f8e7f9" providerId="LiveId" clId="{20F0F18A-9429-406C-B392-E549F940441F}" dt="2023-07-03T15:03:49.558" v="2103" actId="14100"/>
          <ac:spMkLst>
            <pc:docMk/>
            <pc:sldMk cId="3818877438" sldId="261"/>
            <ac:spMk id="37" creationId="{2562D93F-048A-BA8F-57AC-7D858608AABA}"/>
          </ac:spMkLst>
        </pc:spChg>
        <pc:spChg chg="add mod">
          <ac:chgData name="Manish Yadav" userId="4beb67dbd1f8e7f9" providerId="LiveId" clId="{20F0F18A-9429-406C-B392-E549F940441F}" dt="2023-07-03T15:03:16.403" v="2053" actId="164"/>
          <ac:spMkLst>
            <pc:docMk/>
            <pc:sldMk cId="3818877438" sldId="261"/>
            <ac:spMk id="40" creationId="{D665CAB1-177C-8BB8-1595-113E307BBC23}"/>
          </ac:spMkLst>
        </pc:spChg>
        <pc:spChg chg="add mod">
          <ac:chgData name="Manish Yadav" userId="4beb67dbd1f8e7f9" providerId="LiveId" clId="{20F0F18A-9429-406C-B392-E549F940441F}" dt="2023-07-03T15:03:12.189" v="2052" actId="164"/>
          <ac:spMkLst>
            <pc:docMk/>
            <pc:sldMk cId="3818877438" sldId="261"/>
            <ac:spMk id="42" creationId="{AE620EAC-14AB-63C0-3650-52B6A62838C6}"/>
          </ac:spMkLst>
        </pc:spChg>
        <pc:spChg chg="add mod">
          <ac:chgData name="Manish Yadav" userId="4beb67dbd1f8e7f9" providerId="LiveId" clId="{20F0F18A-9429-406C-B392-E549F940441F}" dt="2023-07-03T14:49:16.200" v="1545" actId="14100"/>
          <ac:spMkLst>
            <pc:docMk/>
            <pc:sldMk cId="3818877438" sldId="261"/>
            <ac:spMk id="44" creationId="{FEB92D0B-E641-21F0-B348-8CEF16426748}"/>
          </ac:spMkLst>
        </pc:spChg>
        <pc:spChg chg="add del mod">
          <ac:chgData name="Manish Yadav" userId="4beb67dbd1f8e7f9" providerId="LiveId" clId="{20F0F18A-9429-406C-B392-E549F940441F}" dt="2023-07-03T14:49:00.189" v="1541"/>
          <ac:spMkLst>
            <pc:docMk/>
            <pc:sldMk cId="3818877438" sldId="261"/>
            <ac:spMk id="45" creationId="{4A32D0AB-B8F7-8BDF-2D43-A6B29208B3C8}"/>
          </ac:spMkLst>
        </pc:spChg>
        <pc:grpChg chg="add mod">
          <ac:chgData name="Manish Yadav" userId="4beb67dbd1f8e7f9" providerId="LiveId" clId="{20F0F18A-9429-406C-B392-E549F940441F}" dt="2023-07-03T14:42:55.734" v="1481" actId="164"/>
          <ac:grpSpMkLst>
            <pc:docMk/>
            <pc:sldMk cId="3818877438" sldId="261"/>
            <ac:grpSpMk id="3" creationId="{D001CB82-148B-3057-B71D-BEB9696BDE82}"/>
          </ac:grpSpMkLst>
        </pc:grpChg>
        <pc:grpChg chg="mod">
          <ac:chgData name="Manish Yadav" userId="4beb67dbd1f8e7f9" providerId="LiveId" clId="{20F0F18A-9429-406C-B392-E549F940441F}" dt="2023-07-03T14:42:22.338" v="1470"/>
          <ac:grpSpMkLst>
            <pc:docMk/>
            <pc:sldMk cId="3818877438" sldId="261"/>
            <ac:grpSpMk id="4" creationId="{B5BA8184-46F0-61CF-FB6E-8F355C2CA174}"/>
          </ac:grpSpMkLst>
        </pc:grpChg>
        <pc:grpChg chg="mod">
          <ac:chgData name="Manish Yadav" userId="4beb67dbd1f8e7f9" providerId="LiveId" clId="{20F0F18A-9429-406C-B392-E549F940441F}" dt="2023-07-03T14:42:22.338" v="1470"/>
          <ac:grpSpMkLst>
            <pc:docMk/>
            <pc:sldMk cId="3818877438" sldId="261"/>
            <ac:grpSpMk id="17" creationId="{7AB0206D-579E-AD32-90F6-B4266642BDA5}"/>
          </ac:grpSpMkLst>
        </pc:grpChg>
        <pc:grpChg chg="mod">
          <ac:chgData name="Manish Yadav" userId="4beb67dbd1f8e7f9" providerId="LiveId" clId="{20F0F18A-9429-406C-B392-E549F940441F}" dt="2023-07-03T14:42:22.338" v="1470"/>
          <ac:grpSpMkLst>
            <pc:docMk/>
            <pc:sldMk cId="3818877438" sldId="261"/>
            <ac:grpSpMk id="27" creationId="{EE714AF7-D685-2BBB-9E56-8D8386B6CE4E}"/>
          </ac:grpSpMkLst>
        </pc:grpChg>
        <pc:grpChg chg="add mod">
          <ac:chgData name="Manish Yadav" userId="4beb67dbd1f8e7f9" providerId="LiveId" clId="{20F0F18A-9429-406C-B392-E549F940441F}" dt="2023-07-03T15:02:49.365" v="2040" actId="1037"/>
          <ac:grpSpMkLst>
            <pc:docMk/>
            <pc:sldMk cId="3818877438" sldId="261"/>
            <ac:grpSpMk id="38" creationId="{ECAD9EAF-6D65-1006-26FE-F6E9D5D51545}"/>
          </ac:grpSpMkLst>
        </pc:grpChg>
        <pc:grpChg chg="add mod">
          <ac:chgData name="Manish Yadav" userId="4beb67dbd1f8e7f9" providerId="LiveId" clId="{20F0F18A-9429-406C-B392-E549F940441F}" dt="2023-07-03T15:03:45.018" v="2102" actId="1036"/>
          <ac:grpSpMkLst>
            <pc:docMk/>
            <pc:sldMk cId="3818877438" sldId="261"/>
            <ac:grpSpMk id="46" creationId="{7D8BC51D-A8D6-6550-993F-54FE3D9EBB46}"/>
          </ac:grpSpMkLst>
        </pc:grpChg>
        <pc:grpChg chg="add mod">
          <ac:chgData name="Manish Yadav" userId="4beb67dbd1f8e7f9" providerId="LiveId" clId="{20F0F18A-9429-406C-B392-E549F940441F}" dt="2023-07-03T15:03:35.150" v="2087" actId="1036"/>
          <ac:grpSpMkLst>
            <pc:docMk/>
            <pc:sldMk cId="3818877438" sldId="261"/>
            <ac:grpSpMk id="47" creationId="{63460850-B990-8313-D1E0-4404BB04064B}"/>
          </ac:grpSpMkLst>
        </pc:grpChg>
        <pc:picChg chg="mod">
          <ac:chgData name="Manish Yadav" userId="4beb67dbd1f8e7f9" providerId="LiveId" clId="{20F0F18A-9429-406C-B392-E549F940441F}" dt="2023-07-03T14:42:22.338" v="1470"/>
          <ac:picMkLst>
            <pc:docMk/>
            <pc:sldMk cId="3818877438" sldId="261"/>
            <ac:picMk id="18" creationId="{24D4AF9F-0A35-D4E2-1775-708C84239B74}"/>
          </ac:picMkLst>
        </pc:picChg>
        <pc:picChg chg="mod">
          <ac:chgData name="Manish Yadav" userId="4beb67dbd1f8e7f9" providerId="LiveId" clId="{20F0F18A-9429-406C-B392-E549F940441F}" dt="2023-07-03T14:42:22.338" v="1470"/>
          <ac:picMkLst>
            <pc:docMk/>
            <pc:sldMk cId="3818877438" sldId="261"/>
            <ac:picMk id="19" creationId="{29A98FC0-B367-0096-8188-AC74787F92ED}"/>
          </ac:picMkLst>
        </pc:picChg>
        <pc:picChg chg="add mod modCrop">
          <ac:chgData name="Manish Yadav" userId="4beb67dbd1f8e7f9" providerId="LiveId" clId="{20F0F18A-9429-406C-B392-E549F940441F}" dt="2023-07-03T15:03:16.403" v="2053" actId="164"/>
          <ac:picMkLst>
            <pc:docMk/>
            <pc:sldMk cId="3818877438" sldId="261"/>
            <ac:picMk id="39" creationId="{55282632-696F-AB0F-C7CC-4880F5C04F84}"/>
          </ac:picMkLst>
        </pc:picChg>
        <pc:picChg chg="add mod modCrop">
          <ac:chgData name="Manish Yadav" userId="4beb67dbd1f8e7f9" providerId="LiveId" clId="{20F0F18A-9429-406C-B392-E549F940441F}" dt="2023-07-03T15:03:12.189" v="2052" actId="164"/>
          <ac:picMkLst>
            <pc:docMk/>
            <pc:sldMk cId="3818877438" sldId="261"/>
            <ac:picMk id="41" creationId="{CB488459-6655-E87D-0005-6BC63018DB64}"/>
          </ac:picMkLst>
        </pc:pic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9" creationId="{196F5C79-FE81-5554-CFC8-31E9FC09F3C9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10" creationId="{070D7A20-5292-12E3-19FF-E800CE0605A2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11" creationId="{AFB7DBE8-1088-D276-0414-D08ACD469044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12" creationId="{0875B2C3-CF13-6B92-A585-EAF614842EB3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20" creationId="{B892D997-C402-DB37-CA7E-ACA0A22A79AC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21" creationId="{88419D5B-5303-656C-6E0F-AE7E12BA8D4F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22" creationId="{F32BBB54-FEFC-398A-71CD-F5EC2D32E083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29" creationId="{D0373F9D-65D4-40A1-5045-7F34AA9453C9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30" creationId="{62D07D0D-493B-FA38-721C-F94808763081}"/>
          </ac:cxnSpMkLst>
        </pc:cxnChg>
        <pc:cxnChg chg="mod">
          <ac:chgData name="Manish Yadav" userId="4beb67dbd1f8e7f9" providerId="LiveId" clId="{20F0F18A-9429-406C-B392-E549F940441F}" dt="2023-07-03T14:42:22.338" v="1470"/>
          <ac:cxnSpMkLst>
            <pc:docMk/>
            <pc:sldMk cId="3818877438" sldId="261"/>
            <ac:cxnSpMk id="31" creationId="{A74EA0EB-2A2E-757C-B86A-FA4C8FDDE4A9}"/>
          </ac:cxnSpMkLst>
        </pc:cxnChg>
        <pc:cxnChg chg="add mod">
          <ac:chgData name="Manish Yadav" userId="4beb67dbd1f8e7f9" providerId="LiveId" clId="{20F0F18A-9429-406C-B392-E549F940441F}" dt="2023-07-03T15:04:03.209" v="2107" actId="693"/>
          <ac:cxnSpMkLst>
            <pc:docMk/>
            <pc:sldMk cId="3818877438" sldId="261"/>
            <ac:cxnSpMk id="49" creationId="{4334D55A-9FB1-7145-352B-76EC9F29915F}"/>
          </ac:cxnSpMkLst>
        </pc:cxnChg>
        <pc:cxnChg chg="add mod">
          <ac:chgData name="Manish Yadav" userId="4beb67dbd1f8e7f9" providerId="LiveId" clId="{20F0F18A-9429-406C-B392-E549F940441F}" dt="2023-07-03T15:04:17.598" v="2111" actId="693"/>
          <ac:cxnSpMkLst>
            <pc:docMk/>
            <pc:sldMk cId="3818877438" sldId="261"/>
            <ac:cxnSpMk id="51" creationId="{D4E1A701-F471-CEBA-7DAE-7CBD759CF8D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82365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99851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12910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1082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40712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1547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99918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9508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41076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16341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7697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327A4-B0BA-4263-B13C-9EBDF4C125DE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C345F-44DB-4999-8AE5-A072E04CEC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5647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825DEEC-1BB8-CFBD-6334-BA0E791A76FE}"/>
              </a:ext>
            </a:extLst>
          </p:cNvPr>
          <p:cNvSpPr txBox="1"/>
          <p:nvPr/>
        </p:nvSpPr>
        <p:spPr>
          <a:xfrm>
            <a:off x="118549" y="92586"/>
            <a:ext cx="9317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5a</a:t>
            </a:r>
            <a:endParaRPr lang="en-IN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1D33926-7605-B111-8C9C-673E1A1A9262}"/>
              </a:ext>
            </a:extLst>
          </p:cNvPr>
          <p:cNvGrpSpPr/>
          <p:nvPr/>
        </p:nvGrpSpPr>
        <p:grpSpPr>
          <a:xfrm>
            <a:off x="37902" y="3747089"/>
            <a:ext cx="3221782" cy="2198712"/>
            <a:chOff x="6263" y="2378834"/>
            <a:chExt cx="3501828" cy="2463748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47FC9F2-F487-A84E-F9E3-CA65E22424E3}"/>
                </a:ext>
              </a:extLst>
            </p:cNvPr>
            <p:cNvSpPr txBox="1"/>
            <p:nvPr/>
          </p:nvSpPr>
          <p:spPr>
            <a:xfrm>
              <a:off x="16972" y="3882868"/>
              <a:ext cx="689223" cy="27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en-I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375C6479-3CEF-6F5F-5124-DA315E90E30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7405" y="3247570"/>
              <a:ext cx="168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1486BDA2-D3EF-2DDE-BB22-1F2611D36DF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7405" y="3565631"/>
              <a:ext cx="168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1DD5781E-3773-6863-0BC3-57207846A02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7405" y="2992321"/>
              <a:ext cx="168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E270AC58-4179-019D-A648-E827D607D0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7405" y="4377576"/>
              <a:ext cx="168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0156A74-E3B4-9847-4EC5-A7585C285D41}"/>
                </a:ext>
              </a:extLst>
            </p:cNvPr>
            <p:cNvSpPr txBox="1"/>
            <p:nvPr/>
          </p:nvSpPr>
          <p:spPr>
            <a:xfrm>
              <a:off x="6263" y="4234799"/>
              <a:ext cx="689223" cy="27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33kDa</a:t>
              </a:r>
              <a:endParaRPr lang="en-I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70F297A0-DF8F-A6BB-41FE-765A8811C3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7405" y="3763622"/>
              <a:ext cx="168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3CE4CCA1-EDD2-D453-40AB-6151E9253D1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7405" y="4017190"/>
              <a:ext cx="168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9E580CD3-F259-9A88-6AD8-28B41F2E44FD}"/>
                </a:ext>
              </a:extLst>
            </p:cNvPr>
            <p:cNvGrpSpPr/>
            <p:nvPr/>
          </p:nvGrpSpPr>
          <p:grpSpPr>
            <a:xfrm>
              <a:off x="107611" y="2378834"/>
              <a:ext cx="3400480" cy="2463748"/>
              <a:chOff x="-986077" y="5246493"/>
              <a:chExt cx="3659938" cy="2515964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239E3C29-76A7-5D2F-010F-871D38BD20C6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795" t="36591" r="37381" b="52500"/>
              <a:stretch/>
            </p:blipFill>
            <p:spPr>
              <a:xfrm>
                <a:off x="-311286" y="6604011"/>
                <a:ext cx="2726148" cy="72790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DB41612C-85B8-87F4-7A35-E844FE5CAB2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457" t="36777" r="37438" b="51882"/>
              <a:stretch/>
            </p:blipFill>
            <p:spPr>
              <a:xfrm>
                <a:off x="-308544" y="5802253"/>
                <a:ext cx="2726148" cy="72790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7BFAB142-8C23-43F5-7751-0286F7E83379}"/>
                  </a:ext>
                </a:extLst>
              </p:cNvPr>
              <p:cNvGrpSpPr/>
              <p:nvPr/>
            </p:nvGrpSpPr>
            <p:grpSpPr>
              <a:xfrm>
                <a:off x="-986077" y="5246493"/>
                <a:ext cx="3659938" cy="2515964"/>
                <a:chOff x="5221449" y="7381938"/>
                <a:chExt cx="3659938" cy="2515964"/>
              </a:xfrm>
            </p:grpSpPr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8A21547D-27B8-F210-3728-41942AEA7992}"/>
                    </a:ext>
                  </a:extLst>
                </p:cNvPr>
                <p:cNvSpPr txBox="1"/>
                <p:nvPr/>
              </p:nvSpPr>
              <p:spPr>
                <a:xfrm rot="5400000">
                  <a:off x="8122918" y="8102612"/>
                  <a:ext cx="1210518" cy="2880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WB:pERK1/2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C15A4CB1-F4C1-5B86-68FA-EDD2AF17B4E8}"/>
                    </a:ext>
                  </a:extLst>
                </p:cNvPr>
                <p:cNvSpPr txBox="1"/>
                <p:nvPr/>
              </p:nvSpPr>
              <p:spPr>
                <a:xfrm rot="5400000">
                  <a:off x="8105248" y="9121762"/>
                  <a:ext cx="1264236" cy="2880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WB:tERK1/2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2BCCABBE-11BB-6A84-E4F9-0A0B5D19C8BA}"/>
                    </a:ext>
                  </a:extLst>
                </p:cNvPr>
                <p:cNvSpPr txBox="1"/>
                <p:nvPr/>
              </p:nvSpPr>
              <p:spPr>
                <a:xfrm>
                  <a:off x="5221449" y="7691167"/>
                  <a:ext cx="3383747" cy="2817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Time (min)       0     5   15   0    5   15    0   5   15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A09F267C-EA3C-B2F1-3A8E-3295F8F07FE4}"/>
                    </a:ext>
                  </a:extLst>
                </p:cNvPr>
                <p:cNvSpPr txBox="1"/>
                <p:nvPr/>
              </p:nvSpPr>
              <p:spPr>
                <a:xfrm>
                  <a:off x="6296759" y="7381939"/>
                  <a:ext cx="675353" cy="2817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Left Brace 26">
                  <a:extLst>
                    <a:ext uri="{FF2B5EF4-FFF2-40B4-BE49-F238E27FC236}">
                      <a16:creationId xmlns:a16="http://schemas.microsoft.com/office/drawing/2014/main" id="{0BB88685-D5BA-738A-4863-F738ACC9DC8A}"/>
                    </a:ext>
                  </a:extLst>
                </p:cNvPr>
                <p:cNvSpPr/>
                <p:nvPr/>
              </p:nvSpPr>
              <p:spPr>
                <a:xfrm rot="5400000">
                  <a:off x="6580617" y="7357518"/>
                  <a:ext cx="113338" cy="681054"/>
                </a:xfrm>
                <a:prstGeom prst="leftBrace">
                  <a:avLst>
                    <a:gd name="adj1" fmla="val 65083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Left Brace 27">
                  <a:extLst>
                    <a:ext uri="{FF2B5EF4-FFF2-40B4-BE49-F238E27FC236}">
                      <a16:creationId xmlns:a16="http://schemas.microsoft.com/office/drawing/2014/main" id="{37451791-CE21-580E-770E-E1E65D517B73}"/>
                    </a:ext>
                  </a:extLst>
                </p:cNvPr>
                <p:cNvSpPr/>
                <p:nvPr/>
              </p:nvSpPr>
              <p:spPr>
                <a:xfrm rot="5400000">
                  <a:off x="7345403" y="7357518"/>
                  <a:ext cx="113338" cy="681054"/>
                </a:xfrm>
                <a:prstGeom prst="leftBrace">
                  <a:avLst>
                    <a:gd name="adj1" fmla="val 65083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Left Brace 28">
                  <a:extLst>
                    <a:ext uri="{FF2B5EF4-FFF2-40B4-BE49-F238E27FC236}">
                      <a16:creationId xmlns:a16="http://schemas.microsoft.com/office/drawing/2014/main" id="{2B65FA0D-4919-F5AD-B090-6905B7EDCB33}"/>
                    </a:ext>
                  </a:extLst>
                </p:cNvPr>
                <p:cNvSpPr/>
                <p:nvPr/>
              </p:nvSpPr>
              <p:spPr>
                <a:xfrm rot="5400000">
                  <a:off x="8115890" y="7357518"/>
                  <a:ext cx="113338" cy="681054"/>
                </a:xfrm>
                <a:prstGeom prst="leftBrace">
                  <a:avLst>
                    <a:gd name="adj1" fmla="val 65083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9BD53FF0-D0D5-554C-C16C-A099D02DD0FA}"/>
                    </a:ext>
                  </a:extLst>
                </p:cNvPr>
                <p:cNvSpPr txBox="1"/>
                <p:nvPr/>
              </p:nvSpPr>
              <p:spPr>
                <a:xfrm>
                  <a:off x="7044181" y="7381941"/>
                  <a:ext cx="788544" cy="2817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CXCR4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CDF068D7-14B6-3BD6-B5AC-ABDE00413D56}"/>
                    </a:ext>
                  </a:extLst>
                </p:cNvPr>
                <p:cNvSpPr txBox="1"/>
                <p:nvPr/>
              </p:nvSpPr>
              <p:spPr>
                <a:xfrm>
                  <a:off x="7783313" y="7381938"/>
                  <a:ext cx="810794" cy="2817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CXCR7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9385214-D888-B449-7011-FCDC1BB431FA}"/>
                </a:ext>
              </a:extLst>
            </p:cNvPr>
            <p:cNvSpPr txBox="1"/>
            <p:nvPr/>
          </p:nvSpPr>
          <p:spPr>
            <a:xfrm>
              <a:off x="16972" y="3624507"/>
              <a:ext cx="684475" cy="27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54kDa</a:t>
              </a:r>
              <a:endParaRPr lang="en-I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FFA1B4E-15BE-CACE-F44A-25BC2F1A6B66}"/>
                </a:ext>
              </a:extLst>
            </p:cNvPr>
            <p:cNvSpPr txBox="1"/>
            <p:nvPr/>
          </p:nvSpPr>
          <p:spPr>
            <a:xfrm>
              <a:off x="16972" y="3101348"/>
              <a:ext cx="676342" cy="27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en-I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B124CC3-D4C7-3848-57DE-2D5940A4F328}"/>
                </a:ext>
              </a:extLst>
            </p:cNvPr>
            <p:cNvSpPr txBox="1"/>
            <p:nvPr/>
          </p:nvSpPr>
          <p:spPr>
            <a:xfrm>
              <a:off x="16972" y="3409607"/>
              <a:ext cx="676342" cy="27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33kDa</a:t>
              </a:r>
              <a:endParaRPr lang="en-I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6202A5A-CBE5-2D1C-CEE1-382C2BAE66FB}"/>
                </a:ext>
              </a:extLst>
            </p:cNvPr>
            <p:cNvSpPr txBox="1"/>
            <p:nvPr/>
          </p:nvSpPr>
          <p:spPr>
            <a:xfrm>
              <a:off x="20941" y="2849610"/>
              <a:ext cx="771923" cy="27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54kDa</a:t>
              </a:r>
              <a:endParaRPr lang="en-I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E02D7267-9CC2-0DD0-F9AD-952F4CA2C3C5}"/>
              </a:ext>
            </a:extLst>
          </p:cNvPr>
          <p:cNvCxnSpPr>
            <a:cxnSpLocks/>
          </p:cNvCxnSpPr>
          <p:nvPr/>
        </p:nvCxnSpPr>
        <p:spPr>
          <a:xfrm flipH="1">
            <a:off x="3732747" y="2856148"/>
            <a:ext cx="15511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F942777-C708-5044-5247-8B642AAA4D00}"/>
              </a:ext>
            </a:extLst>
          </p:cNvPr>
          <p:cNvCxnSpPr>
            <a:cxnSpLocks/>
          </p:cNvCxnSpPr>
          <p:nvPr/>
        </p:nvCxnSpPr>
        <p:spPr>
          <a:xfrm flipH="1">
            <a:off x="3732747" y="2628358"/>
            <a:ext cx="15511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DD2FB6D5-18A6-57C4-4386-B7A8DA515C36}"/>
              </a:ext>
            </a:extLst>
          </p:cNvPr>
          <p:cNvSpPr txBox="1"/>
          <p:nvPr/>
        </p:nvSpPr>
        <p:spPr>
          <a:xfrm>
            <a:off x="4619430" y="2080867"/>
            <a:ext cx="577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I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7EA9702-BDCC-BE00-97FD-089865B9994F}"/>
              </a:ext>
            </a:extLst>
          </p:cNvPr>
          <p:cNvSpPr txBox="1"/>
          <p:nvPr/>
        </p:nvSpPr>
        <p:spPr>
          <a:xfrm>
            <a:off x="5258331" y="2080869"/>
            <a:ext cx="674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XCR4</a:t>
            </a:r>
            <a:endParaRPr lang="en-I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FE79C6F-8F76-C585-AB23-B3965D7B3AA5}"/>
              </a:ext>
            </a:extLst>
          </p:cNvPr>
          <p:cNvSpPr txBox="1"/>
          <p:nvPr/>
        </p:nvSpPr>
        <p:spPr>
          <a:xfrm>
            <a:off x="5890146" y="2080866"/>
            <a:ext cx="69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XCR7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D6E3D5AD-6AE3-F6F5-8501-EB186F86F970}"/>
              </a:ext>
            </a:extLst>
          </p:cNvPr>
          <p:cNvCxnSpPr>
            <a:cxnSpLocks/>
          </p:cNvCxnSpPr>
          <p:nvPr/>
        </p:nvCxnSpPr>
        <p:spPr>
          <a:xfrm flipH="1">
            <a:off x="3719786" y="3126721"/>
            <a:ext cx="15511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" name="Group 31">
            <a:extLst>
              <a:ext uri="{FF2B5EF4-FFF2-40B4-BE49-F238E27FC236}">
                <a16:creationId xmlns:a16="http://schemas.microsoft.com/office/drawing/2014/main" id="{7F81ED71-303A-E82E-6C78-8D91A3AEF02A}"/>
              </a:ext>
            </a:extLst>
          </p:cNvPr>
          <p:cNvGrpSpPr/>
          <p:nvPr/>
        </p:nvGrpSpPr>
        <p:grpSpPr>
          <a:xfrm>
            <a:off x="3232641" y="2080866"/>
            <a:ext cx="3588292" cy="2449983"/>
            <a:chOff x="3232641" y="396456"/>
            <a:chExt cx="3588292" cy="2449983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CA3CDE8-88A0-BAF5-336B-C1C3371DA0A0}"/>
                </a:ext>
              </a:extLst>
            </p:cNvPr>
            <p:cNvSpPr txBox="1"/>
            <p:nvPr/>
          </p:nvSpPr>
          <p:spPr>
            <a:xfrm>
              <a:off x="3232641" y="791542"/>
              <a:ext cx="7101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4kDa</a:t>
              </a:r>
              <a:endParaRPr lang="en-I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0DDE1B62-A80D-7069-64D0-087841AA667F}"/>
                </a:ext>
              </a:extLst>
            </p:cNvPr>
            <p:cNvGrpSpPr/>
            <p:nvPr/>
          </p:nvGrpSpPr>
          <p:grpSpPr>
            <a:xfrm>
              <a:off x="3717014" y="396456"/>
              <a:ext cx="3103919" cy="2449983"/>
              <a:chOff x="3717014" y="396456"/>
              <a:chExt cx="3103919" cy="2449983"/>
            </a:xfrm>
          </p:grpSpPr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16B72037-2B47-037D-6B24-23EB90EEE95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538" t="28116" r="33178" b="28205"/>
              <a:stretch/>
            </p:blipFill>
            <p:spPr>
              <a:xfrm>
                <a:off x="3717014" y="396456"/>
                <a:ext cx="2906044" cy="244998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911932F0-ACD6-A611-B87C-EC44DBA9AAAC}"/>
                  </a:ext>
                </a:extLst>
              </p:cNvPr>
              <p:cNvSpPr txBox="1"/>
              <p:nvPr/>
            </p:nvSpPr>
            <p:spPr>
              <a:xfrm rot="5400000">
                <a:off x="6168884" y="1029007"/>
                <a:ext cx="10578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B:pERK1/2</a:t>
                </a:r>
              </a:p>
            </p:txBody>
          </p: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BA520452-C518-E7AF-DF7A-1D419CC313CD}"/>
                  </a:ext>
                </a:extLst>
              </p:cNvPr>
              <p:cNvSpPr/>
              <p:nvPr/>
            </p:nvSpPr>
            <p:spPr>
              <a:xfrm>
                <a:off x="3998978" y="866775"/>
                <a:ext cx="2330329" cy="69579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</p:grpSp>
      <p:sp>
        <p:nvSpPr>
          <p:cNvPr id="64" name="Rectangle 63">
            <a:extLst>
              <a:ext uri="{FF2B5EF4-FFF2-40B4-BE49-F238E27FC236}">
                <a16:creationId xmlns:a16="http://schemas.microsoft.com/office/drawing/2014/main" id="{52A54032-3A2E-3B83-C321-F09EB731E911}"/>
              </a:ext>
            </a:extLst>
          </p:cNvPr>
          <p:cNvSpPr/>
          <p:nvPr/>
        </p:nvSpPr>
        <p:spPr>
          <a:xfrm>
            <a:off x="47754" y="3587638"/>
            <a:ext cx="3211929" cy="2208953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D027A65B-08B8-6DD8-9FC4-5C47F84DBD22}"/>
              </a:ext>
            </a:extLst>
          </p:cNvPr>
          <p:cNvCxnSpPr>
            <a:cxnSpLocks/>
          </p:cNvCxnSpPr>
          <p:nvPr/>
        </p:nvCxnSpPr>
        <p:spPr>
          <a:xfrm flipV="1">
            <a:off x="3259683" y="1964611"/>
            <a:ext cx="421756" cy="1623027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59B4FB0A-A636-1D85-7B66-444C91DEE9FC}"/>
              </a:ext>
            </a:extLst>
          </p:cNvPr>
          <p:cNvCxnSpPr>
            <a:cxnSpLocks/>
          </p:cNvCxnSpPr>
          <p:nvPr/>
        </p:nvCxnSpPr>
        <p:spPr>
          <a:xfrm>
            <a:off x="3259683" y="5796591"/>
            <a:ext cx="416714" cy="1935693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3E1E3717-0A53-F58E-A81E-232B32549000}"/>
              </a:ext>
            </a:extLst>
          </p:cNvPr>
          <p:cNvGrpSpPr/>
          <p:nvPr/>
        </p:nvGrpSpPr>
        <p:grpSpPr>
          <a:xfrm>
            <a:off x="3193064" y="5156342"/>
            <a:ext cx="3602162" cy="2449983"/>
            <a:chOff x="3193064" y="3471932"/>
            <a:chExt cx="3602162" cy="2449983"/>
          </a:xfrm>
        </p:grpSpPr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0EF5A728-2818-2193-2BEC-A5A6EC6687A4}"/>
                </a:ext>
              </a:extLst>
            </p:cNvPr>
            <p:cNvGrpSpPr/>
            <p:nvPr/>
          </p:nvGrpSpPr>
          <p:grpSpPr>
            <a:xfrm>
              <a:off x="3193064" y="3471932"/>
              <a:ext cx="3602162" cy="2449983"/>
              <a:chOff x="3550238" y="1114099"/>
              <a:chExt cx="3602162" cy="2449983"/>
            </a:xfrm>
          </p:grpSpPr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D758DAA5-7A9B-52AB-60EF-078B50C07AA6}"/>
                  </a:ext>
                </a:extLst>
              </p:cNvPr>
              <p:cNvGrpSpPr/>
              <p:nvPr/>
            </p:nvGrpSpPr>
            <p:grpSpPr>
              <a:xfrm>
                <a:off x="4123272" y="1114099"/>
                <a:ext cx="2806152" cy="2449983"/>
                <a:chOff x="4123272" y="1114099"/>
                <a:chExt cx="2806152" cy="2449983"/>
              </a:xfrm>
            </p:grpSpPr>
            <p:cxnSp>
              <p:nvCxnSpPr>
                <p:cNvPr id="37" name="Straight Connector 36">
                  <a:extLst>
                    <a:ext uri="{FF2B5EF4-FFF2-40B4-BE49-F238E27FC236}">
                      <a16:creationId xmlns:a16="http://schemas.microsoft.com/office/drawing/2014/main" id="{3F171DED-DF63-4048-F95B-250BB27CD6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23272" y="2180185"/>
                  <a:ext cx="15511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>
                  <a:extLst>
                    <a:ext uri="{FF2B5EF4-FFF2-40B4-BE49-F238E27FC236}">
                      <a16:creationId xmlns:a16="http://schemas.microsoft.com/office/drawing/2014/main" id="{4B669C4F-5073-5C23-4E9F-89A8F885B3A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23272" y="1632276"/>
                  <a:ext cx="15511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>
                  <a:extLst>
                    <a:ext uri="{FF2B5EF4-FFF2-40B4-BE49-F238E27FC236}">
                      <a16:creationId xmlns:a16="http://schemas.microsoft.com/office/drawing/2014/main" id="{EED270D8-7657-B3D6-66F8-E99EC16E96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23272" y="1858567"/>
                  <a:ext cx="15511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46" name="Picture 45">
                  <a:extLst>
                    <a:ext uri="{FF2B5EF4-FFF2-40B4-BE49-F238E27FC236}">
                      <a16:creationId xmlns:a16="http://schemas.microsoft.com/office/drawing/2014/main" id="{62DBD90F-47ED-5832-456E-F4923B35BB48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629" t="28554" r="32845" b="29430"/>
                <a:stretch/>
              </p:blipFill>
              <p:spPr>
                <a:xfrm>
                  <a:off x="4123272" y="1114099"/>
                  <a:ext cx="2806152" cy="2449983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</p:grp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D7D780B8-77B5-08AD-B7A5-0AAB8D1BA620}"/>
                  </a:ext>
                </a:extLst>
              </p:cNvPr>
              <p:cNvSpPr txBox="1"/>
              <p:nvPr/>
            </p:nvSpPr>
            <p:spPr>
              <a:xfrm rot="5400000">
                <a:off x="6476879" y="1919646"/>
                <a:ext cx="1104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B:tERK1/2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150AD55B-0191-1B45-3739-CF21CB41EAEA}"/>
                  </a:ext>
                </a:extLst>
              </p:cNvPr>
              <p:cNvSpPr txBox="1"/>
              <p:nvPr/>
            </p:nvSpPr>
            <p:spPr>
              <a:xfrm>
                <a:off x="3550238" y="1491828"/>
                <a:ext cx="6297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4kDa</a:t>
                </a:r>
                <a:endParaRPr lang="en-I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B2E1D574-627C-FCEC-5F2E-2878D044851E}"/>
                </a:ext>
              </a:extLst>
            </p:cNvPr>
            <p:cNvSpPr/>
            <p:nvPr/>
          </p:nvSpPr>
          <p:spPr>
            <a:xfrm>
              <a:off x="3942832" y="3965211"/>
              <a:ext cx="2330329" cy="69159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72" name="Rectangle 71">
            <a:extLst>
              <a:ext uri="{FF2B5EF4-FFF2-40B4-BE49-F238E27FC236}">
                <a16:creationId xmlns:a16="http://schemas.microsoft.com/office/drawing/2014/main" id="{2A099C97-403D-39BF-FC34-7A35656091DA}"/>
              </a:ext>
            </a:extLst>
          </p:cNvPr>
          <p:cNvSpPr/>
          <p:nvPr/>
        </p:nvSpPr>
        <p:spPr>
          <a:xfrm>
            <a:off x="3681439" y="1964611"/>
            <a:ext cx="3125155" cy="5767673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520707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A4B59316-8C95-E822-5D42-BF6F97F34DF2}"/>
              </a:ext>
            </a:extLst>
          </p:cNvPr>
          <p:cNvSpPr txBox="1"/>
          <p:nvPr/>
        </p:nvSpPr>
        <p:spPr>
          <a:xfrm>
            <a:off x="110721" y="170119"/>
            <a:ext cx="8329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5c</a:t>
            </a:r>
            <a:endParaRPr lang="en-IN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Group 90">
            <a:extLst>
              <a:ext uri="{FF2B5EF4-FFF2-40B4-BE49-F238E27FC236}">
                <a16:creationId xmlns:a16="http://schemas.microsoft.com/office/drawing/2014/main" id="{49703A39-6D10-8535-9996-D72523B96F97}"/>
              </a:ext>
            </a:extLst>
          </p:cNvPr>
          <p:cNvGrpSpPr/>
          <p:nvPr/>
        </p:nvGrpSpPr>
        <p:grpSpPr>
          <a:xfrm>
            <a:off x="110721" y="3229169"/>
            <a:ext cx="3214618" cy="2265046"/>
            <a:chOff x="145635" y="2345466"/>
            <a:chExt cx="3214618" cy="2265046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E5270DEE-EBD8-D04C-11D3-E5AA93A58543}"/>
                </a:ext>
              </a:extLst>
            </p:cNvPr>
            <p:cNvGrpSpPr/>
            <p:nvPr/>
          </p:nvGrpSpPr>
          <p:grpSpPr>
            <a:xfrm>
              <a:off x="148167" y="2345466"/>
              <a:ext cx="3212086" cy="2265046"/>
              <a:chOff x="-46530" y="2247609"/>
              <a:chExt cx="3491284" cy="2538073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6908E5AE-FDA6-0AD4-F25E-604284808EC8}"/>
                  </a:ext>
                </a:extLst>
              </p:cNvPr>
              <p:cNvGrpSpPr/>
              <p:nvPr/>
            </p:nvGrpSpPr>
            <p:grpSpPr>
              <a:xfrm>
                <a:off x="-46530" y="2247609"/>
                <a:ext cx="3491284" cy="2382867"/>
                <a:chOff x="8551" y="6596469"/>
                <a:chExt cx="3491284" cy="2382867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5B97E0C9-FC8B-0DB9-452B-2E8256EBE1BF}"/>
                    </a:ext>
                  </a:extLst>
                </p:cNvPr>
                <p:cNvSpPr txBox="1"/>
                <p:nvPr/>
              </p:nvSpPr>
              <p:spPr>
                <a:xfrm rot="5400000">
                  <a:off x="2740827" y="7290711"/>
                  <a:ext cx="1237996" cy="26762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WB:pERK1/2</a:t>
                  </a:r>
                </a:p>
              </p:txBody>
            </p: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F6353313-3C02-5490-8F0E-2F8F597E0EC6}"/>
                    </a:ext>
                  </a:extLst>
                </p:cNvPr>
                <p:cNvGrpSpPr/>
                <p:nvPr/>
              </p:nvGrpSpPr>
              <p:grpSpPr>
                <a:xfrm>
                  <a:off x="8551" y="6596469"/>
                  <a:ext cx="3491284" cy="2382867"/>
                  <a:chOff x="8551" y="6596469"/>
                  <a:chExt cx="3491284" cy="2382867"/>
                </a:xfrm>
              </p:grpSpPr>
              <p:grpSp>
                <p:nvGrpSpPr>
                  <p:cNvPr id="12" name="Group 11">
                    <a:extLst>
                      <a:ext uri="{FF2B5EF4-FFF2-40B4-BE49-F238E27FC236}">
                        <a16:creationId xmlns:a16="http://schemas.microsoft.com/office/drawing/2014/main" id="{82B19C65-2947-0C9F-8D8D-CB4E1F17F2CC}"/>
                      </a:ext>
                    </a:extLst>
                  </p:cNvPr>
                  <p:cNvGrpSpPr/>
                  <p:nvPr/>
                </p:nvGrpSpPr>
                <p:grpSpPr>
                  <a:xfrm>
                    <a:off x="8551" y="6596469"/>
                    <a:ext cx="3449204" cy="2146534"/>
                    <a:chOff x="-9456" y="6903315"/>
                    <a:chExt cx="3449204" cy="2146534"/>
                  </a:xfrm>
                </p:grpSpPr>
                <p:grpSp>
                  <p:nvGrpSpPr>
                    <p:cNvPr id="14" name="Group 13">
                      <a:extLst>
                        <a:ext uri="{FF2B5EF4-FFF2-40B4-BE49-F238E27FC236}">
                          <a16:creationId xmlns:a16="http://schemas.microsoft.com/office/drawing/2014/main" id="{6CA7E691-3B3E-4794-9AD5-0EE7E3F2B9D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9456" y="6903315"/>
                      <a:ext cx="3449204" cy="2146534"/>
                      <a:chOff x="-9456" y="6903315"/>
                      <a:chExt cx="3449204" cy="2146534"/>
                    </a:xfrm>
                  </p:grpSpPr>
                  <p:grpSp>
                    <p:nvGrpSpPr>
                      <p:cNvPr id="17" name="Group 16">
                        <a:extLst>
                          <a:ext uri="{FF2B5EF4-FFF2-40B4-BE49-F238E27FC236}">
                            <a16:creationId xmlns:a16="http://schemas.microsoft.com/office/drawing/2014/main" id="{B6995B6C-2DBF-FB5C-C00D-12AC8AAD82C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9456" y="7226813"/>
                        <a:ext cx="3449204" cy="1823036"/>
                        <a:chOff x="-9456" y="7226813"/>
                        <a:chExt cx="3449204" cy="1823036"/>
                      </a:xfrm>
                    </p:grpSpPr>
                    <p:grpSp>
                      <p:nvGrpSpPr>
                        <p:cNvPr id="20" name="Group 19">
                          <a:extLst>
                            <a:ext uri="{FF2B5EF4-FFF2-40B4-BE49-F238E27FC236}">
                              <a16:creationId xmlns:a16="http://schemas.microsoft.com/office/drawing/2014/main" id="{DD94EDC7-AE28-D0AD-3E7E-6B697865C2D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9456" y="7226813"/>
                          <a:ext cx="3449204" cy="1823036"/>
                          <a:chOff x="5673" y="5241043"/>
                          <a:chExt cx="3449204" cy="1823036"/>
                        </a:xfrm>
                      </p:grpSpPr>
                      <p:sp>
                        <p:nvSpPr>
                          <p:cNvPr id="23" name="TextBox 22">
                            <a:extLst>
                              <a:ext uri="{FF2B5EF4-FFF2-40B4-BE49-F238E27FC236}">
                                <a16:creationId xmlns:a16="http://schemas.microsoft.com/office/drawing/2014/main" id="{696BEB26-D1B1-595E-6B00-FA0A806BC9D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71131" y="5241043"/>
                            <a:ext cx="3383746" cy="27590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0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ime (min)       0     5     0     5     0     5     0      5</a:t>
                            </a:r>
                            <a:endParaRPr lang="en-IN" sz="100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24" name="Straight Connector 23">
                            <a:extLst>
                              <a:ext uri="{FF2B5EF4-FFF2-40B4-BE49-F238E27FC236}">
                                <a16:creationId xmlns:a16="http://schemas.microsoft.com/office/drawing/2014/main" id="{14C6B780-5A0C-ED02-2B1B-7EC4F62C05E2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868348" y="7047303"/>
                            <a:ext cx="525388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5" name="Straight Connector 24">
                            <a:extLst>
                              <a:ext uri="{FF2B5EF4-FFF2-40B4-BE49-F238E27FC236}">
                                <a16:creationId xmlns:a16="http://schemas.microsoft.com/office/drawing/2014/main" id="{02DBDC9B-CBB5-EFD2-2C80-00B4DBFCC2D7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449175" y="7047303"/>
                            <a:ext cx="525388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6" name="Straight Connector 25">
                            <a:extLst>
                              <a:ext uri="{FF2B5EF4-FFF2-40B4-BE49-F238E27FC236}">
                                <a16:creationId xmlns:a16="http://schemas.microsoft.com/office/drawing/2014/main" id="{572EC5C1-1C97-FB3C-43FD-F4B8C3CC4FB7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2037706" y="7047303"/>
                            <a:ext cx="525388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7" name="Straight Connector 26">
                            <a:extLst>
                              <a:ext uri="{FF2B5EF4-FFF2-40B4-BE49-F238E27FC236}">
                                <a16:creationId xmlns:a16="http://schemas.microsoft.com/office/drawing/2014/main" id="{D15D2583-78B2-33D8-D28E-D35BB1E51FE5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2626238" y="7050546"/>
                            <a:ext cx="525388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28" name="TextBox 27">
                            <a:extLst>
                              <a:ext uri="{FF2B5EF4-FFF2-40B4-BE49-F238E27FC236}">
                                <a16:creationId xmlns:a16="http://schemas.microsoft.com/office/drawing/2014/main" id="{54D342DA-8124-0D5D-177A-4C84FE777F0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673" y="6519794"/>
                            <a:ext cx="691831" cy="27590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0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43kDa</a:t>
                            </a:r>
                            <a:endParaRPr lang="en-IN" sz="100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9" name="TextBox 28">
                            <a:extLst>
                              <a:ext uri="{FF2B5EF4-FFF2-40B4-BE49-F238E27FC236}">
                                <a16:creationId xmlns:a16="http://schemas.microsoft.com/office/drawing/2014/main" id="{9A5BD46D-776B-B418-B99D-1D412D737A9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316" y="6788179"/>
                            <a:ext cx="680478" cy="27590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0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33kDa</a:t>
                            </a:r>
                            <a:endParaRPr lang="en-IN" sz="100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30" name="TextBox 29">
                            <a:extLst>
                              <a:ext uri="{FF2B5EF4-FFF2-40B4-BE49-F238E27FC236}">
                                <a16:creationId xmlns:a16="http://schemas.microsoft.com/office/drawing/2014/main" id="{96541DD1-A933-0A6B-76CD-7520659F4E3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673" y="6266751"/>
                            <a:ext cx="687084" cy="27590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0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54kDa</a:t>
                            </a:r>
                            <a:endParaRPr lang="en-IN" sz="100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31" name="TextBox 30">
                            <a:extLst>
                              <a:ext uri="{FF2B5EF4-FFF2-40B4-BE49-F238E27FC236}">
                                <a16:creationId xmlns:a16="http://schemas.microsoft.com/office/drawing/2014/main" id="{BF102F00-A9B2-2827-6C15-8D42A0AEB94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7102" y="5769426"/>
                            <a:ext cx="662112" cy="27590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0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43kDa</a:t>
                            </a:r>
                            <a:endParaRPr lang="en-IN" sz="100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32" name="TextBox 31">
                            <a:extLst>
                              <a:ext uri="{FF2B5EF4-FFF2-40B4-BE49-F238E27FC236}">
                                <a16:creationId xmlns:a16="http://schemas.microsoft.com/office/drawing/2014/main" id="{043FE449-39A4-C5D9-A48F-FF7C83A8C26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551" y="6003875"/>
                            <a:ext cx="678072" cy="27590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0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33kDa</a:t>
                            </a:r>
                            <a:endParaRPr lang="en-IN" sz="100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33" name="TextBox 32">
                            <a:extLst>
                              <a:ext uri="{FF2B5EF4-FFF2-40B4-BE49-F238E27FC236}">
                                <a16:creationId xmlns:a16="http://schemas.microsoft.com/office/drawing/2014/main" id="{F3B56600-8298-876F-E1FF-796E9ADC222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283" y="5531546"/>
                            <a:ext cx="660330" cy="27590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00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54kDa</a:t>
                            </a:r>
                            <a:endParaRPr lang="en-IN" sz="100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34" name="Straight Connector 33">
                            <a:extLst>
                              <a:ext uri="{FF2B5EF4-FFF2-40B4-BE49-F238E27FC236}">
                                <a16:creationId xmlns:a16="http://schemas.microsoft.com/office/drawing/2014/main" id="{5CBD42FC-9914-CB42-B04E-CDF26985FD0A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567405" y="5900723"/>
                            <a:ext cx="168594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5" name="Straight Connector 34">
                            <a:extLst>
                              <a:ext uri="{FF2B5EF4-FFF2-40B4-BE49-F238E27FC236}">
                                <a16:creationId xmlns:a16="http://schemas.microsoft.com/office/drawing/2014/main" id="{46A6DFD3-8528-EC18-AE1A-841AB873DE45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567405" y="6170295"/>
                            <a:ext cx="168594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6" name="Straight Connector 35">
                            <a:extLst>
                              <a:ext uri="{FF2B5EF4-FFF2-40B4-BE49-F238E27FC236}">
                                <a16:creationId xmlns:a16="http://schemas.microsoft.com/office/drawing/2014/main" id="{4764AEAB-0FB1-D5EB-E473-DD825816A083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567405" y="5673182"/>
                            <a:ext cx="168594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7" name="Straight Connector 36">
                            <a:extLst>
                              <a:ext uri="{FF2B5EF4-FFF2-40B4-BE49-F238E27FC236}">
                                <a16:creationId xmlns:a16="http://schemas.microsoft.com/office/drawing/2014/main" id="{0331F3A3-2C16-C4A5-835D-D8809418ED0F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567405" y="6954592"/>
                            <a:ext cx="168594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8" name="Straight Connector 37">
                            <a:extLst>
                              <a:ext uri="{FF2B5EF4-FFF2-40B4-BE49-F238E27FC236}">
                                <a16:creationId xmlns:a16="http://schemas.microsoft.com/office/drawing/2014/main" id="{42816FF0-69BB-C5A9-1404-1891C2A6B21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567405" y="6671424"/>
                            <a:ext cx="168594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9" name="Straight Connector 38">
                            <a:extLst>
                              <a:ext uri="{FF2B5EF4-FFF2-40B4-BE49-F238E27FC236}">
                                <a16:creationId xmlns:a16="http://schemas.microsoft.com/office/drawing/2014/main" id="{09B7EDAD-9EEC-7B13-DE28-822A7648F6F3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567405" y="6393009"/>
                            <a:ext cx="168594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pic>
                      <p:nvPicPr>
                        <p:cNvPr id="21" name="Picture 20">
                          <a:extLst>
                            <a:ext uri="{FF2B5EF4-FFF2-40B4-BE49-F238E27FC236}">
                              <a16:creationId xmlns:a16="http://schemas.microsoft.com/office/drawing/2014/main" id="{9A50F1A7-ECA2-CC2D-E5C9-24506813FD30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33134" t="53450" r="37114" b="35822"/>
                        <a:stretch/>
                      </p:blipFill>
                      <p:spPr>
                        <a:xfrm>
                          <a:off x="703247" y="8260884"/>
                          <a:ext cx="2534648" cy="712799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  <p:pic>
                      <p:nvPicPr>
                        <p:cNvPr id="22" name="Picture 21">
                          <a:extLst>
                            <a:ext uri="{FF2B5EF4-FFF2-40B4-BE49-F238E27FC236}">
                              <a16:creationId xmlns:a16="http://schemas.microsoft.com/office/drawing/2014/main" id="{80F18D4F-3407-D3DA-D5C5-700989888CE2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 rotWithShape="1">
                        <a:blip r:embed="rId3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28832" t="50850" r="37503" b="32380"/>
                        <a:stretch/>
                      </p:blipFill>
                      <p:spPr>
                        <a:xfrm>
                          <a:off x="713293" y="7469226"/>
                          <a:ext cx="2524602" cy="712799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</p:grpSp>
                  <p:sp>
                    <p:nvSpPr>
                      <p:cNvPr id="18" name="TextBox 17">
                        <a:extLst>
                          <a:ext uri="{FF2B5EF4-FFF2-40B4-BE49-F238E27FC236}">
                            <a16:creationId xmlns:a16="http://schemas.microsoft.com/office/drawing/2014/main" id="{194F4398-2A49-E8E8-0901-F972FDDFFED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95772" y="6903315"/>
                        <a:ext cx="1008000" cy="2759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ock</a:t>
                        </a:r>
                        <a:endParaRPr lang="en-IN" sz="10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9" name="TextBox 18">
                        <a:extLst>
                          <a:ext uri="{FF2B5EF4-FFF2-40B4-BE49-F238E27FC236}">
                            <a16:creationId xmlns:a16="http://schemas.microsoft.com/office/drawing/2014/main" id="{183325B2-3021-0504-CCB6-53A0C8A4C43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36885" y="6903315"/>
                        <a:ext cx="1044000" cy="2759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XCR7</a:t>
                        </a:r>
                        <a:endParaRPr lang="en-IN" sz="10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5" name="Left Brace 14">
                      <a:extLst>
                        <a:ext uri="{FF2B5EF4-FFF2-40B4-BE49-F238E27FC236}">
                          <a16:creationId xmlns:a16="http://schemas.microsoft.com/office/drawing/2014/main" id="{F706B1E0-A661-AB7A-21AF-8FE2CCCEC45C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1441361" y="6716085"/>
                      <a:ext cx="113338" cy="1008000"/>
                    </a:xfrm>
                    <a:prstGeom prst="leftBrace">
                      <a:avLst>
                        <a:gd name="adj1" fmla="val 65083"/>
                        <a:gd name="adj2" fmla="val 50000"/>
                      </a:avLst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" name="Left Brace 15">
                      <a:extLst>
                        <a:ext uri="{FF2B5EF4-FFF2-40B4-BE49-F238E27FC236}">
                          <a16:creationId xmlns:a16="http://schemas.microsoft.com/office/drawing/2014/main" id="{5BEBBAFB-7031-AF37-EA3E-9AD8F1901661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2603031" y="6687587"/>
                      <a:ext cx="108000" cy="1044000"/>
                    </a:xfrm>
                    <a:prstGeom prst="leftBrace">
                      <a:avLst>
                        <a:gd name="adj1" fmla="val 65083"/>
                        <a:gd name="adj2" fmla="val 50000"/>
                      </a:avLst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D20BAA8C-5C97-4CD2-3B4A-F20C086F408B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2807984" y="8287485"/>
                    <a:ext cx="1116079" cy="2676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B:tERK1/2</a:t>
                    </a:r>
                  </a:p>
                </p:txBody>
              </p:sp>
            </p:grpSp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5EAE5946-8ABD-4CE0-0716-DDF75C46BEBE}"/>
                  </a:ext>
                </a:extLst>
              </p:cNvPr>
              <p:cNvSpPr txBox="1"/>
              <p:nvPr/>
            </p:nvSpPr>
            <p:spPr>
              <a:xfrm>
                <a:off x="1280605" y="4337336"/>
                <a:ext cx="788757" cy="4483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CXCL12</a:t>
                </a:r>
              </a:p>
              <a:p>
                <a:pPr algn="ctr"/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+AMD</a:t>
                </a:r>
                <a:endParaRPr lang="en-IN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6E70AC9B-4C8C-7141-40E4-9C6A27100AC7}"/>
                  </a:ext>
                </a:extLst>
              </p:cNvPr>
              <p:cNvSpPr txBox="1"/>
              <p:nvPr/>
            </p:nvSpPr>
            <p:spPr>
              <a:xfrm>
                <a:off x="678042" y="4337334"/>
                <a:ext cx="809807" cy="2759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CXCL12</a:t>
                </a:r>
                <a:endParaRPr lang="en-IN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08D62D6-14EF-3857-5210-ED5B875C7FA9}"/>
                  </a:ext>
                </a:extLst>
              </p:cNvPr>
              <p:cNvSpPr txBox="1"/>
              <p:nvPr/>
            </p:nvSpPr>
            <p:spPr>
              <a:xfrm>
                <a:off x="1871382" y="4337336"/>
                <a:ext cx="836746" cy="2759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CXCL12</a:t>
                </a:r>
                <a:endParaRPr lang="en-IN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4CA9FDB-255E-5A47-9FF2-4F41E3165669}"/>
                  </a:ext>
                </a:extLst>
              </p:cNvPr>
              <p:cNvSpPr txBox="1"/>
              <p:nvPr/>
            </p:nvSpPr>
            <p:spPr>
              <a:xfrm>
                <a:off x="2462160" y="4337343"/>
                <a:ext cx="829180" cy="4483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CXCL12</a:t>
                </a:r>
              </a:p>
              <a:p>
                <a:pPr algn="ctr"/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+AMD</a:t>
                </a:r>
                <a:endParaRPr lang="en-IN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C0777817-E8B9-7324-0E2C-3ED7EFA5154E}"/>
                </a:ext>
              </a:extLst>
            </p:cNvPr>
            <p:cNvSpPr/>
            <p:nvPr/>
          </p:nvSpPr>
          <p:spPr>
            <a:xfrm>
              <a:off x="145635" y="2354456"/>
              <a:ext cx="3211929" cy="2208953"/>
            </a:xfrm>
            <a:prstGeom prst="rect">
              <a:avLst/>
            </a:prstGeom>
            <a:noFill/>
            <a:ln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id="{8199635E-0D7B-D5CA-2D4D-3EFC5A3DE41C}"/>
              </a:ext>
            </a:extLst>
          </p:cNvPr>
          <p:cNvGrpSpPr/>
          <p:nvPr/>
        </p:nvGrpSpPr>
        <p:grpSpPr>
          <a:xfrm>
            <a:off x="3485352" y="2515228"/>
            <a:ext cx="3205069" cy="1661963"/>
            <a:chOff x="3578963" y="616129"/>
            <a:chExt cx="3205069" cy="1661963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F27B635-1964-BA72-5130-5D1CD79DE8F9}"/>
                </a:ext>
              </a:extLst>
            </p:cNvPr>
            <p:cNvSpPr txBox="1"/>
            <p:nvPr/>
          </p:nvSpPr>
          <p:spPr>
            <a:xfrm rot="5400000">
              <a:off x="6108510" y="1515026"/>
              <a:ext cx="11048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WB:pERK1/2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6B997D9-CE3B-E579-B3D7-FCFE0AB2B737}"/>
                </a:ext>
              </a:extLst>
            </p:cNvPr>
            <p:cNvSpPr txBox="1"/>
            <p:nvPr/>
          </p:nvSpPr>
          <p:spPr>
            <a:xfrm>
              <a:off x="3578963" y="1659402"/>
              <a:ext cx="6091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en-I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84E42C74-E36E-6CC0-002D-63157073324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94458" y="1776575"/>
              <a:ext cx="1551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87B5E260-DBD6-79FD-B098-30BDC025B2B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94458" y="2017148"/>
              <a:ext cx="1551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4F792334-67EC-863E-6649-BC3E13A38F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94458" y="1573511"/>
              <a:ext cx="1551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95956E4E-9DFD-7F1D-863B-AA7BA0D9D0DE}"/>
                </a:ext>
              </a:extLst>
            </p:cNvPr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85" t="29905" r="34332" b="26285"/>
            <a:stretch/>
          </p:blipFill>
          <p:spPr>
            <a:xfrm>
              <a:off x="4094458" y="616129"/>
              <a:ext cx="2689574" cy="166196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1291A85B-41C6-DFB7-D003-274255E7C0E1}"/>
                </a:ext>
              </a:extLst>
            </p:cNvPr>
            <p:cNvSpPr/>
            <p:nvPr/>
          </p:nvSpPr>
          <p:spPr>
            <a:xfrm>
              <a:off x="4265013" y="1424217"/>
              <a:ext cx="2322709" cy="63612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87" name="Rectangle 86">
            <a:extLst>
              <a:ext uri="{FF2B5EF4-FFF2-40B4-BE49-F238E27FC236}">
                <a16:creationId xmlns:a16="http://schemas.microsoft.com/office/drawing/2014/main" id="{2AF65083-D8C1-2796-9367-C17807DE85D3}"/>
              </a:ext>
            </a:extLst>
          </p:cNvPr>
          <p:cNvSpPr/>
          <p:nvPr/>
        </p:nvSpPr>
        <p:spPr>
          <a:xfrm>
            <a:off x="3453359" y="2350655"/>
            <a:ext cx="3330674" cy="4716379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grpSp>
        <p:nvGrpSpPr>
          <p:cNvPr id="84" name="Group 83">
            <a:extLst>
              <a:ext uri="{FF2B5EF4-FFF2-40B4-BE49-F238E27FC236}">
                <a16:creationId xmlns:a16="http://schemas.microsoft.com/office/drawing/2014/main" id="{7D7C7E28-7A59-3D8E-BA84-0EB61A7E3E5C}"/>
              </a:ext>
            </a:extLst>
          </p:cNvPr>
          <p:cNvGrpSpPr/>
          <p:nvPr/>
        </p:nvGrpSpPr>
        <p:grpSpPr>
          <a:xfrm>
            <a:off x="3434071" y="4672657"/>
            <a:ext cx="3261821" cy="2208951"/>
            <a:chOff x="3434675" y="4610506"/>
            <a:chExt cx="3261821" cy="2208951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E342C79-C4C3-8FEC-09AB-7624C6A84E00}"/>
                </a:ext>
              </a:extLst>
            </p:cNvPr>
            <p:cNvSpPr txBox="1"/>
            <p:nvPr/>
          </p:nvSpPr>
          <p:spPr>
            <a:xfrm>
              <a:off x="3434675" y="6020978"/>
              <a:ext cx="6365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en-I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288817EA-6A23-BD54-3DB8-BC0089095F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1485" y="6409004"/>
              <a:ext cx="1551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541FCAA8-E512-F00C-13A2-BE491564D32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1485" y="6156297"/>
              <a:ext cx="1551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973690D6-9429-B72D-AF0D-05846F4FD86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1485" y="5907832"/>
              <a:ext cx="1551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CA9E8E6C-0D0F-8A91-4A9E-0FF8D4AF48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66" t="33344" r="33612" b="29403"/>
            <a:stretch/>
          </p:blipFill>
          <p:spPr>
            <a:xfrm>
              <a:off x="3951485" y="4610506"/>
              <a:ext cx="2745011" cy="220895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884118D-6681-A03E-D08D-F9CE5FEF97F8}"/>
                </a:ext>
              </a:extLst>
            </p:cNvPr>
            <p:cNvSpPr txBox="1"/>
            <p:nvPr/>
          </p:nvSpPr>
          <p:spPr>
            <a:xfrm rot="5400000">
              <a:off x="6025641" y="6096503"/>
              <a:ext cx="9960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WB:tERK1/2</a:t>
              </a: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76895C09-27C5-6268-30C3-35B78138219D}"/>
                </a:ext>
              </a:extLst>
            </p:cNvPr>
            <p:cNvSpPr/>
            <p:nvPr/>
          </p:nvSpPr>
          <p:spPr>
            <a:xfrm>
              <a:off x="4087593" y="5806025"/>
              <a:ext cx="2331952" cy="63612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76058F5F-263C-9D71-09B0-C307F7D6436A}"/>
              </a:ext>
            </a:extLst>
          </p:cNvPr>
          <p:cNvCxnSpPr>
            <a:cxnSpLocks/>
          </p:cNvCxnSpPr>
          <p:nvPr/>
        </p:nvCxnSpPr>
        <p:spPr>
          <a:xfrm>
            <a:off x="3319637" y="5447112"/>
            <a:ext cx="131032" cy="1628912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E6237B8D-700D-4943-92B6-070526E72166}"/>
              </a:ext>
            </a:extLst>
          </p:cNvPr>
          <p:cNvCxnSpPr>
            <a:cxnSpLocks/>
          </p:cNvCxnSpPr>
          <p:nvPr/>
        </p:nvCxnSpPr>
        <p:spPr>
          <a:xfrm flipV="1">
            <a:off x="3319637" y="2350655"/>
            <a:ext cx="131032" cy="878514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104641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E094C602-FC0D-4AED-4919-7720B5ECB1AA}"/>
              </a:ext>
            </a:extLst>
          </p:cNvPr>
          <p:cNvGrpSpPr/>
          <p:nvPr/>
        </p:nvGrpSpPr>
        <p:grpSpPr>
          <a:xfrm>
            <a:off x="0" y="3464665"/>
            <a:ext cx="3225560" cy="2135181"/>
            <a:chOff x="63836" y="4902150"/>
            <a:chExt cx="3225560" cy="2135181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C3D235CD-3237-0817-E75F-19BF61EC98FC}"/>
                </a:ext>
              </a:extLst>
            </p:cNvPr>
            <p:cNvGrpSpPr/>
            <p:nvPr/>
          </p:nvGrpSpPr>
          <p:grpSpPr>
            <a:xfrm>
              <a:off x="72045" y="4902150"/>
              <a:ext cx="3217351" cy="2135181"/>
              <a:chOff x="-6388" y="111385"/>
              <a:chExt cx="3497009" cy="2392561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14C34B7-BEB8-08BC-07E6-FCD8E665AFD5}"/>
                  </a:ext>
                </a:extLst>
              </p:cNvPr>
              <p:cNvSpPr txBox="1"/>
              <p:nvPr/>
            </p:nvSpPr>
            <p:spPr>
              <a:xfrm rot="5400000">
                <a:off x="2776411" y="1800256"/>
                <a:ext cx="1139756" cy="2676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WB:tERK1/2</a:t>
                </a:r>
              </a:p>
            </p:txBody>
          </p: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03B0612D-DA6B-B372-E991-C0D15C1FBACE}"/>
                  </a:ext>
                </a:extLst>
              </p:cNvPr>
              <p:cNvGrpSpPr/>
              <p:nvPr/>
            </p:nvGrpSpPr>
            <p:grpSpPr>
              <a:xfrm>
                <a:off x="-6388" y="111385"/>
                <a:ext cx="3497009" cy="2167815"/>
                <a:chOff x="3685" y="91782"/>
                <a:chExt cx="3497009" cy="2167815"/>
              </a:xfrm>
            </p:grpSpPr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A2C080BC-67AD-05C9-E7AC-9805CE4DC074}"/>
                    </a:ext>
                  </a:extLst>
                </p:cNvPr>
                <p:cNvSpPr txBox="1"/>
                <p:nvPr/>
              </p:nvSpPr>
              <p:spPr>
                <a:xfrm>
                  <a:off x="3685" y="1664720"/>
                  <a:ext cx="702100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43kDa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18BEB509-6F78-02CB-8F1B-0FCAD52B901E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474" t="53503" r="37340" b="34850"/>
                <a:stretch/>
              </p:blipFill>
              <p:spPr>
                <a:xfrm>
                  <a:off x="729480" y="683244"/>
                  <a:ext cx="2536495" cy="712332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A54D2D81-6A83-BB67-BDF9-42A9C95732DD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311" t="52197" r="37984" b="36156"/>
                <a:stretch/>
              </p:blipFill>
              <p:spPr>
                <a:xfrm>
                  <a:off x="729480" y="1466524"/>
                  <a:ext cx="2536495" cy="712332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AE6EB446-38D1-AEE6-A913-A6F7CEA674B4}"/>
                    </a:ext>
                  </a:extLst>
                </p:cNvPr>
                <p:cNvSpPr txBox="1"/>
                <p:nvPr/>
              </p:nvSpPr>
              <p:spPr>
                <a:xfrm rot="5400000">
                  <a:off x="2796733" y="850193"/>
                  <a:ext cx="1140299" cy="26762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WB:pERK1/2</a:t>
                  </a:r>
                </a:p>
              </p:txBody>
            </p: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E92E0043-2CC5-F013-6A49-7498DFF015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969093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44403555-96A3-3A32-6B60-5FA7A74E41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1282074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A8E5789F-78CE-39E8-CE02-6C5E9B3570D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754484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>
                  <a:extLst>
                    <a:ext uri="{FF2B5EF4-FFF2-40B4-BE49-F238E27FC236}">
                      <a16:creationId xmlns:a16="http://schemas.microsoft.com/office/drawing/2014/main" id="{6A996281-F138-A9D7-1631-1F393D296A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2144819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id="{ED887429-8395-F5D8-F927-0BF5F76167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1811780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id="{8B9F9591-94B4-55A8-71C9-482A668067A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1556951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781EE77C-BEB5-C4EC-E53D-F2CE92D5491D}"/>
                    </a:ext>
                  </a:extLst>
                </p:cNvPr>
                <p:cNvSpPr txBox="1"/>
                <p:nvPr/>
              </p:nvSpPr>
              <p:spPr>
                <a:xfrm>
                  <a:off x="3685" y="1983696"/>
                  <a:ext cx="691391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33kDa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A7C02E8F-E03B-2D04-7787-CE95B4BDE658}"/>
                    </a:ext>
                  </a:extLst>
                </p:cNvPr>
                <p:cNvSpPr txBox="1"/>
                <p:nvPr/>
              </p:nvSpPr>
              <p:spPr>
                <a:xfrm>
                  <a:off x="3685" y="822871"/>
                  <a:ext cx="689221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43kDa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CC51B931-D916-DA47-A271-0969AA9FFD78}"/>
                    </a:ext>
                  </a:extLst>
                </p:cNvPr>
                <p:cNvSpPr txBox="1"/>
                <p:nvPr/>
              </p:nvSpPr>
              <p:spPr>
                <a:xfrm>
                  <a:off x="3685" y="1104402"/>
                  <a:ext cx="689220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33kDa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EE9969BC-7156-2C8D-2DB3-2BE71ECEDAB0}"/>
                    </a:ext>
                  </a:extLst>
                </p:cNvPr>
                <p:cNvSpPr txBox="1"/>
                <p:nvPr/>
              </p:nvSpPr>
              <p:spPr>
                <a:xfrm>
                  <a:off x="5856" y="611775"/>
                  <a:ext cx="671038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54kDa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9CA1B3E6-55DC-83A0-E886-3C72551EF76F}"/>
                    </a:ext>
                  </a:extLst>
                </p:cNvPr>
                <p:cNvSpPr txBox="1"/>
                <p:nvPr/>
              </p:nvSpPr>
              <p:spPr>
                <a:xfrm>
                  <a:off x="100211" y="424420"/>
                  <a:ext cx="3169332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Time (min)        0    5   15    0    5   15   0    5   15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FB2A869E-1860-E9B4-D3C3-862A48BF79DE}"/>
                    </a:ext>
                  </a:extLst>
                </p:cNvPr>
                <p:cNvSpPr txBox="1"/>
                <p:nvPr/>
              </p:nvSpPr>
              <p:spPr>
                <a:xfrm>
                  <a:off x="1102295" y="91782"/>
                  <a:ext cx="632557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Left Brace 23">
                  <a:extLst>
                    <a:ext uri="{FF2B5EF4-FFF2-40B4-BE49-F238E27FC236}">
                      <a16:creationId xmlns:a16="http://schemas.microsoft.com/office/drawing/2014/main" id="{21647AB1-1D7D-B538-EAFB-EE11D0DAB9DF}"/>
                    </a:ext>
                  </a:extLst>
                </p:cNvPr>
                <p:cNvSpPr/>
                <p:nvPr/>
              </p:nvSpPr>
              <p:spPr>
                <a:xfrm rot="5400000">
                  <a:off x="1365179" y="68502"/>
                  <a:ext cx="112131" cy="637898"/>
                </a:xfrm>
                <a:prstGeom prst="leftBrace">
                  <a:avLst>
                    <a:gd name="adj1" fmla="val 65083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Left Brace 24">
                  <a:extLst>
                    <a:ext uri="{FF2B5EF4-FFF2-40B4-BE49-F238E27FC236}">
                      <a16:creationId xmlns:a16="http://schemas.microsoft.com/office/drawing/2014/main" id="{1FD5782A-C3DC-7794-DB05-CB37197D2544}"/>
                    </a:ext>
                  </a:extLst>
                </p:cNvPr>
                <p:cNvSpPr/>
                <p:nvPr/>
              </p:nvSpPr>
              <p:spPr>
                <a:xfrm rot="5400000">
                  <a:off x="2081503" y="68502"/>
                  <a:ext cx="112131" cy="637898"/>
                </a:xfrm>
                <a:prstGeom prst="leftBrace">
                  <a:avLst>
                    <a:gd name="adj1" fmla="val 65083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Left Brace 25">
                  <a:extLst>
                    <a:ext uri="{FF2B5EF4-FFF2-40B4-BE49-F238E27FC236}">
                      <a16:creationId xmlns:a16="http://schemas.microsoft.com/office/drawing/2014/main" id="{B7B67A6E-4835-87F2-8541-2F9374AA626C}"/>
                    </a:ext>
                  </a:extLst>
                </p:cNvPr>
                <p:cNvSpPr/>
                <p:nvPr/>
              </p:nvSpPr>
              <p:spPr>
                <a:xfrm rot="5400000">
                  <a:off x="2803168" y="68502"/>
                  <a:ext cx="112131" cy="637898"/>
                </a:xfrm>
                <a:prstGeom prst="leftBrace">
                  <a:avLst>
                    <a:gd name="adj1" fmla="val 65083"/>
                    <a:gd name="adj2" fmla="val 50000"/>
                  </a:avLst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B5200741-70E1-7B51-2659-0D62E8583991}"/>
                    </a:ext>
                  </a:extLst>
                </p:cNvPr>
                <p:cNvSpPr txBox="1"/>
                <p:nvPr/>
              </p:nvSpPr>
              <p:spPr>
                <a:xfrm>
                  <a:off x="1772280" y="91782"/>
                  <a:ext cx="732222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CXCR4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07994175-AB89-63B4-C940-F41673DD7C74}"/>
                    </a:ext>
                  </a:extLst>
                </p:cNvPr>
                <p:cNvSpPr txBox="1"/>
                <p:nvPr/>
              </p:nvSpPr>
              <p:spPr>
                <a:xfrm>
                  <a:off x="2469679" y="91782"/>
                  <a:ext cx="773654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CXCR7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964E1DC-84CE-B60D-1469-EFD7C14390E9}"/>
                </a:ext>
              </a:extLst>
            </p:cNvPr>
            <p:cNvSpPr txBox="1"/>
            <p:nvPr/>
          </p:nvSpPr>
          <p:spPr>
            <a:xfrm>
              <a:off x="63836" y="6087104"/>
              <a:ext cx="6200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54kDa</a:t>
              </a:r>
              <a:endParaRPr lang="en-I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1" name="Rectangle 80">
            <a:extLst>
              <a:ext uri="{FF2B5EF4-FFF2-40B4-BE49-F238E27FC236}">
                <a16:creationId xmlns:a16="http://schemas.microsoft.com/office/drawing/2014/main" id="{5F4624D8-7971-CF42-E1AE-CE517AB2B9FC}"/>
              </a:ext>
            </a:extLst>
          </p:cNvPr>
          <p:cNvSpPr/>
          <p:nvPr/>
        </p:nvSpPr>
        <p:spPr>
          <a:xfrm>
            <a:off x="29403" y="3329566"/>
            <a:ext cx="3211929" cy="2208953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330E5890-7145-8C51-859B-6F10018B404D}"/>
              </a:ext>
            </a:extLst>
          </p:cNvPr>
          <p:cNvSpPr/>
          <p:nvPr/>
        </p:nvSpPr>
        <p:spPr>
          <a:xfrm>
            <a:off x="3390371" y="2094211"/>
            <a:ext cx="3397937" cy="5106422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4BEDE3C5-D160-F250-C013-205046AE19FD}"/>
              </a:ext>
            </a:extLst>
          </p:cNvPr>
          <p:cNvCxnSpPr>
            <a:cxnSpLocks/>
          </p:cNvCxnSpPr>
          <p:nvPr/>
        </p:nvCxnSpPr>
        <p:spPr>
          <a:xfrm>
            <a:off x="3241332" y="5538519"/>
            <a:ext cx="144129" cy="1662114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3522F432-2CB5-3B5D-6484-DACF16CEE100}"/>
              </a:ext>
            </a:extLst>
          </p:cNvPr>
          <p:cNvCxnSpPr>
            <a:cxnSpLocks/>
          </p:cNvCxnSpPr>
          <p:nvPr/>
        </p:nvCxnSpPr>
        <p:spPr>
          <a:xfrm flipV="1">
            <a:off x="3240035" y="2094211"/>
            <a:ext cx="144129" cy="1235355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F7590BC0-C557-4C4D-CA98-EF2D4AAD1C83}"/>
              </a:ext>
            </a:extLst>
          </p:cNvPr>
          <p:cNvGrpSpPr/>
          <p:nvPr/>
        </p:nvGrpSpPr>
        <p:grpSpPr>
          <a:xfrm>
            <a:off x="3385461" y="2199418"/>
            <a:ext cx="3313046" cy="2284376"/>
            <a:chOff x="3385461" y="244550"/>
            <a:chExt cx="3313046" cy="2284376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B7BD8FB1-2C7D-E9C7-5623-6EF5FDAF347D}"/>
                </a:ext>
              </a:extLst>
            </p:cNvPr>
            <p:cNvGrpSpPr/>
            <p:nvPr/>
          </p:nvGrpSpPr>
          <p:grpSpPr>
            <a:xfrm>
              <a:off x="3385461" y="244550"/>
              <a:ext cx="3313046" cy="2284376"/>
              <a:chOff x="3685" y="-865452"/>
              <a:chExt cx="3601022" cy="2559742"/>
            </a:xfrm>
          </p:grpSpPr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97A8E8DB-55DE-07C3-F7D6-D31F133C03F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470" t="28181" r="32907" b="29966"/>
              <a:stretch/>
            </p:blipFill>
            <p:spPr>
              <a:xfrm>
                <a:off x="576302" y="-865452"/>
                <a:ext cx="3028405" cy="255974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A5D0F88D-E5F9-EB33-09BA-13AD22FE3367}"/>
                  </a:ext>
                </a:extLst>
              </p:cNvPr>
              <p:cNvSpPr txBox="1"/>
              <p:nvPr/>
            </p:nvSpPr>
            <p:spPr>
              <a:xfrm rot="5400000">
                <a:off x="2819847" y="874023"/>
                <a:ext cx="1140299" cy="2676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WB:pERK1/2</a:t>
                </a:r>
              </a:p>
            </p:txBody>
          </p: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D64C18AC-D08F-57EF-5AC8-01617125A3C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53134" y="969093"/>
                <a:ext cx="16859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6B14C8A7-0A56-4B0D-575B-5A2FCC03591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53134" y="1282074"/>
                <a:ext cx="16859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A676F0E2-F603-8C7B-2A48-FE1D9180E14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53134" y="754484"/>
                <a:ext cx="16859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43EBEAFE-A849-FC4F-8DD4-DAA6B281953F}"/>
                  </a:ext>
                </a:extLst>
              </p:cNvPr>
              <p:cNvSpPr txBox="1"/>
              <p:nvPr/>
            </p:nvSpPr>
            <p:spPr>
              <a:xfrm>
                <a:off x="3685" y="822871"/>
                <a:ext cx="689221" cy="2759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43kDa</a:t>
                </a:r>
                <a:endParaRPr lang="en-IN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D8588E65-125B-88FE-6BD6-03CF14B5369C}"/>
                </a:ext>
              </a:extLst>
            </p:cNvPr>
            <p:cNvSpPr/>
            <p:nvPr/>
          </p:nvSpPr>
          <p:spPr>
            <a:xfrm>
              <a:off x="4050464" y="1623955"/>
              <a:ext cx="2339091" cy="63570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92" name="TextBox 91">
            <a:extLst>
              <a:ext uri="{FF2B5EF4-FFF2-40B4-BE49-F238E27FC236}">
                <a16:creationId xmlns:a16="http://schemas.microsoft.com/office/drawing/2014/main" id="{CF8BE0E3-7CFB-A7F7-D2AB-F86E6C69DD8A}"/>
              </a:ext>
            </a:extLst>
          </p:cNvPr>
          <p:cNvSpPr txBox="1"/>
          <p:nvPr/>
        </p:nvSpPr>
        <p:spPr>
          <a:xfrm>
            <a:off x="222768" y="244550"/>
            <a:ext cx="9449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5e</a:t>
            </a:r>
            <a:endParaRPr lang="en-IN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4C29E2BA-7F36-84C6-980D-C7AA4AB65C7D}"/>
              </a:ext>
            </a:extLst>
          </p:cNvPr>
          <p:cNvGrpSpPr/>
          <p:nvPr/>
        </p:nvGrpSpPr>
        <p:grpSpPr>
          <a:xfrm>
            <a:off x="3353611" y="4877948"/>
            <a:ext cx="3366162" cy="2208953"/>
            <a:chOff x="3353611" y="5449718"/>
            <a:chExt cx="3366162" cy="2208953"/>
          </a:xfrm>
        </p:grpSpPr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4FD430A7-C14D-3527-BBFA-20FF2A2BCE59}"/>
                </a:ext>
              </a:extLst>
            </p:cNvPr>
            <p:cNvGrpSpPr/>
            <p:nvPr/>
          </p:nvGrpSpPr>
          <p:grpSpPr>
            <a:xfrm>
              <a:off x="3353611" y="5449718"/>
              <a:ext cx="3366162" cy="2208953"/>
              <a:chOff x="-6388" y="111385"/>
              <a:chExt cx="3658755" cy="2475224"/>
            </a:xfrm>
          </p:grpSpPr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7486DAEE-53EF-20AF-C53E-0FA83A773C3C}"/>
                  </a:ext>
                </a:extLst>
              </p:cNvPr>
              <p:cNvSpPr txBox="1"/>
              <p:nvPr/>
            </p:nvSpPr>
            <p:spPr>
              <a:xfrm rot="5400000">
                <a:off x="2776411" y="1800256"/>
                <a:ext cx="1139756" cy="2676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WB:tERK1/2</a:t>
                </a:r>
              </a:p>
            </p:txBody>
          </p:sp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DB80BD06-E8F1-FA45-1C30-3E8EA4CD8996}"/>
                  </a:ext>
                </a:extLst>
              </p:cNvPr>
              <p:cNvGrpSpPr/>
              <p:nvPr/>
            </p:nvGrpSpPr>
            <p:grpSpPr>
              <a:xfrm>
                <a:off x="-6388" y="111385"/>
                <a:ext cx="3658755" cy="2475224"/>
                <a:chOff x="3685" y="91782"/>
                <a:chExt cx="3658755" cy="2475224"/>
              </a:xfrm>
            </p:grpSpPr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16E7B726-DD48-34E0-1004-5795C60946A2}"/>
                    </a:ext>
                  </a:extLst>
                </p:cNvPr>
                <p:cNvSpPr txBox="1"/>
                <p:nvPr/>
              </p:nvSpPr>
              <p:spPr>
                <a:xfrm>
                  <a:off x="3685" y="1664720"/>
                  <a:ext cx="702100" cy="2759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43kDa</a:t>
                  </a:r>
                  <a:endParaRPr lang="en-I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62" name="Picture 61">
                  <a:extLst>
                    <a:ext uri="{FF2B5EF4-FFF2-40B4-BE49-F238E27FC236}">
                      <a16:creationId xmlns:a16="http://schemas.microsoft.com/office/drawing/2014/main" id="{F176F0C6-1214-28D8-3309-C61F1CBD3BA8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038" t="29720" r="32872" b="29809"/>
                <a:stretch/>
              </p:blipFill>
              <p:spPr>
                <a:xfrm>
                  <a:off x="553134" y="91782"/>
                  <a:ext cx="3109306" cy="2475224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cxnSp>
              <p:nvCxnSpPr>
                <p:cNvPr id="67" name="Straight Connector 66">
                  <a:extLst>
                    <a:ext uri="{FF2B5EF4-FFF2-40B4-BE49-F238E27FC236}">
                      <a16:creationId xmlns:a16="http://schemas.microsoft.com/office/drawing/2014/main" id="{F7E78635-B54E-892D-301C-3B3CF8BB1C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2144819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>
                  <a:extLst>
                    <a:ext uri="{FF2B5EF4-FFF2-40B4-BE49-F238E27FC236}">
                      <a16:creationId xmlns:a16="http://schemas.microsoft.com/office/drawing/2014/main" id="{B309790A-24BA-8F4A-093E-48180A0EC8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1811780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Straight Connector 68">
                  <a:extLst>
                    <a:ext uri="{FF2B5EF4-FFF2-40B4-BE49-F238E27FC236}">
                      <a16:creationId xmlns:a16="http://schemas.microsoft.com/office/drawing/2014/main" id="{345A3836-9CE2-79E8-508F-39BDEA24C4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134" y="1556951"/>
                  <a:ext cx="16859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6B9D0093-D2B8-1F59-C1A1-02B8CA758E09}"/>
                </a:ext>
              </a:extLst>
            </p:cNvPr>
            <p:cNvSpPr/>
            <p:nvPr/>
          </p:nvSpPr>
          <p:spPr>
            <a:xfrm>
              <a:off x="4042044" y="6705823"/>
              <a:ext cx="2344452" cy="62440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</p:spTree>
    <p:extLst>
      <p:ext uri="{BB962C8B-B14F-4D97-AF65-F5344CB8AC3E}">
        <p14:creationId xmlns:p14="http://schemas.microsoft.com/office/powerpoint/2010/main" val="2940019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2</TotalTime>
  <Words>126</Words>
  <Application>Microsoft Office PowerPoint</Application>
  <PresentationFormat>A4 Paper (210x297 mm)</PresentationFormat>
  <Paragraphs>5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ish Yadav</dc:creator>
  <cp:lastModifiedBy>gpcrlab3@gmail.com</cp:lastModifiedBy>
  <cp:revision>3</cp:revision>
  <dcterms:created xsi:type="dcterms:W3CDTF">2023-07-03T11:07:41Z</dcterms:created>
  <dcterms:modified xsi:type="dcterms:W3CDTF">2023-07-06T06:45:19Z</dcterms:modified>
</cp:coreProperties>
</file>